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4"/>
  </p:notesMasterIdLst>
  <p:sldIdLst>
    <p:sldId id="777" r:id="rId3"/>
  </p:sldIdLst>
  <p:sldSz cx="6300788" cy="8153400"/>
  <p:notesSz cx="6858000" cy="9144000"/>
  <p:defaultTextStyle>
    <a:defPPr>
      <a:defRPr lang="ja-JP"/>
    </a:defPPr>
    <a:lvl1pPr marL="0" algn="l" defTabSz="720163" rtl="0" eaLnBrk="1" latinLnBrk="0" hangingPunct="1">
      <a:defRPr kumimoji="1" sz="1410" kern="1200">
        <a:solidFill>
          <a:schemeClr val="tx1"/>
        </a:solidFill>
        <a:latin typeface="+mn-lt"/>
        <a:ea typeface="+mn-ea"/>
        <a:cs typeface="+mn-cs"/>
      </a:defRPr>
    </a:lvl1pPr>
    <a:lvl2pPr marL="360081" algn="l" defTabSz="720163" rtl="0" eaLnBrk="1" latinLnBrk="0" hangingPunct="1">
      <a:defRPr kumimoji="1" sz="1410" kern="1200">
        <a:solidFill>
          <a:schemeClr val="tx1"/>
        </a:solidFill>
        <a:latin typeface="+mn-lt"/>
        <a:ea typeface="+mn-ea"/>
        <a:cs typeface="+mn-cs"/>
      </a:defRPr>
    </a:lvl2pPr>
    <a:lvl3pPr marL="720163" algn="l" defTabSz="720163" rtl="0" eaLnBrk="1" latinLnBrk="0" hangingPunct="1">
      <a:defRPr kumimoji="1" sz="1410" kern="1200">
        <a:solidFill>
          <a:schemeClr val="tx1"/>
        </a:solidFill>
        <a:latin typeface="+mn-lt"/>
        <a:ea typeface="+mn-ea"/>
        <a:cs typeface="+mn-cs"/>
      </a:defRPr>
    </a:lvl3pPr>
    <a:lvl4pPr marL="1080245" algn="l" defTabSz="720163" rtl="0" eaLnBrk="1" latinLnBrk="0" hangingPunct="1">
      <a:defRPr kumimoji="1" sz="1410" kern="1200">
        <a:solidFill>
          <a:schemeClr val="tx1"/>
        </a:solidFill>
        <a:latin typeface="+mn-lt"/>
        <a:ea typeface="+mn-ea"/>
        <a:cs typeface="+mn-cs"/>
      </a:defRPr>
    </a:lvl4pPr>
    <a:lvl5pPr marL="1440327" algn="l" defTabSz="720163" rtl="0" eaLnBrk="1" latinLnBrk="0" hangingPunct="1">
      <a:defRPr kumimoji="1" sz="1410" kern="1200">
        <a:solidFill>
          <a:schemeClr val="tx1"/>
        </a:solidFill>
        <a:latin typeface="+mn-lt"/>
        <a:ea typeface="+mn-ea"/>
        <a:cs typeface="+mn-cs"/>
      </a:defRPr>
    </a:lvl5pPr>
    <a:lvl6pPr marL="1800408" algn="l" defTabSz="720163" rtl="0" eaLnBrk="1" latinLnBrk="0" hangingPunct="1">
      <a:defRPr kumimoji="1" sz="1410" kern="1200">
        <a:solidFill>
          <a:schemeClr val="tx1"/>
        </a:solidFill>
        <a:latin typeface="+mn-lt"/>
        <a:ea typeface="+mn-ea"/>
        <a:cs typeface="+mn-cs"/>
      </a:defRPr>
    </a:lvl6pPr>
    <a:lvl7pPr marL="2160490" algn="l" defTabSz="720163" rtl="0" eaLnBrk="1" latinLnBrk="0" hangingPunct="1">
      <a:defRPr kumimoji="1" sz="1410" kern="1200">
        <a:solidFill>
          <a:schemeClr val="tx1"/>
        </a:solidFill>
        <a:latin typeface="+mn-lt"/>
        <a:ea typeface="+mn-ea"/>
        <a:cs typeface="+mn-cs"/>
      </a:defRPr>
    </a:lvl7pPr>
    <a:lvl8pPr marL="2520572" algn="l" defTabSz="720163" rtl="0" eaLnBrk="1" latinLnBrk="0" hangingPunct="1">
      <a:defRPr kumimoji="1" sz="1410" kern="1200">
        <a:solidFill>
          <a:schemeClr val="tx1"/>
        </a:solidFill>
        <a:latin typeface="+mn-lt"/>
        <a:ea typeface="+mn-ea"/>
        <a:cs typeface="+mn-cs"/>
      </a:defRPr>
    </a:lvl8pPr>
    <a:lvl9pPr marL="2880653" algn="l" defTabSz="720163" rtl="0" eaLnBrk="1" latinLnBrk="0" hangingPunct="1">
      <a:defRPr kumimoji="1" sz="141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68" userDrawn="1">
          <p15:clr>
            <a:srgbClr val="A4A3A4"/>
          </p15:clr>
        </p15:guide>
        <p15:guide id="2" pos="19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56" autoAdjust="0"/>
    <p:restoredTop sz="92857" autoAdjust="0"/>
  </p:normalViewPr>
  <p:slideViewPr>
    <p:cSldViewPr>
      <p:cViewPr varScale="1">
        <p:scale>
          <a:sx n="71" d="100"/>
          <a:sy n="71" d="100"/>
        </p:scale>
        <p:origin x="1716" y="60"/>
      </p:cViewPr>
      <p:guideLst>
        <p:guide orient="horz" pos="2568"/>
        <p:guide pos="198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DC0130-D09B-4150-B17B-85C72628014F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E65392-C703-4059-9BCE-82940E85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665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81B7CD-0F2F-0C27-506D-CB8AD63221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B585D750-3269-9AEF-559D-9580241582D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322BD135-A7E2-5D0A-F571-B415C93217E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631BFA-E241-4033-1DAE-BA983DFA3FE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E65392-C703-4059-9BCE-82940E850D4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747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72560" y="2532841"/>
            <a:ext cx="5355670" cy="1747696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45118" y="4620261"/>
            <a:ext cx="4410552" cy="208364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230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461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692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923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154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385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61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847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568072" y="326515"/>
            <a:ext cx="1417677" cy="6956813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15040" y="326515"/>
            <a:ext cx="4148019" cy="6956813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912F34-9791-7B79-A9C7-F6AFED8949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87400" y="1335088"/>
            <a:ext cx="4725988" cy="283845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13BB78-D155-E24A-133F-07B1C3E34A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87400" y="4283075"/>
            <a:ext cx="4725988" cy="196850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en-US" altLang="ja-JP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0E6C56-E4CC-868A-786C-C2E32C16A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FC67AB-0C50-7460-4417-564B089F7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2F9CAA-76D8-438F-2FE7-7E8D95595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284484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217620-0EEE-A098-4EEA-B83691F814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89BD03-7D17-FC9B-2E64-7654ADC389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D1679C-B815-DF22-2DD2-E8AEB8B21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07582F-AC79-A74B-12F0-223A78DFE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BEE96F-F157-DE35-804E-BB5992AF5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140011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302F8-C143-7FAF-9602-8A3323A73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0213" y="2032000"/>
            <a:ext cx="5434012" cy="339248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3E4C0D-F832-BA00-AE2A-8D0923EEA6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30213" y="5456238"/>
            <a:ext cx="5434012" cy="1784350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245BF9-5EC0-B7C1-5FD8-8AD11166C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14C9DB-4403-7932-DDC7-456A278BC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C58E93-FD0C-8CE5-BF4E-6F8A67DA0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498583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99751B-9E39-90D3-47B3-4E3E7B4D88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E47DA1-CE76-A3A9-C8FC-AE31ABB400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33388" y="2170113"/>
            <a:ext cx="2640012" cy="5173662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6A2BBA-F444-D216-E61C-CD0591759A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225800" y="2170113"/>
            <a:ext cx="2641600" cy="5173662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7BAC9E-E01C-0E04-13CD-8EEA7F1C7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3110F1-FBEF-541B-1A13-86FF5E772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8F7FAF-A02C-9256-95B7-6C294EDED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635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55112B-46A9-38B3-12C1-8814F126FC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388" y="433388"/>
            <a:ext cx="5435600" cy="1576387"/>
          </a:xfrm>
        </p:spPr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9FD477-A990-E7DA-23E7-512A5DF774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33388" y="1998663"/>
            <a:ext cx="2665412" cy="97948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DF2207-F17A-D25E-5AB0-DD2DAFD17D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33388" y="2978150"/>
            <a:ext cx="2665412" cy="4379913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8913B57-586B-E244-3F9A-98965AB90B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189288" y="1998663"/>
            <a:ext cx="2679700" cy="97948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11E170-D9E8-0F83-D959-4CBE97F481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189288" y="2978150"/>
            <a:ext cx="2679700" cy="4379913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376DF7-4B42-D856-2C63-E6E3A5105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40C586-9A7F-C972-807D-25A3E3466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F84734-AEEB-D938-245F-CF64525BA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18609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7EA8F0-DDD2-71CF-FA9E-A1FDBEF9C7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E2D434-468A-6150-D523-CAA121493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2354AF-301B-3D4A-B47A-334C9EDC9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707452-2516-169E-B528-327B31F9D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335818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68E074-14CF-236F-032E-D061382BF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37151F-4BC5-DBA4-D37F-9D5117D06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CF21F6B-77AD-158B-8230-7DD95270E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38952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302750-F68E-CBA5-29B8-DA5995EF8A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388" y="542925"/>
            <a:ext cx="2032000" cy="190341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519D40-D00B-6D40-5BB3-ADB4E3D62A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678113" y="1173163"/>
            <a:ext cx="3190875" cy="579437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9340B1-7945-A85A-110A-0CC0BFB681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33388" y="2446338"/>
            <a:ext cx="2032000" cy="453072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545B4D-B397-D991-691D-CB7D194FF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693BD6-B070-05B1-EB43-18B5EB86F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13898C-FD6A-E902-64DE-DE598C3376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1576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0F7762-5439-C555-04C4-F15837108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388" y="542925"/>
            <a:ext cx="2032000" cy="190341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BB1FCC-4319-8DC7-4F4A-E816CC2E37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678113" y="1173163"/>
            <a:ext cx="3190875" cy="57943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28D363-897B-7180-02AB-42B3B84BDA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33388" y="2446338"/>
            <a:ext cx="2032000" cy="453072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E3E044-5A79-8C9D-B284-C3F606C94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4E37B8-4740-B5A2-6747-9811B1A9C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3B28AA-060B-C9AD-05F6-E87256793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30820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815FD9-2F08-822C-046E-28B39E1290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0B46D6-08B6-7C0D-3A1A-1C66E3D8F8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564F87-0B57-4511-F63F-42EB320F0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28AB82-A52A-F1F2-ADDC-58046272D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405EA4-059E-65A1-8078-14A9AA9E3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35885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E359AE-A402-B245-5DC4-246694CF6A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510088" y="433388"/>
            <a:ext cx="1357312" cy="6910387"/>
          </a:xfrm>
        </p:spPr>
        <p:txBody>
          <a:bodyPr vert="eaVert"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6922B7-C082-4463-6128-53C3946381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33388" y="433388"/>
            <a:ext cx="3924300" cy="6910387"/>
          </a:xfrm>
        </p:spPr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63EED2-5F12-C8EA-7615-46D3961A1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A883EB-1255-F494-A342-367C42905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D2DDB9-18A1-9F34-54BC-43997723B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578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7720" y="5239316"/>
            <a:ext cx="5355670" cy="1619356"/>
          </a:xfrm>
        </p:spPr>
        <p:txBody>
          <a:bodyPr anchor="t"/>
          <a:lstStyle>
            <a:lvl1pPr algn="l">
              <a:defRPr sz="2823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97720" y="3455761"/>
            <a:ext cx="5355670" cy="1783556"/>
          </a:xfrm>
        </p:spPr>
        <p:txBody>
          <a:bodyPr anchor="b"/>
          <a:lstStyle>
            <a:lvl1pPr marL="0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1pPr>
            <a:lvl2pPr marL="323094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2pPr>
            <a:lvl3pPr marL="646188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3pPr>
            <a:lvl4pPr marL="969282" indent="0">
              <a:buNone/>
              <a:defRPr sz="974">
                <a:solidFill>
                  <a:schemeClr val="tx1">
                    <a:tint val="75000"/>
                  </a:schemeClr>
                </a:solidFill>
              </a:defRPr>
            </a:lvl4pPr>
            <a:lvl5pPr marL="1292376" indent="0">
              <a:buNone/>
              <a:defRPr sz="974">
                <a:solidFill>
                  <a:schemeClr val="tx1">
                    <a:tint val="75000"/>
                  </a:schemeClr>
                </a:solidFill>
              </a:defRPr>
            </a:lvl5pPr>
            <a:lvl6pPr marL="1615470" indent="0">
              <a:buNone/>
              <a:defRPr sz="974">
                <a:solidFill>
                  <a:schemeClr val="tx1">
                    <a:tint val="75000"/>
                  </a:schemeClr>
                </a:solidFill>
              </a:defRPr>
            </a:lvl6pPr>
            <a:lvl7pPr marL="1938564" indent="0">
              <a:buNone/>
              <a:defRPr sz="974">
                <a:solidFill>
                  <a:schemeClr val="tx1">
                    <a:tint val="75000"/>
                  </a:schemeClr>
                </a:solidFill>
              </a:defRPr>
            </a:lvl7pPr>
            <a:lvl8pPr marL="2261658" indent="0">
              <a:buNone/>
              <a:defRPr sz="974">
                <a:solidFill>
                  <a:schemeClr val="tx1">
                    <a:tint val="75000"/>
                  </a:schemeClr>
                </a:solidFill>
              </a:defRPr>
            </a:lvl8pPr>
            <a:lvl9pPr marL="2584752" indent="0">
              <a:buNone/>
              <a:defRPr sz="97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15039" y="1902462"/>
            <a:ext cx="2782848" cy="5380867"/>
          </a:xfrm>
        </p:spPr>
        <p:txBody>
          <a:bodyPr/>
          <a:lstStyle>
            <a:lvl1pPr>
              <a:defRPr sz="1979"/>
            </a:lvl1pPr>
            <a:lvl2pPr>
              <a:defRPr sz="1688"/>
            </a:lvl2pPr>
            <a:lvl3pPr>
              <a:defRPr sz="1428"/>
            </a:lvl3pPr>
            <a:lvl4pPr>
              <a:defRPr sz="1266"/>
            </a:lvl4pPr>
            <a:lvl5pPr>
              <a:defRPr sz="1266"/>
            </a:lvl5pPr>
            <a:lvl6pPr>
              <a:defRPr sz="1266"/>
            </a:lvl6pPr>
            <a:lvl7pPr>
              <a:defRPr sz="1266"/>
            </a:lvl7pPr>
            <a:lvl8pPr>
              <a:defRPr sz="1266"/>
            </a:lvl8pPr>
            <a:lvl9pPr>
              <a:defRPr sz="1266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202901" y="1902462"/>
            <a:ext cx="2782848" cy="5380867"/>
          </a:xfrm>
        </p:spPr>
        <p:txBody>
          <a:bodyPr/>
          <a:lstStyle>
            <a:lvl1pPr>
              <a:defRPr sz="1979"/>
            </a:lvl1pPr>
            <a:lvl2pPr>
              <a:defRPr sz="1688"/>
            </a:lvl2pPr>
            <a:lvl3pPr>
              <a:defRPr sz="1428"/>
            </a:lvl3pPr>
            <a:lvl4pPr>
              <a:defRPr sz="1266"/>
            </a:lvl4pPr>
            <a:lvl5pPr>
              <a:defRPr sz="1266"/>
            </a:lvl5pPr>
            <a:lvl6pPr>
              <a:defRPr sz="1266"/>
            </a:lvl6pPr>
            <a:lvl7pPr>
              <a:defRPr sz="1266"/>
            </a:lvl7pPr>
            <a:lvl8pPr>
              <a:defRPr sz="1266"/>
            </a:lvl8pPr>
            <a:lvl9pPr>
              <a:defRPr sz="1266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15040" y="1825079"/>
            <a:ext cx="2783942" cy="760606"/>
          </a:xfrm>
        </p:spPr>
        <p:txBody>
          <a:bodyPr anchor="b"/>
          <a:lstStyle>
            <a:lvl1pPr marL="0" indent="0">
              <a:buNone/>
              <a:defRPr sz="1688" b="1"/>
            </a:lvl1pPr>
            <a:lvl2pPr marL="323094" indent="0">
              <a:buNone/>
              <a:defRPr sz="1428" b="1"/>
            </a:lvl2pPr>
            <a:lvl3pPr marL="646188" indent="0">
              <a:buNone/>
              <a:defRPr sz="1266" b="1"/>
            </a:lvl3pPr>
            <a:lvl4pPr marL="969282" indent="0">
              <a:buNone/>
              <a:defRPr sz="1136" b="1"/>
            </a:lvl4pPr>
            <a:lvl5pPr marL="1292376" indent="0">
              <a:buNone/>
              <a:defRPr sz="1136" b="1"/>
            </a:lvl5pPr>
            <a:lvl6pPr marL="1615470" indent="0">
              <a:buNone/>
              <a:defRPr sz="1136" b="1"/>
            </a:lvl6pPr>
            <a:lvl7pPr marL="1938564" indent="0">
              <a:buNone/>
              <a:defRPr sz="1136" b="1"/>
            </a:lvl7pPr>
            <a:lvl8pPr marL="2261658" indent="0">
              <a:buNone/>
              <a:defRPr sz="1136" b="1"/>
            </a:lvl8pPr>
            <a:lvl9pPr marL="2584752" indent="0">
              <a:buNone/>
              <a:defRPr sz="1136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15040" y="2585686"/>
            <a:ext cx="2783942" cy="4697642"/>
          </a:xfrm>
        </p:spPr>
        <p:txBody>
          <a:bodyPr/>
          <a:lstStyle>
            <a:lvl1pPr>
              <a:defRPr sz="1688"/>
            </a:lvl1pPr>
            <a:lvl2pPr>
              <a:defRPr sz="1428"/>
            </a:lvl2pPr>
            <a:lvl3pPr>
              <a:defRPr sz="1266"/>
            </a:lvl3pPr>
            <a:lvl4pPr>
              <a:defRPr sz="1136"/>
            </a:lvl4pPr>
            <a:lvl5pPr>
              <a:defRPr sz="1136"/>
            </a:lvl5pPr>
            <a:lvl6pPr>
              <a:defRPr sz="1136"/>
            </a:lvl6pPr>
            <a:lvl7pPr>
              <a:defRPr sz="1136"/>
            </a:lvl7pPr>
            <a:lvl8pPr>
              <a:defRPr sz="1136"/>
            </a:lvl8pPr>
            <a:lvl9pPr>
              <a:defRPr sz="1136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200714" y="1825079"/>
            <a:ext cx="2785036" cy="760606"/>
          </a:xfrm>
        </p:spPr>
        <p:txBody>
          <a:bodyPr anchor="b"/>
          <a:lstStyle>
            <a:lvl1pPr marL="0" indent="0">
              <a:buNone/>
              <a:defRPr sz="1688" b="1"/>
            </a:lvl1pPr>
            <a:lvl2pPr marL="323094" indent="0">
              <a:buNone/>
              <a:defRPr sz="1428" b="1"/>
            </a:lvl2pPr>
            <a:lvl3pPr marL="646188" indent="0">
              <a:buNone/>
              <a:defRPr sz="1266" b="1"/>
            </a:lvl3pPr>
            <a:lvl4pPr marL="969282" indent="0">
              <a:buNone/>
              <a:defRPr sz="1136" b="1"/>
            </a:lvl4pPr>
            <a:lvl5pPr marL="1292376" indent="0">
              <a:buNone/>
              <a:defRPr sz="1136" b="1"/>
            </a:lvl5pPr>
            <a:lvl6pPr marL="1615470" indent="0">
              <a:buNone/>
              <a:defRPr sz="1136" b="1"/>
            </a:lvl6pPr>
            <a:lvl7pPr marL="1938564" indent="0">
              <a:buNone/>
              <a:defRPr sz="1136" b="1"/>
            </a:lvl7pPr>
            <a:lvl8pPr marL="2261658" indent="0">
              <a:buNone/>
              <a:defRPr sz="1136" b="1"/>
            </a:lvl8pPr>
            <a:lvl9pPr marL="2584752" indent="0">
              <a:buNone/>
              <a:defRPr sz="1136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200714" y="2585686"/>
            <a:ext cx="2785036" cy="4697642"/>
          </a:xfrm>
        </p:spPr>
        <p:txBody>
          <a:bodyPr/>
          <a:lstStyle>
            <a:lvl1pPr>
              <a:defRPr sz="1688"/>
            </a:lvl1pPr>
            <a:lvl2pPr>
              <a:defRPr sz="1428"/>
            </a:lvl2pPr>
            <a:lvl3pPr>
              <a:defRPr sz="1266"/>
            </a:lvl3pPr>
            <a:lvl4pPr>
              <a:defRPr sz="1136"/>
            </a:lvl4pPr>
            <a:lvl5pPr>
              <a:defRPr sz="1136"/>
            </a:lvl5pPr>
            <a:lvl6pPr>
              <a:defRPr sz="1136"/>
            </a:lvl6pPr>
            <a:lvl7pPr>
              <a:defRPr sz="1136"/>
            </a:lvl7pPr>
            <a:lvl8pPr>
              <a:defRPr sz="1136"/>
            </a:lvl8pPr>
            <a:lvl9pPr>
              <a:defRPr sz="1136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15040" y="324627"/>
            <a:ext cx="2072916" cy="1381548"/>
          </a:xfrm>
        </p:spPr>
        <p:txBody>
          <a:bodyPr anchor="b"/>
          <a:lstStyle>
            <a:lvl1pPr algn="l">
              <a:defRPr sz="1428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463434" y="324627"/>
            <a:ext cx="3522316" cy="6958702"/>
          </a:xfrm>
        </p:spPr>
        <p:txBody>
          <a:bodyPr/>
          <a:lstStyle>
            <a:lvl1pPr>
              <a:defRPr sz="2271"/>
            </a:lvl1pPr>
            <a:lvl2pPr>
              <a:defRPr sz="1979"/>
            </a:lvl2pPr>
            <a:lvl3pPr>
              <a:defRPr sz="1688"/>
            </a:lvl3pPr>
            <a:lvl4pPr>
              <a:defRPr sz="1428"/>
            </a:lvl4pPr>
            <a:lvl5pPr>
              <a:defRPr sz="1428"/>
            </a:lvl5pPr>
            <a:lvl6pPr>
              <a:defRPr sz="1428"/>
            </a:lvl6pPr>
            <a:lvl7pPr>
              <a:defRPr sz="1428"/>
            </a:lvl7pPr>
            <a:lvl8pPr>
              <a:defRPr sz="1428"/>
            </a:lvl8pPr>
            <a:lvl9pPr>
              <a:defRPr sz="1428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15040" y="1706176"/>
            <a:ext cx="2072916" cy="5577153"/>
          </a:xfrm>
        </p:spPr>
        <p:txBody>
          <a:bodyPr/>
          <a:lstStyle>
            <a:lvl1pPr marL="0" indent="0">
              <a:buNone/>
              <a:defRPr sz="974"/>
            </a:lvl1pPr>
            <a:lvl2pPr marL="323094" indent="0">
              <a:buNone/>
              <a:defRPr sz="844"/>
            </a:lvl2pPr>
            <a:lvl3pPr marL="646188" indent="0">
              <a:buNone/>
              <a:defRPr sz="714"/>
            </a:lvl3pPr>
            <a:lvl4pPr marL="969282" indent="0">
              <a:buNone/>
              <a:defRPr sz="649"/>
            </a:lvl4pPr>
            <a:lvl5pPr marL="1292376" indent="0">
              <a:buNone/>
              <a:defRPr sz="649"/>
            </a:lvl5pPr>
            <a:lvl6pPr marL="1615470" indent="0">
              <a:buNone/>
              <a:defRPr sz="649"/>
            </a:lvl6pPr>
            <a:lvl7pPr marL="1938564" indent="0">
              <a:buNone/>
              <a:defRPr sz="649"/>
            </a:lvl7pPr>
            <a:lvl8pPr marL="2261658" indent="0">
              <a:buNone/>
              <a:defRPr sz="649"/>
            </a:lvl8pPr>
            <a:lvl9pPr marL="2584752" indent="0">
              <a:buNone/>
              <a:defRPr sz="649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35000" y="5707381"/>
            <a:ext cx="3780473" cy="673789"/>
          </a:xfrm>
        </p:spPr>
        <p:txBody>
          <a:bodyPr anchor="b"/>
          <a:lstStyle>
            <a:lvl1pPr algn="l">
              <a:defRPr sz="1428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35000" y="728521"/>
            <a:ext cx="3780473" cy="4892040"/>
          </a:xfrm>
        </p:spPr>
        <p:txBody>
          <a:bodyPr/>
          <a:lstStyle>
            <a:lvl1pPr marL="0" indent="0">
              <a:buNone/>
              <a:defRPr sz="2271"/>
            </a:lvl1pPr>
            <a:lvl2pPr marL="323094" indent="0">
              <a:buNone/>
              <a:defRPr sz="1979"/>
            </a:lvl2pPr>
            <a:lvl3pPr marL="646188" indent="0">
              <a:buNone/>
              <a:defRPr sz="1688"/>
            </a:lvl3pPr>
            <a:lvl4pPr marL="969282" indent="0">
              <a:buNone/>
              <a:defRPr sz="1428"/>
            </a:lvl4pPr>
            <a:lvl5pPr marL="1292376" indent="0">
              <a:buNone/>
              <a:defRPr sz="1428"/>
            </a:lvl5pPr>
            <a:lvl6pPr marL="1615470" indent="0">
              <a:buNone/>
              <a:defRPr sz="1428"/>
            </a:lvl6pPr>
            <a:lvl7pPr marL="1938564" indent="0">
              <a:buNone/>
              <a:defRPr sz="1428"/>
            </a:lvl7pPr>
            <a:lvl8pPr marL="2261658" indent="0">
              <a:buNone/>
              <a:defRPr sz="1428"/>
            </a:lvl8pPr>
            <a:lvl9pPr marL="2584752" indent="0">
              <a:buNone/>
              <a:defRPr sz="1428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35000" y="6381170"/>
            <a:ext cx="3780473" cy="956891"/>
          </a:xfrm>
        </p:spPr>
        <p:txBody>
          <a:bodyPr/>
          <a:lstStyle>
            <a:lvl1pPr marL="0" indent="0">
              <a:buNone/>
              <a:defRPr sz="974"/>
            </a:lvl1pPr>
            <a:lvl2pPr marL="323094" indent="0">
              <a:buNone/>
              <a:defRPr sz="844"/>
            </a:lvl2pPr>
            <a:lvl3pPr marL="646188" indent="0">
              <a:buNone/>
              <a:defRPr sz="714"/>
            </a:lvl3pPr>
            <a:lvl4pPr marL="969282" indent="0">
              <a:buNone/>
              <a:defRPr sz="649"/>
            </a:lvl4pPr>
            <a:lvl5pPr marL="1292376" indent="0">
              <a:buNone/>
              <a:defRPr sz="649"/>
            </a:lvl5pPr>
            <a:lvl6pPr marL="1615470" indent="0">
              <a:buNone/>
              <a:defRPr sz="649"/>
            </a:lvl6pPr>
            <a:lvl7pPr marL="1938564" indent="0">
              <a:buNone/>
              <a:defRPr sz="649"/>
            </a:lvl7pPr>
            <a:lvl8pPr marL="2261658" indent="0">
              <a:buNone/>
              <a:defRPr sz="649"/>
            </a:lvl8pPr>
            <a:lvl9pPr marL="2584752" indent="0">
              <a:buNone/>
              <a:defRPr sz="649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15041" y="326515"/>
            <a:ext cx="5670709" cy="1358900"/>
          </a:xfrm>
          <a:prstGeom prst="rect">
            <a:avLst/>
          </a:prstGeom>
        </p:spPr>
        <p:txBody>
          <a:bodyPr vert="horz" lIns="199138" tIns="99569" rIns="199138" bIns="99569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15041" y="1902462"/>
            <a:ext cx="5670709" cy="5380867"/>
          </a:xfrm>
          <a:prstGeom prst="rect">
            <a:avLst/>
          </a:prstGeom>
        </p:spPr>
        <p:txBody>
          <a:bodyPr vert="horz" lIns="199138" tIns="99569" rIns="199138" bIns="99569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15039" y="7556994"/>
            <a:ext cx="1470184" cy="434094"/>
          </a:xfrm>
          <a:prstGeom prst="rect">
            <a:avLst/>
          </a:prstGeom>
        </p:spPr>
        <p:txBody>
          <a:bodyPr vert="horz" lIns="199138" tIns="99569" rIns="199138" bIns="99569" rtlCol="0" anchor="ctr"/>
          <a:lstStyle>
            <a:lvl1pPr algn="l">
              <a:defRPr sz="8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25/3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152769" y="7556994"/>
            <a:ext cx="1995250" cy="434094"/>
          </a:xfrm>
          <a:prstGeom prst="rect">
            <a:avLst/>
          </a:prstGeom>
        </p:spPr>
        <p:txBody>
          <a:bodyPr vert="horz" lIns="199138" tIns="99569" rIns="199138" bIns="99569" rtlCol="0" anchor="ctr"/>
          <a:lstStyle>
            <a:lvl1pPr algn="ctr">
              <a:defRPr sz="8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515565" y="7556994"/>
            <a:ext cx="1470184" cy="434094"/>
          </a:xfrm>
          <a:prstGeom prst="rect">
            <a:avLst/>
          </a:prstGeom>
        </p:spPr>
        <p:txBody>
          <a:bodyPr vert="horz" lIns="199138" tIns="99569" rIns="199138" bIns="99569" rtlCol="0" anchor="ctr"/>
          <a:lstStyle>
            <a:lvl1pPr algn="r">
              <a:defRPr sz="8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46188" rtl="0" eaLnBrk="1" latinLnBrk="0" hangingPunct="1">
        <a:spcBef>
          <a:spcPct val="0"/>
        </a:spcBef>
        <a:buNone/>
        <a:defRPr kumimoji="1" sz="31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2320" indent="-242320" algn="l" defTabSz="646188" rtl="0" eaLnBrk="1" latinLnBrk="0" hangingPunct="1">
        <a:spcBef>
          <a:spcPct val="20000"/>
        </a:spcBef>
        <a:buFont typeface="Arial" pitchFamily="34" charset="0"/>
        <a:buChar char="•"/>
        <a:defRPr kumimoji="1" sz="2271" kern="1200">
          <a:solidFill>
            <a:schemeClr val="tx1"/>
          </a:solidFill>
          <a:latin typeface="+mn-lt"/>
          <a:ea typeface="+mn-ea"/>
          <a:cs typeface="+mn-cs"/>
        </a:defRPr>
      </a:lvl1pPr>
      <a:lvl2pPr marL="525028" indent="-201934" algn="l" defTabSz="646188" rtl="0" eaLnBrk="1" latinLnBrk="0" hangingPunct="1">
        <a:spcBef>
          <a:spcPct val="20000"/>
        </a:spcBef>
        <a:buFont typeface="Arial" pitchFamily="34" charset="0"/>
        <a:buChar char="–"/>
        <a:defRPr kumimoji="1" sz="1979" kern="1200">
          <a:solidFill>
            <a:schemeClr val="tx1"/>
          </a:solidFill>
          <a:latin typeface="+mn-lt"/>
          <a:ea typeface="+mn-ea"/>
          <a:cs typeface="+mn-cs"/>
        </a:defRPr>
      </a:lvl2pPr>
      <a:lvl3pPr marL="807735" indent="-161547" algn="l" defTabSz="646188" rtl="0" eaLnBrk="1" latinLnBrk="0" hangingPunct="1">
        <a:spcBef>
          <a:spcPct val="20000"/>
        </a:spcBef>
        <a:buFont typeface="Arial" pitchFamily="34" charset="0"/>
        <a:buChar char="•"/>
        <a:defRPr kumimoji="1" sz="1688" kern="1200">
          <a:solidFill>
            <a:schemeClr val="tx1"/>
          </a:solidFill>
          <a:latin typeface="+mn-lt"/>
          <a:ea typeface="+mn-ea"/>
          <a:cs typeface="+mn-cs"/>
        </a:defRPr>
      </a:lvl3pPr>
      <a:lvl4pPr marL="1130829" indent="-161547" algn="l" defTabSz="646188" rtl="0" eaLnBrk="1" latinLnBrk="0" hangingPunct="1">
        <a:spcBef>
          <a:spcPct val="20000"/>
        </a:spcBef>
        <a:buFont typeface="Arial" pitchFamily="34" charset="0"/>
        <a:buChar char="–"/>
        <a:defRPr kumimoji="1" sz="1428" kern="1200">
          <a:solidFill>
            <a:schemeClr val="tx1"/>
          </a:solidFill>
          <a:latin typeface="+mn-lt"/>
          <a:ea typeface="+mn-ea"/>
          <a:cs typeface="+mn-cs"/>
        </a:defRPr>
      </a:lvl4pPr>
      <a:lvl5pPr marL="1453924" indent="-161547" algn="l" defTabSz="646188" rtl="0" eaLnBrk="1" latinLnBrk="0" hangingPunct="1">
        <a:spcBef>
          <a:spcPct val="20000"/>
        </a:spcBef>
        <a:buFont typeface="Arial" pitchFamily="34" charset="0"/>
        <a:buChar char="»"/>
        <a:defRPr kumimoji="1" sz="1428" kern="1200">
          <a:solidFill>
            <a:schemeClr val="tx1"/>
          </a:solidFill>
          <a:latin typeface="+mn-lt"/>
          <a:ea typeface="+mn-ea"/>
          <a:cs typeface="+mn-cs"/>
        </a:defRPr>
      </a:lvl5pPr>
      <a:lvl6pPr marL="1777017" indent="-161547" algn="l" defTabSz="646188" rtl="0" eaLnBrk="1" latinLnBrk="0" hangingPunct="1">
        <a:spcBef>
          <a:spcPct val="20000"/>
        </a:spcBef>
        <a:buFont typeface="Arial" pitchFamily="34" charset="0"/>
        <a:buChar char="•"/>
        <a:defRPr kumimoji="1" sz="1428" kern="1200">
          <a:solidFill>
            <a:schemeClr val="tx1"/>
          </a:solidFill>
          <a:latin typeface="+mn-lt"/>
          <a:ea typeface="+mn-ea"/>
          <a:cs typeface="+mn-cs"/>
        </a:defRPr>
      </a:lvl6pPr>
      <a:lvl7pPr marL="2100111" indent="-161547" algn="l" defTabSz="646188" rtl="0" eaLnBrk="1" latinLnBrk="0" hangingPunct="1">
        <a:spcBef>
          <a:spcPct val="20000"/>
        </a:spcBef>
        <a:buFont typeface="Arial" pitchFamily="34" charset="0"/>
        <a:buChar char="•"/>
        <a:defRPr kumimoji="1" sz="1428" kern="1200">
          <a:solidFill>
            <a:schemeClr val="tx1"/>
          </a:solidFill>
          <a:latin typeface="+mn-lt"/>
          <a:ea typeface="+mn-ea"/>
          <a:cs typeface="+mn-cs"/>
        </a:defRPr>
      </a:lvl7pPr>
      <a:lvl8pPr marL="2423205" indent="-161547" algn="l" defTabSz="646188" rtl="0" eaLnBrk="1" latinLnBrk="0" hangingPunct="1">
        <a:spcBef>
          <a:spcPct val="20000"/>
        </a:spcBef>
        <a:buFont typeface="Arial" pitchFamily="34" charset="0"/>
        <a:buChar char="•"/>
        <a:defRPr kumimoji="1" sz="1428" kern="1200">
          <a:solidFill>
            <a:schemeClr val="tx1"/>
          </a:solidFill>
          <a:latin typeface="+mn-lt"/>
          <a:ea typeface="+mn-ea"/>
          <a:cs typeface="+mn-cs"/>
        </a:defRPr>
      </a:lvl8pPr>
      <a:lvl9pPr marL="2746300" indent="-161547" algn="l" defTabSz="646188" rtl="0" eaLnBrk="1" latinLnBrk="0" hangingPunct="1">
        <a:spcBef>
          <a:spcPct val="20000"/>
        </a:spcBef>
        <a:buFont typeface="Arial" pitchFamily="34" charset="0"/>
        <a:buChar char="•"/>
        <a:defRPr kumimoji="1" sz="14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46188" rtl="0" eaLnBrk="1" latinLnBrk="0" hangingPunct="1">
        <a:defRPr kumimoji="1" sz="1266" kern="1200">
          <a:solidFill>
            <a:schemeClr val="tx1"/>
          </a:solidFill>
          <a:latin typeface="+mn-lt"/>
          <a:ea typeface="+mn-ea"/>
          <a:cs typeface="+mn-cs"/>
        </a:defRPr>
      </a:lvl1pPr>
      <a:lvl2pPr marL="323094" algn="l" defTabSz="646188" rtl="0" eaLnBrk="1" latinLnBrk="0" hangingPunct="1">
        <a:defRPr kumimoji="1" sz="1266" kern="1200">
          <a:solidFill>
            <a:schemeClr val="tx1"/>
          </a:solidFill>
          <a:latin typeface="+mn-lt"/>
          <a:ea typeface="+mn-ea"/>
          <a:cs typeface="+mn-cs"/>
        </a:defRPr>
      </a:lvl2pPr>
      <a:lvl3pPr marL="646188" algn="l" defTabSz="646188" rtl="0" eaLnBrk="1" latinLnBrk="0" hangingPunct="1">
        <a:defRPr kumimoji="1" sz="1266" kern="1200">
          <a:solidFill>
            <a:schemeClr val="tx1"/>
          </a:solidFill>
          <a:latin typeface="+mn-lt"/>
          <a:ea typeface="+mn-ea"/>
          <a:cs typeface="+mn-cs"/>
        </a:defRPr>
      </a:lvl3pPr>
      <a:lvl4pPr marL="969282" algn="l" defTabSz="646188" rtl="0" eaLnBrk="1" latinLnBrk="0" hangingPunct="1">
        <a:defRPr kumimoji="1" sz="1266" kern="1200">
          <a:solidFill>
            <a:schemeClr val="tx1"/>
          </a:solidFill>
          <a:latin typeface="+mn-lt"/>
          <a:ea typeface="+mn-ea"/>
          <a:cs typeface="+mn-cs"/>
        </a:defRPr>
      </a:lvl4pPr>
      <a:lvl5pPr marL="1292376" algn="l" defTabSz="646188" rtl="0" eaLnBrk="1" latinLnBrk="0" hangingPunct="1">
        <a:defRPr kumimoji="1" sz="1266" kern="1200">
          <a:solidFill>
            <a:schemeClr val="tx1"/>
          </a:solidFill>
          <a:latin typeface="+mn-lt"/>
          <a:ea typeface="+mn-ea"/>
          <a:cs typeface="+mn-cs"/>
        </a:defRPr>
      </a:lvl5pPr>
      <a:lvl6pPr marL="1615470" algn="l" defTabSz="646188" rtl="0" eaLnBrk="1" latinLnBrk="0" hangingPunct="1">
        <a:defRPr kumimoji="1" sz="1266" kern="1200">
          <a:solidFill>
            <a:schemeClr val="tx1"/>
          </a:solidFill>
          <a:latin typeface="+mn-lt"/>
          <a:ea typeface="+mn-ea"/>
          <a:cs typeface="+mn-cs"/>
        </a:defRPr>
      </a:lvl6pPr>
      <a:lvl7pPr marL="1938564" algn="l" defTabSz="646188" rtl="0" eaLnBrk="1" latinLnBrk="0" hangingPunct="1">
        <a:defRPr kumimoji="1" sz="1266" kern="1200">
          <a:solidFill>
            <a:schemeClr val="tx1"/>
          </a:solidFill>
          <a:latin typeface="+mn-lt"/>
          <a:ea typeface="+mn-ea"/>
          <a:cs typeface="+mn-cs"/>
        </a:defRPr>
      </a:lvl7pPr>
      <a:lvl8pPr marL="2261658" algn="l" defTabSz="646188" rtl="0" eaLnBrk="1" latinLnBrk="0" hangingPunct="1">
        <a:defRPr kumimoji="1" sz="1266" kern="1200">
          <a:solidFill>
            <a:schemeClr val="tx1"/>
          </a:solidFill>
          <a:latin typeface="+mn-lt"/>
          <a:ea typeface="+mn-ea"/>
          <a:cs typeface="+mn-cs"/>
        </a:defRPr>
      </a:lvl8pPr>
      <a:lvl9pPr marL="2584752" algn="l" defTabSz="646188" rtl="0" eaLnBrk="1" latinLnBrk="0" hangingPunct="1">
        <a:defRPr kumimoji="1" sz="126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7574EE-CB46-7A7B-76B5-8804E8F30E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388" y="433388"/>
            <a:ext cx="5434012" cy="15763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C40DD5-04FF-2BBC-6229-77D6CA0F77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33388" y="2170113"/>
            <a:ext cx="5434012" cy="51736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115B76-1C29-E358-8AE9-D354613AD1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33388" y="7556500"/>
            <a:ext cx="1417637" cy="434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91DAA-F310-458F-8F61-97DD2D9BD523}" type="datetimeFigureOut">
              <a:rPr kumimoji="1" lang="ja-JP" altLang="en-US" smtClean="0"/>
              <a:t>2025/3/20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5EAACF-9C7A-7D97-40AE-3AD21D7289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087563" y="7556500"/>
            <a:ext cx="2125662" cy="434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E8EC60-5B0A-BB59-1734-5C1D6724F5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449763" y="7556500"/>
            <a:ext cx="1417637" cy="434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71D696-3322-4486-AD38-060B15A9B0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788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FEF6B4-C148-503A-3DA0-6E57CCF4C8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682C4472-D1A6-B4A9-57A3-676F83B9910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236" y="574862"/>
            <a:ext cx="5725668" cy="2300173"/>
          </a:xfrm>
          <a:prstGeom prst="rect">
            <a:avLst/>
          </a:prstGeom>
        </p:spPr>
      </p:pic>
      <p:grpSp>
        <p:nvGrpSpPr>
          <p:cNvPr id="230" name="Group 229">
            <a:extLst>
              <a:ext uri="{FF2B5EF4-FFF2-40B4-BE49-F238E27FC236}">
                <a16:creationId xmlns:a16="http://schemas.microsoft.com/office/drawing/2014/main" id="{F2398B66-E513-0727-A4DF-67A03123C660}"/>
              </a:ext>
            </a:extLst>
          </p:cNvPr>
          <p:cNvGrpSpPr/>
          <p:nvPr/>
        </p:nvGrpSpPr>
        <p:grpSpPr>
          <a:xfrm>
            <a:off x="929324" y="431125"/>
            <a:ext cx="4850947" cy="2515487"/>
            <a:chOff x="929324" y="431125"/>
            <a:chExt cx="4850947" cy="2515487"/>
          </a:xfrm>
        </p:grpSpPr>
        <p:grpSp>
          <p:nvGrpSpPr>
            <p:cNvPr id="159" name="Group 158">
              <a:extLst>
                <a:ext uri="{FF2B5EF4-FFF2-40B4-BE49-F238E27FC236}">
                  <a16:creationId xmlns:a16="http://schemas.microsoft.com/office/drawing/2014/main" id="{1475A558-BC2E-5B1C-CA6C-6AE9A22570BD}"/>
                </a:ext>
              </a:extLst>
            </p:cNvPr>
            <p:cNvGrpSpPr/>
            <p:nvPr/>
          </p:nvGrpSpPr>
          <p:grpSpPr>
            <a:xfrm>
              <a:off x="929324" y="431125"/>
              <a:ext cx="4850947" cy="2502311"/>
              <a:chOff x="929324" y="431125"/>
              <a:chExt cx="4850947" cy="2502311"/>
            </a:xfrm>
          </p:grpSpPr>
          <p:sp>
            <p:nvSpPr>
              <p:cNvPr id="20" name="Freeform: Shape 19">
                <a:extLst>
                  <a:ext uri="{FF2B5EF4-FFF2-40B4-BE49-F238E27FC236}">
                    <a16:creationId xmlns:a16="http://schemas.microsoft.com/office/drawing/2014/main" id="{B5D1CAA8-48EF-DD4E-2C5C-97F67A00DFF0}"/>
                  </a:ext>
                </a:extLst>
              </p:cNvPr>
              <p:cNvSpPr/>
              <p:nvPr/>
            </p:nvSpPr>
            <p:spPr>
              <a:xfrm rot="19461561">
                <a:off x="1227023" y="690217"/>
                <a:ext cx="2607638" cy="2062826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899365"/>
                  <a:gd name="connsiteY0" fmla="*/ 17685 h 264215"/>
                  <a:gd name="connsiteX1" fmla="*/ 634896 w 899365"/>
                  <a:gd name="connsiteY1" fmla="*/ 9630 h 264215"/>
                  <a:gd name="connsiteX2" fmla="*/ 838846 w 899365"/>
                  <a:gd name="connsiteY2" fmla="*/ 179450 h 264215"/>
                  <a:gd name="connsiteX3" fmla="*/ 899365 w 899365"/>
                  <a:gd name="connsiteY3" fmla="*/ 264215 h 264215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838846 w 899365"/>
                  <a:gd name="connsiteY2" fmla="*/ 161765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705863 w 899365"/>
                  <a:gd name="connsiteY2" fmla="*/ 120337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164737 w 899365"/>
                  <a:gd name="connsiteY1" fmla="*/ 4845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1191533"/>
                  <a:gd name="connsiteY0" fmla="*/ 0 h 614340"/>
                  <a:gd name="connsiteX1" fmla="*/ 456905 w 1191533"/>
                  <a:gd name="connsiteY1" fmla="*/ 416265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785181 w 1191533"/>
                  <a:gd name="connsiteY2" fmla="*/ 477195 h 614340"/>
                  <a:gd name="connsiteX3" fmla="*/ 1191533 w 1191533"/>
                  <a:gd name="connsiteY3" fmla="*/ 614340 h 614340"/>
                  <a:gd name="connsiteX0" fmla="*/ 0 w 1359842"/>
                  <a:gd name="connsiteY0" fmla="*/ 0 h 1178527"/>
                  <a:gd name="connsiteX1" fmla="*/ 508766 w 1359842"/>
                  <a:gd name="connsiteY1" fmla="*/ 954016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59842"/>
                  <a:gd name="connsiteY0" fmla="*/ 0 h 1178527"/>
                  <a:gd name="connsiteX1" fmla="*/ 453857 w 1359842"/>
                  <a:gd name="connsiteY1" fmla="*/ 896315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97513"/>
                  <a:gd name="connsiteY0" fmla="*/ 0 h 1299748"/>
                  <a:gd name="connsiteX1" fmla="*/ 491528 w 1397513"/>
                  <a:gd name="connsiteY1" fmla="*/ 1017536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1397513 w 1397513"/>
                  <a:gd name="connsiteY2" fmla="*/ 1299748 h 1299748"/>
                  <a:gd name="connsiteX0" fmla="*/ 0 w 1367953"/>
                  <a:gd name="connsiteY0" fmla="*/ 0 h 1296690"/>
                  <a:gd name="connsiteX1" fmla="*/ 508687 w 1367953"/>
                  <a:gd name="connsiteY1" fmla="*/ 1009350 h 1296690"/>
                  <a:gd name="connsiteX2" fmla="*/ 1367953 w 1367953"/>
                  <a:gd name="connsiteY2" fmla="*/ 1296690 h 1296690"/>
                  <a:gd name="connsiteX0" fmla="*/ 0 w 1367953"/>
                  <a:gd name="connsiteY0" fmla="*/ 0 h 1296690"/>
                  <a:gd name="connsiteX1" fmla="*/ 544175 w 1367953"/>
                  <a:gd name="connsiteY1" fmla="*/ 1001954 h 1296690"/>
                  <a:gd name="connsiteX2" fmla="*/ 1367953 w 1367953"/>
                  <a:gd name="connsiteY2" fmla="*/ 1296690 h 1296690"/>
                  <a:gd name="connsiteX0" fmla="*/ 0 w 1354849"/>
                  <a:gd name="connsiteY0" fmla="*/ 0 h 1363958"/>
                  <a:gd name="connsiteX1" fmla="*/ 531071 w 1354849"/>
                  <a:gd name="connsiteY1" fmla="*/ 1069222 h 1363958"/>
                  <a:gd name="connsiteX2" fmla="*/ 1354849 w 1354849"/>
                  <a:gd name="connsiteY2" fmla="*/ 1363958 h 1363958"/>
                  <a:gd name="connsiteX0" fmla="*/ 0 w 933906"/>
                  <a:gd name="connsiteY0" fmla="*/ 0 h 1322623"/>
                  <a:gd name="connsiteX1" fmla="*/ 110128 w 933906"/>
                  <a:gd name="connsiteY1" fmla="*/ 1027887 h 1322623"/>
                  <a:gd name="connsiteX2" fmla="*/ 933906 w 933906"/>
                  <a:gd name="connsiteY2" fmla="*/ 1322623 h 1322623"/>
                  <a:gd name="connsiteX0" fmla="*/ 0 w 933906"/>
                  <a:gd name="connsiteY0" fmla="*/ 71559 h 1394182"/>
                  <a:gd name="connsiteX1" fmla="*/ 19820 w 933906"/>
                  <a:gd name="connsiteY1" fmla="*/ 77478 h 1394182"/>
                  <a:gd name="connsiteX2" fmla="*/ 110128 w 933906"/>
                  <a:gd name="connsiteY2" fmla="*/ 1099446 h 1394182"/>
                  <a:gd name="connsiteX3" fmla="*/ 933906 w 933906"/>
                  <a:gd name="connsiteY3" fmla="*/ 1394182 h 1394182"/>
                  <a:gd name="connsiteX0" fmla="*/ 0 w 933906"/>
                  <a:gd name="connsiteY0" fmla="*/ 76723 h 1399346"/>
                  <a:gd name="connsiteX1" fmla="*/ 230331 w 933906"/>
                  <a:gd name="connsiteY1" fmla="*/ 75643 h 1399346"/>
                  <a:gd name="connsiteX2" fmla="*/ 110128 w 933906"/>
                  <a:gd name="connsiteY2" fmla="*/ 1104610 h 1399346"/>
                  <a:gd name="connsiteX3" fmla="*/ 933906 w 933906"/>
                  <a:gd name="connsiteY3" fmla="*/ 1399346 h 1399346"/>
                  <a:gd name="connsiteX0" fmla="*/ 0 w 933906"/>
                  <a:gd name="connsiteY0" fmla="*/ 10001 h 1332624"/>
                  <a:gd name="connsiteX1" fmla="*/ 48053 w 933906"/>
                  <a:gd name="connsiteY1" fmla="*/ 120669 h 1332624"/>
                  <a:gd name="connsiteX2" fmla="*/ 110128 w 933906"/>
                  <a:gd name="connsiteY2" fmla="*/ 1037888 h 1332624"/>
                  <a:gd name="connsiteX3" fmla="*/ 933906 w 933906"/>
                  <a:gd name="connsiteY3" fmla="*/ 1332624 h 1332624"/>
                  <a:gd name="connsiteX0" fmla="*/ 309248 w 904419"/>
                  <a:gd name="connsiteY0" fmla="*/ 37164 h 1305927"/>
                  <a:gd name="connsiteX1" fmla="*/ 18566 w 904419"/>
                  <a:gd name="connsiteY1" fmla="*/ 93972 h 1305927"/>
                  <a:gd name="connsiteX2" fmla="*/ 80641 w 904419"/>
                  <a:gd name="connsiteY2" fmla="*/ 1011191 h 1305927"/>
                  <a:gd name="connsiteX3" fmla="*/ 904419 w 904419"/>
                  <a:gd name="connsiteY3" fmla="*/ 1305927 h 1305927"/>
                  <a:gd name="connsiteX0" fmla="*/ 295426 w 890597"/>
                  <a:gd name="connsiteY0" fmla="*/ 94090 h 1362853"/>
                  <a:gd name="connsiteX1" fmla="*/ 37972 w 890597"/>
                  <a:gd name="connsiteY1" fmla="*/ 70216 h 1362853"/>
                  <a:gd name="connsiteX2" fmla="*/ 66819 w 890597"/>
                  <a:gd name="connsiteY2" fmla="*/ 1068117 h 1362853"/>
                  <a:gd name="connsiteX3" fmla="*/ 890597 w 890597"/>
                  <a:gd name="connsiteY3" fmla="*/ 1362853 h 1362853"/>
                  <a:gd name="connsiteX0" fmla="*/ 423650 w 890597"/>
                  <a:gd name="connsiteY0" fmla="*/ 143628 h 1351532"/>
                  <a:gd name="connsiteX1" fmla="*/ 37972 w 890597"/>
                  <a:gd name="connsiteY1" fmla="*/ 58895 h 1351532"/>
                  <a:gd name="connsiteX2" fmla="*/ 66819 w 890597"/>
                  <a:gd name="connsiteY2" fmla="*/ 1056796 h 1351532"/>
                  <a:gd name="connsiteX3" fmla="*/ 890597 w 890597"/>
                  <a:gd name="connsiteY3" fmla="*/ 1351532 h 1351532"/>
                  <a:gd name="connsiteX0" fmla="*/ 459818 w 926765"/>
                  <a:gd name="connsiteY0" fmla="*/ 143628 h 1351532"/>
                  <a:gd name="connsiteX1" fmla="*/ 74140 w 926765"/>
                  <a:gd name="connsiteY1" fmla="*/ 58895 h 1351532"/>
                  <a:gd name="connsiteX2" fmla="*/ 55176 w 926765"/>
                  <a:gd name="connsiteY2" fmla="*/ 997615 h 1351532"/>
                  <a:gd name="connsiteX3" fmla="*/ 926765 w 926765"/>
                  <a:gd name="connsiteY3" fmla="*/ 1351532 h 1351532"/>
                  <a:gd name="connsiteX0" fmla="*/ 830546 w 1297493"/>
                  <a:gd name="connsiteY0" fmla="*/ 190984 h 1398888"/>
                  <a:gd name="connsiteX1" fmla="*/ 292 w 1297493"/>
                  <a:gd name="connsiteY1" fmla="*/ 51402 h 1398888"/>
                  <a:gd name="connsiteX2" fmla="*/ 425904 w 1297493"/>
                  <a:gd name="connsiteY2" fmla="*/ 1044971 h 1398888"/>
                  <a:gd name="connsiteX3" fmla="*/ 1297493 w 1297493"/>
                  <a:gd name="connsiteY3" fmla="*/ 1398888 h 1398888"/>
                  <a:gd name="connsiteX0" fmla="*/ 3193 w 1306252"/>
                  <a:gd name="connsiteY0" fmla="*/ 0 h 1609851"/>
                  <a:gd name="connsiteX1" fmla="*/ 9051 w 1306252"/>
                  <a:gd name="connsiteY1" fmla="*/ 262365 h 1609851"/>
                  <a:gd name="connsiteX2" fmla="*/ 434663 w 1306252"/>
                  <a:gd name="connsiteY2" fmla="*/ 1255934 h 1609851"/>
                  <a:gd name="connsiteX3" fmla="*/ 1306252 w 1306252"/>
                  <a:gd name="connsiteY3" fmla="*/ 1609851 h 1609851"/>
                  <a:gd name="connsiteX0" fmla="*/ 102907 w 1405966"/>
                  <a:gd name="connsiteY0" fmla="*/ 0 h 1609851"/>
                  <a:gd name="connsiteX1" fmla="*/ 1872 w 1405966"/>
                  <a:gd name="connsiteY1" fmla="*/ 390525 h 1609851"/>
                  <a:gd name="connsiteX2" fmla="*/ 534377 w 1405966"/>
                  <a:gd name="connsiteY2" fmla="*/ 1255934 h 1609851"/>
                  <a:gd name="connsiteX3" fmla="*/ 1405966 w 1405966"/>
                  <a:gd name="connsiteY3" fmla="*/ 1609851 h 1609851"/>
                  <a:gd name="connsiteX0" fmla="*/ 0 w 1523070"/>
                  <a:gd name="connsiteY0" fmla="*/ 0 h 1523658"/>
                  <a:gd name="connsiteX1" fmla="*/ 118976 w 1523070"/>
                  <a:gd name="connsiteY1" fmla="*/ 304332 h 1523658"/>
                  <a:gd name="connsiteX2" fmla="*/ 651481 w 1523070"/>
                  <a:gd name="connsiteY2" fmla="*/ 1169741 h 1523658"/>
                  <a:gd name="connsiteX3" fmla="*/ 1523070 w 1523070"/>
                  <a:gd name="connsiteY3" fmla="*/ 1523658 h 1523658"/>
                  <a:gd name="connsiteX0" fmla="*/ 925 w 1523995"/>
                  <a:gd name="connsiteY0" fmla="*/ 0 h 1523658"/>
                  <a:gd name="connsiteX1" fmla="*/ 84924 w 1523995"/>
                  <a:gd name="connsiteY1" fmla="*/ 341873 h 1523658"/>
                  <a:gd name="connsiteX2" fmla="*/ 652406 w 1523995"/>
                  <a:gd name="connsiteY2" fmla="*/ 1169741 h 1523658"/>
                  <a:gd name="connsiteX3" fmla="*/ 1523995 w 1523995"/>
                  <a:gd name="connsiteY3" fmla="*/ 1523658 h 1523658"/>
                  <a:gd name="connsiteX0" fmla="*/ 0 w 1523070"/>
                  <a:gd name="connsiteY0" fmla="*/ 0 h 1523658"/>
                  <a:gd name="connsiteX1" fmla="*/ 108482 w 1523070"/>
                  <a:gd name="connsiteY1" fmla="*/ 407357 h 1523658"/>
                  <a:gd name="connsiteX2" fmla="*/ 651481 w 1523070"/>
                  <a:gd name="connsiteY2" fmla="*/ 1169741 h 1523658"/>
                  <a:gd name="connsiteX3" fmla="*/ 1523070 w 1523070"/>
                  <a:gd name="connsiteY3" fmla="*/ 1523658 h 152365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523070" h="1523658">
                    <a:moveTo>
                      <a:pt x="0" y="0"/>
                    </a:moveTo>
                    <a:cubicBezTo>
                      <a:pt x="3303" y="987"/>
                      <a:pt x="-98" y="212400"/>
                      <a:pt x="108482" y="407357"/>
                    </a:cubicBezTo>
                    <a:cubicBezTo>
                      <a:pt x="217062" y="602314"/>
                      <a:pt x="435281" y="945160"/>
                      <a:pt x="651481" y="1169741"/>
                    </a:cubicBezTo>
                    <a:cubicBezTo>
                      <a:pt x="867681" y="1394322"/>
                      <a:pt x="1337898" y="1463159"/>
                      <a:pt x="1523070" y="1523658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Oval 12">
                <a:extLst>
                  <a:ext uri="{FF2B5EF4-FFF2-40B4-BE49-F238E27FC236}">
                    <a16:creationId xmlns:a16="http://schemas.microsoft.com/office/drawing/2014/main" id="{A43FD42F-A69D-E95F-FED7-41475F709BCB}"/>
                  </a:ext>
                </a:extLst>
              </p:cNvPr>
              <p:cNvSpPr/>
              <p:nvPr/>
            </p:nvSpPr>
            <p:spPr>
              <a:xfrm rot="1830438">
                <a:off x="4104575" y="1668487"/>
                <a:ext cx="720080" cy="302984"/>
              </a:xfrm>
              <a:prstGeom prst="ellipse">
                <a:avLst/>
              </a:prstGeom>
              <a:solidFill>
                <a:srgbClr val="FF0000">
                  <a:alpha val="20000"/>
                </a:srgbClr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en-US" sz="90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790E37F-7738-3BA4-45B4-FF2CCD5533C3}"/>
                  </a:ext>
                </a:extLst>
              </p:cNvPr>
              <p:cNvSpPr txBox="1"/>
              <p:nvPr/>
            </p:nvSpPr>
            <p:spPr>
              <a:xfrm>
                <a:off x="4239206" y="1721059"/>
                <a:ext cx="51722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B7/B6</a:t>
                </a:r>
              </a:p>
            </p:txBody>
          </p:sp>
          <p:sp>
            <p:nvSpPr>
              <p:cNvPr id="18" name="Oval 17">
                <a:extLst>
                  <a:ext uri="{FF2B5EF4-FFF2-40B4-BE49-F238E27FC236}">
                    <a16:creationId xmlns:a16="http://schemas.microsoft.com/office/drawing/2014/main" id="{3BD7761D-69C0-578B-F5DF-C37DC50A0DED}"/>
                  </a:ext>
                </a:extLst>
              </p:cNvPr>
              <p:cNvSpPr/>
              <p:nvPr/>
            </p:nvSpPr>
            <p:spPr>
              <a:xfrm rot="1830438">
                <a:off x="4004292" y="1995860"/>
                <a:ext cx="720080" cy="238756"/>
              </a:xfrm>
              <a:prstGeom prst="ellipse">
                <a:avLst/>
              </a:prstGeom>
              <a:solidFill>
                <a:srgbClr val="00B0F0">
                  <a:alpha val="20000"/>
                </a:srgbClr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en-US" sz="900"/>
              </a:p>
            </p:txBody>
          </p:sp>
          <p:sp>
            <p:nvSpPr>
              <p:cNvPr id="19" name="Oval 18">
                <a:extLst>
                  <a:ext uri="{FF2B5EF4-FFF2-40B4-BE49-F238E27FC236}">
                    <a16:creationId xmlns:a16="http://schemas.microsoft.com/office/drawing/2014/main" id="{1EDA4E5A-5E02-1E68-F26A-D9568EDE6030}"/>
                  </a:ext>
                </a:extLst>
              </p:cNvPr>
              <p:cNvSpPr/>
              <p:nvPr/>
            </p:nvSpPr>
            <p:spPr>
              <a:xfrm rot="1830438">
                <a:off x="4004336" y="2231342"/>
                <a:ext cx="427869" cy="238756"/>
              </a:xfrm>
              <a:prstGeom prst="ellipse">
                <a:avLst/>
              </a:prstGeom>
              <a:solidFill>
                <a:srgbClr val="92D050">
                  <a:alpha val="20000"/>
                </a:srgbClr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en-US" sz="90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5CB94FAC-2BE5-D0EB-47AA-66430D2CD434}"/>
                  </a:ext>
                </a:extLst>
              </p:cNvPr>
              <p:cNvSpPr txBox="1"/>
              <p:nvPr/>
            </p:nvSpPr>
            <p:spPr>
              <a:xfrm>
                <a:off x="4138543" y="2011218"/>
                <a:ext cx="55810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B8/B5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386FAF36-52B3-0DC2-B5F7-11EBB2F61309}"/>
                  </a:ext>
                </a:extLst>
              </p:cNvPr>
              <p:cNvSpPr txBox="1"/>
              <p:nvPr/>
            </p:nvSpPr>
            <p:spPr>
              <a:xfrm>
                <a:off x="4055821" y="2225334"/>
                <a:ext cx="3600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B9</a:t>
                </a:r>
              </a:p>
            </p:txBody>
          </p:sp>
          <p:sp>
            <p:nvSpPr>
              <p:cNvPr id="28" name="Oval 27">
                <a:extLst>
                  <a:ext uri="{FF2B5EF4-FFF2-40B4-BE49-F238E27FC236}">
                    <a16:creationId xmlns:a16="http://schemas.microsoft.com/office/drawing/2014/main" id="{F5743088-0E48-81A0-E04C-1E13259B02C4}"/>
                  </a:ext>
                </a:extLst>
              </p:cNvPr>
              <p:cNvSpPr/>
              <p:nvPr/>
            </p:nvSpPr>
            <p:spPr>
              <a:xfrm>
                <a:off x="4935698" y="2020127"/>
                <a:ext cx="321528" cy="238756"/>
              </a:xfrm>
              <a:prstGeom prst="ellipse">
                <a:avLst/>
              </a:prstGeom>
              <a:solidFill>
                <a:schemeClr val="bg1">
                  <a:lumMod val="75000"/>
                  <a:alpha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en-US" sz="9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CB54670-7787-6935-35BB-542AFE1843B2}"/>
                  </a:ext>
                </a:extLst>
              </p:cNvPr>
              <p:cNvSpPr txBox="1"/>
              <p:nvPr/>
            </p:nvSpPr>
            <p:spPr>
              <a:xfrm>
                <a:off x="4933962" y="2020127"/>
                <a:ext cx="3600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B4</a:t>
                </a:r>
              </a:p>
            </p:txBody>
          </p:sp>
          <p:sp>
            <p:nvSpPr>
              <p:cNvPr id="32" name="Oval 31">
                <a:extLst>
                  <a:ext uri="{FF2B5EF4-FFF2-40B4-BE49-F238E27FC236}">
                    <a16:creationId xmlns:a16="http://schemas.microsoft.com/office/drawing/2014/main" id="{DD0AE605-7C20-5455-7C01-7DFB941BE470}"/>
                  </a:ext>
                </a:extLst>
              </p:cNvPr>
              <p:cNvSpPr/>
              <p:nvPr/>
            </p:nvSpPr>
            <p:spPr>
              <a:xfrm>
                <a:off x="4736422" y="2449620"/>
                <a:ext cx="968310" cy="238756"/>
              </a:xfrm>
              <a:prstGeom prst="ellipse">
                <a:avLst/>
              </a:prstGeom>
              <a:solidFill>
                <a:schemeClr val="bg1">
                  <a:lumMod val="85000"/>
                  <a:alpha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en-US" sz="90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D4F63DFC-4838-A271-70B6-B801E10AFBAA}"/>
                  </a:ext>
                </a:extLst>
              </p:cNvPr>
              <p:cNvSpPr txBox="1"/>
              <p:nvPr/>
            </p:nvSpPr>
            <p:spPr>
              <a:xfrm>
                <a:off x="4887739" y="2451225"/>
                <a:ext cx="74297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B3/B1/B2</a:t>
                </a:r>
              </a:p>
            </p:txBody>
          </p:sp>
          <p:sp>
            <p:nvSpPr>
              <p:cNvPr id="39" name="Freeform: Shape 38">
                <a:extLst>
                  <a:ext uri="{FF2B5EF4-FFF2-40B4-BE49-F238E27FC236}">
                    <a16:creationId xmlns:a16="http://schemas.microsoft.com/office/drawing/2014/main" id="{7D1E5FB4-A020-7909-CA4C-B4C2865FD9C0}"/>
                  </a:ext>
                </a:extLst>
              </p:cNvPr>
              <p:cNvSpPr/>
              <p:nvPr/>
            </p:nvSpPr>
            <p:spPr>
              <a:xfrm>
                <a:off x="5248425" y="2193550"/>
                <a:ext cx="438150" cy="204788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38150" h="204788">
                    <a:moveTo>
                      <a:pt x="0" y="0"/>
                    </a:moveTo>
                    <a:cubicBezTo>
                      <a:pt x="53181" y="3572"/>
                      <a:pt x="106363" y="7144"/>
                      <a:pt x="161925" y="23813"/>
                    </a:cubicBezTo>
                    <a:cubicBezTo>
                      <a:pt x="217488" y="40482"/>
                      <a:pt x="287338" y="69851"/>
                      <a:pt x="333375" y="100013"/>
                    </a:cubicBezTo>
                    <a:cubicBezTo>
                      <a:pt x="379412" y="130175"/>
                      <a:pt x="408781" y="167481"/>
                      <a:pt x="438150" y="204788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" name="Freeform: Shape 39">
                <a:extLst>
                  <a:ext uri="{FF2B5EF4-FFF2-40B4-BE49-F238E27FC236}">
                    <a16:creationId xmlns:a16="http://schemas.microsoft.com/office/drawing/2014/main" id="{313B122F-B8B3-AA51-6772-6F890ECB792D}"/>
                  </a:ext>
                </a:extLst>
              </p:cNvPr>
              <p:cNvSpPr/>
              <p:nvPr/>
            </p:nvSpPr>
            <p:spPr>
              <a:xfrm>
                <a:off x="5257951" y="2149116"/>
                <a:ext cx="438150" cy="204788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38150" h="204788">
                    <a:moveTo>
                      <a:pt x="0" y="0"/>
                    </a:moveTo>
                    <a:cubicBezTo>
                      <a:pt x="53181" y="3572"/>
                      <a:pt x="106363" y="7144"/>
                      <a:pt x="161925" y="23813"/>
                    </a:cubicBezTo>
                    <a:cubicBezTo>
                      <a:pt x="217488" y="40482"/>
                      <a:pt x="287338" y="69851"/>
                      <a:pt x="333375" y="100013"/>
                    </a:cubicBezTo>
                    <a:cubicBezTo>
                      <a:pt x="379412" y="130175"/>
                      <a:pt x="408781" y="167481"/>
                      <a:pt x="438150" y="204788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Freeform: Shape 40">
                <a:extLst>
                  <a:ext uri="{FF2B5EF4-FFF2-40B4-BE49-F238E27FC236}">
                    <a16:creationId xmlns:a16="http://schemas.microsoft.com/office/drawing/2014/main" id="{0A0DE87F-5AA7-79B1-3C27-BBC12CD65AD6}"/>
                  </a:ext>
                </a:extLst>
              </p:cNvPr>
              <p:cNvSpPr/>
              <p:nvPr/>
            </p:nvSpPr>
            <p:spPr>
              <a:xfrm>
                <a:off x="5248425" y="2113383"/>
                <a:ext cx="438150" cy="204788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38150" h="204788">
                    <a:moveTo>
                      <a:pt x="0" y="0"/>
                    </a:moveTo>
                    <a:cubicBezTo>
                      <a:pt x="53181" y="3572"/>
                      <a:pt x="106363" y="7144"/>
                      <a:pt x="161925" y="23813"/>
                    </a:cubicBezTo>
                    <a:cubicBezTo>
                      <a:pt x="217488" y="40482"/>
                      <a:pt x="287338" y="69851"/>
                      <a:pt x="333375" y="100013"/>
                    </a:cubicBezTo>
                    <a:cubicBezTo>
                      <a:pt x="379412" y="130175"/>
                      <a:pt x="408781" y="167481"/>
                      <a:pt x="438150" y="204788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" name="Freeform: Shape 41">
                <a:extLst>
                  <a:ext uri="{FF2B5EF4-FFF2-40B4-BE49-F238E27FC236}">
                    <a16:creationId xmlns:a16="http://schemas.microsoft.com/office/drawing/2014/main" id="{A2BB9ED1-FF5A-D64A-FEC7-E6DE2B25F069}"/>
                  </a:ext>
                </a:extLst>
              </p:cNvPr>
              <p:cNvSpPr/>
              <p:nvPr/>
            </p:nvSpPr>
            <p:spPr>
              <a:xfrm rot="19461561">
                <a:off x="4918641" y="2267817"/>
                <a:ext cx="681987" cy="379619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81987" h="379619">
                    <a:moveTo>
                      <a:pt x="0" y="0"/>
                    </a:moveTo>
                    <a:cubicBezTo>
                      <a:pt x="53181" y="3572"/>
                      <a:pt x="106363" y="7144"/>
                      <a:pt x="161925" y="23813"/>
                    </a:cubicBezTo>
                    <a:cubicBezTo>
                      <a:pt x="217488" y="40482"/>
                      <a:pt x="287338" y="69851"/>
                      <a:pt x="333375" y="100013"/>
                    </a:cubicBezTo>
                    <a:cubicBezTo>
                      <a:pt x="379412" y="130175"/>
                      <a:pt x="652618" y="342312"/>
                      <a:pt x="681987" y="379619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Freeform: Shape 42">
                <a:extLst>
                  <a:ext uri="{FF2B5EF4-FFF2-40B4-BE49-F238E27FC236}">
                    <a16:creationId xmlns:a16="http://schemas.microsoft.com/office/drawing/2014/main" id="{87E54ADC-B9B0-4B0C-2F8F-B5E25FDF2573}"/>
                  </a:ext>
                </a:extLst>
              </p:cNvPr>
              <p:cNvSpPr/>
              <p:nvPr/>
            </p:nvSpPr>
            <p:spPr>
              <a:xfrm rot="19461561">
                <a:off x="4807877" y="2257716"/>
                <a:ext cx="781669" cy="378528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736830"/>
                  <a:gd name="connsiteY0" fmla="*/ 1873 h 362213"/>
                  <a:gd name="connsiteX1" fmla="*/ 216768 w 736830"/>
                  <a:gd name="connsiteY1" fmla="*/ 6407 h 362213"/>
                  <a:gd name="connsiteX2" fmla="*/ 388218 w 736830"/>
                  <a:gd name="connsiteY2" fmla="*/ 82607 h 362213"/>
                  <a:gd name="connsiteX3" fmla="*/ 736830 w 736830"/>
                  <a:gd name="connsiteY3" fmla="*/ 362213 h 362213"/>
                  <a:gd name="connsiteX0" fmla="*/ 0 w 736830"/>
                  <a:gd name="connsiteY0" fmla="*/ 17751 h 378091"/>
                  <a:gd name="connsiteX1" fmla="*/ 165867 w 736830"/>
                  <a:gd name="connsiteY1" fmla="*/ 3371 h 378091"/>
                  <a:gd name="connsiteX2" fmla="*/ 388218 w 736830"/>
                  <a:gd name="connsiteY2" fmla="*/ 98485 h 378091"/>
                  <a:gd name="connsiteX3" fmla="*/ 736830 w 736830"/>
                  <a:gd name="connsiteY3" fmla="*/ 378091 h 378091"/>
                  <a:gd name="connsiteX0" fmla="*/ 0 w 781669"/>
                  <a:gd name="connsiteY0" fmla="*/ 15339 h 378528"/>
                  <a:gd name="connsiteX1" fmla="*/ 210706 w 781669"/>
                  <a:gd name="connsiteY1" fmla="*/ 3808 h 378528"/>
                  <a:gd name="connsiteX2" fmla="*/ 433057 w 781669"/>
                  <a:gd name="connsiteY2" fmla="*/ 98922 h 378528"/>
                  <a:gd name="connsiteX3" fmla="*/ 781669 w 781669"/>
                  <a:gd name="connsiteY3" fmla="*/ 378528 h 3785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1669" h="378528">
                    <a:moveTo>
                      <a:pt x="0" y="15339"/>
                    </a:moveTo>
                    <a:cubicBezTo>
                      <a:pt x="53181" y="18911"/>
                      <a:pt x="138530" y="-10122"/>
                      <a:pt x="210706" y="3808"/>
                    </a:cubicBezTo>
                    <a:cubicBezTo>
                      <a:pt x="282882" y="17738"/>
                      <a:pt x="387020" y="68760"/>
                      <a:pt x="433057" y="98922"/>
                    </a:cubicBezTo>
                    <a:cubicBezTo>
                      <a:pt x="479094" y="129084"/>
                      <a:pt x="752300" y="341221"/>
                      <a:pt x="781669" y="378528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44" name="Freeform: Shape 43">
                <a:extLst>
                  <a:ext uri="{FF2B5EF4-FFF2-40B4-BE49-F238E27FC236}">
                    <a16:creationId xmlns:a16="http://schemas.microsoft.com/office/drawing/2014/main" id="{BE91B2B0-BDDC-C9B3-E14E-4C7EAA9CB476}"/>
                  </a:ext>
                </a:extLst>
              </p:cNvPr>
              <p:cNvSpPr/>
              <p:nvPr/>
            </p:nvSpPr>
            <p:spPr>
              <a:xfrm rot="19461561">
                <a:off x="5164476" y="2294861"/>
                <a:ext cx="499345" cy="348288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99345" h="348288">
                    <a:moveTo>
                      <a:pt x="0" y="0"/>
                    </a:moveTo>
                    <a:cubicBezTo>
                      <a:pt x="53181" y="3572"/>
                      <a:pt x="93814" y="6937"/>
                      <a:pt x="150825" y="39295"/>
                    </a:cubicBezTo>
                    <a:cubicBezTo>
                      <a:pt x="207836" y="71653"/>
                      <a:pt x="296028" y="163984"/>
                      <a:pt x="342065" y="194146"/>
                    </a:cubicBezTo>
                    <a:cubicBezTo>
                      <a:pt x="388102" y="224308"/>
                      <a:pt x="469976" y="310981"/>
                      <a:pt x="499345" y="348288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" name="Freeform: Shape 44">
                <a:extLst>
                  <a:ext uri="{FF2B5EF4-FFF2-40B4-BE49-F238E27FC236}">
                    <a16:creationId xmlns:a16="http://schemas.microsoft.com/office/drawing/2014/main" id="{15741684-CF36-6B0F-90FE-49957636684F}"/>
                  </a:ext>
                </a:extLst>
              </p:cNvPr>
              <p:cNvSpPr/>
              <p:nvPr/>
            </p:nvSpPr>
            <p:spPr>
              <a:xfrm rot="19461561">
                <a:off x="5288343" y="2330391"/>
                <a:ext cx="410252" cy="325428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10252" h="325428">
                    <a:moveTo>
                      <a:pt x="0" y="0"/>
                    </a:moveTo>
                    <a:cubicBezTo>
                      <a:pt x="53181" y="3572"/>
                      <a:pt x="87494" y="30733"/>
                      <a:pt x="145783" y="70843"/>
                    </a:cubicBezTo>
                    <a:cubicBezTo>
                      <a:pt x="204072" y="110953"/>
                      <a:pt x="303696" y="210501"/>
                      <a:pt x="349733" y="240663"/>
                    </a:cubicBezTo>
                    <a:cubicBezTo>
                      <a:pt x="395770" y="270825"/>
                      <a:pt x="380883" y="288121"/>
                      <a:pt x="410252" y="325428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Freeform: Shape 45">
                <a:extLst>
                  <a:ext uri="{FF2B5EF4-FFF2-40B4-BE49-F238E27FC236}">
                    <a16:creationId xmlns:a16="http://schemas.microsoft.com/office/drawing/2014/main" id="{B9F9C6D6-7E95-26D4-DCB1-2D310AC6F163}"/>
                  </a:ext>
                </a:extLst>
              </p:cNvPr>
              <p:cNvSpPr/>
              <p:nvPr/>
            </p:nvSpPr>
            <p:spPr>
              <a:xfrm rot="19461561">
                <a:off x="5583120" y="2430020"/>
                <a:ext cx="194258" cy="187789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349733"/>
                  <a:gd name="connsiteY0" fmla="*/ 0 h 240663"/>
                  <a:gd name="connsiteX1" fmla="*/ 145783 w 349733"/>
                  <a:gd name="connsiteY1" fmla="*/ 70843 h 240663"/>
                  <a:gd name="connsiteX2" fmla="*/ 349733 w 349733"/>
                  <a:gd name="connsiteY2" fmla="*/ 240663 h 240663"/>
                  <a:gd name="connsiteX0" fmla="*/ 0 w 349733"/>
                  <a:gd name="connsiteY0" fmla="*/ 0 h 240663"/>
                  <a:gd name="connsiteX1" fmla="*/ 130738 w 349733"/>
                  <a:gd name="connsiteY1" fmla="*/ 124519 h 240663"/>
                  <a:gd name="connsiteX2" fmla="*/ 349733 w 349733"/>
                  <a:gd name="connsiteY2" fmla="*/ 240663 h 240663"/>
                  <a:gd name="connsiteX0" fmla="*/ 0 w 194258"/>
                  <a:gd name="connsiteY0" fmla="*/ 0 h 187789"/>
                  <a:gd name="connsiteX1" fmla="*/ 130738 w 194258"/>
                  <a:gd name="connsiteY1" fmla="*/ 124519 h 187789"/>
                  <a:gd name="connsiteX2" fmla="*/ 194258 w 194258"/>
                  <a:gd name="connsiteY2" fmla="*/ 187789 h 18778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94258" h="187789">
                    <a:moveTo>
                      <a:pt x="0" y="0"/>
                    </a:moveTo>
                    <a:cubicBezTo>
                      <a:pt x="53181" y="3572"/>
                      <a:pt x="98362" y="93221"/>
                      <a:pt x="130738" y="124519"/>
                    </a:cubicBezTo>
                    <a:cubicBezTo>
                      <a:pt x="163114" y="155817"/>
                      <a:pt x="148221" y="157627"/>
                      <a:pt x="194258" y="187789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Freeform: Shape 46">
                <a:extLst>
                  <a:ext uri="{FF2B5EF4-FFF2-40B4-BE49-F238E27FC236}">
                    <a16:creationId xmlns:a16="http://schemas.microsoft.com/office/drawing/2014/main" id="{74626E62-3589-5459-D2F3-E0D4A0E2389D}"/>
                  </a:ext>
                </a:extLst>
              </p:cNvPr>
              <p:cNvSpPr/>
              <p:nvPr/>
            </p:nvSpPr>
            <p:spPr>
              <a:xfrm rot="19461561">
                <a:off x="5702549" y="2562483"/>
                <a:ext cx="77722" cy="51343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349733"/>
                  <a:gd name="connsiteY0" fmla="*/ 0 h 240663"/>
                  <a:gd name="connsiteX1" fmla="*/ 145783 w 349733"/>
                  <a:gd name="connsiteY1" fmla="*/ 70843 h 240663"/>
                  <a:gd name="connsiteX2" fmla="*/ 349733 w 349733"/>
                  <a:gd name="connsiteY2" fmla="*/ 240663 h 240663"/>
                  <a:gd name="connsiteX0" fmla="*/ 0 w 145783"/>
                  <a:gd name="connsiteY0" fmla="*/ 0 h 70843"/>
                  <a:gd name="connsiteX1" fmla="*/ 145783 w 145783"/>
                  <a:gd name="connsiteY1" fmla="*/ 70843 h 70843"/>
                  <a:gd name="connsiteX0" fmla="*/ 0 w 77722"/>
                  <a:gd name="connsiteY0" fmla="*/ 0 h 51343"/>
                  <a:gd name="connsiteX1" fmla="*/ 77722 w 77722"/>
                  <a:gd name="connsiteY1" fmla="*/ 51343 h 513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7722" h="51343">
                    <a:moveTo>
                      <a:pt x="0" y="0"/>
                    </a:moveTo>
                    <a:cubicBezTo>
                      <a:pt x="53181" y="3572"/>
                      <a:pt x="19433" y="11233"/>
                      <a:pt x="77722" y="51343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Freeform: Shape 47">
                <a:extLst>
                  <a:ext uri="{FF2B5EF4-FFF2-40B4-BE49-F238E27FC236}">
                    <a16:creationId xmlns:a16="http://schemas.microsoft.com/office/drawing/2014/main" id="{656DB2F7-CDCF-EE78-D938-3DCD3A039D6A}"/>
                  </a:ext>
                </a:extLst>
              </p:cNvPr>
              <p:cNvSpPr/>
              <p:nvPr/>
            </p:nvSpPr>
            <p:spPr>
              <a:xfrm rot="19461561">
                <a:off x="2910480" y="1427185"/>
                <a:ext cx="1170762" cy="633013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899365"/>
                  <a:gd name="connsiteY0" fmla="*/ 17685 h 264215"/>
                  <a:gd name="connsiteX1" fmla="*/ 634896 w 899365"/>
                  <a:gd name="connsiteY1" fmla="*/ 9630 h 264215"/>
                  <a:gd name="connsiteX2" fmla="*/ 838846 w 899365"/>
                  <a:gd name="connsiteY2" fmla="*/ 179450 h 264215"/>
                  <a:gd name="connsiteX3" fmla="*/ 899365 w 899365"/>
                  <a:gd name="connsiteY3" fmla="*/ 264215 h 264215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838846 w 899365"/>
                  <a:gd name="connsiteY2" fmla="*/ 161765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705863 w 899365"/>
                  <a:gd name="connsiteY2" fmla="*/ 120337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164737 w 899365"/>
                  <a:gd name="connsiteY1" fmla="*/ 4845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1191533"/>
                  <a:gd name="connsiteY0" fmla="*/ 0 h 614340"/>
                  <a:gd name="connsiteX1" fmla="*/ 456905 w 1191533"/>
                  <a:gd name="connsiteY1" fmla="*/ 416265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785181 w 1191533"/>
                  <a:gd name="connsiteY2" fmla="*/ 477195 h 614340"/>
                  <a:gd name="connsiteX3" fmla="*/ 1191533 w 1191533"/>
                  <a:gd name="connsiteY3" fmla="*/ 614340 h 614340"/>
                  <a:gd name="connsiteX0" fmla="*/ 0 w 1359842"/>
                  <a:gd name="connsiteY0" fmla="*/ 0 h 1178527"/>
                  <a:gd name="connsiteX1" fmla="*/ 508766 w 1359842"/>
                  <a:gd name="connsiteY1" fmla="*/ 954016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59842"/>
                  <a:gd name="connsiteY0" fmla="*/ 0 h 1178527"/>
                  <a:gd name="connsiteX1" fmla="*/ 453857 w 1359842"/>
                  <a:gd name="connsiteY1" fmla="*/ 896315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97513"/>
                  <a:gd name="connsiteY0" fmla="*/ 0 h 1299748"/>
                  <a:gd name="connsiteX1" fmla="*/ 491528 w 1397513"/>
                  <a:gd name="connsiteY1" fmla="*/ 1017536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1397513 w 1397513"/>
                  <a:gd name="connsiteY2" fmla="*/ 1299748 h 1299748"/>
                  <a:gd name="connsiteX0" fmla="*/ 0 w 1397513"/>
                  <a:gd name="connsiteY0" fmla="*/ 0 h 1299748"/>
                  <a:gd name="connsiteX1" fmla="*/ 817159 w 1397513"/>
                  <a:gd name="connsiteY1" fmla="*/ 1138664 h 1299748"/>
                  <a:gd name="connsiteX2" fmla="*/ 1397513 w 1397513"/>
                  <a:gd name="connsiteY2" fmla="*/ 1299748 h 1299748"/>
                  <a:gd name="connsiteX0" fmla="*/ 25784 w 616127"/>
                  <a:gd name="connsiteY0" fmla="*/ 0 h 504551"/>
                  <a:gd name="connsiteX1" fmla="*/ 35773 w 616127"/>
                  <a:gd name="connsiteY1" fmla="*/ 343467 h 504551"/>
                  <a:gd name="connsiteX2" fmla="*/ 616127 w 616127"/>
                  <a:gd name="connsiteY2" fmla="*/ 504551 h 504551"/>
                  <a:gd name="connsiteX0" fmla="*/ 0 w 590343"/>
                  <a:gd name="connsiteY0" fmla="*/ 0 h 504551"/>
                  <a:gd name="connsiteX1" fmla="*/ 119963 w 590343"/>
                  <a:gd name="connsiteY1" fmla="*/ 348204 h 504551"/>
                  <a:gd name="connsiteX2" fmla="*/ 590343 w 590343"/>
                  <a:gd name="connsiteY2" fmla="*/ 504551 h 504551"/>
                  <a:gd name="connsiteX0" fmla="*/ 0 w 590343"/>
                  <a:gd name="connsiteY0" fmla="*/ 0 h 504551"/>
                  <a:gd name="connsiteX1" fmla="*/ 152487 w 590343"/>
                  <a:gd name="connsiteY1" fmla="*/ 346035 h 504551"/>
                  <a:gd name="connsiteX2" fmla="*/ 590343 w 590343"/>
                  <a:gd name="connsiteY2" fmla="*/ 504551 h 504551"/>
                  <a:gd name="connsiteX0" fmla="*/ 49080 w 639423"/>
                  <a:gd name="connsiteY0" fmla="*/ 0 h 504551"/>
                  <a:gd name="connsiteX1" fmla="*/ 31381 w 639423"/>
                  <a:gd name="connsiteY1" fmla="*/ 270873 h 504551"/>
                  <a:gd name="connsiteX2" fmla="*/ 639423 w 639423"/>
                  <a:gd name="connsiteY2" fmla="*/ 504551 h 504551"/>
                  <a:gd name="connsiteX0" fmla="*/ 144683 w 623257"/>
                  <a:gd name="connsiteY0" fmla="*/ 0 h 514017"/>
                  <a:gd name="connsiteX1" fmla="*/ 15215 w 623257"/>
                  <a:gd name="connsiteY1" fmla="*/ 280339 h 514017"/>
                  <a:gd name="connsiteX2" fmla="*/ 623257 w 623257"/>
                  <a:gd name="connsiteY2" fmla="*/ 514017 h 514017"/>
                  <a:gd name="connsiteX0" fmla="*/ 208159 w 686733"/>
                  <a:gd name="connsiteY0" fmla="*/ 0 h 514017"/>
                  <a:gd name="connsiteX1" fmla="*/ 12551 w 686733"/>
                  <a:gd name="connsiteY1" fmla="*/ 220369 h 514017"/>
                  <a:gd name="connsiteX2" fmla="*/ 686733 w 686733"/>
                  <a:gd name="connsiteY2" fmla="*/ 514017 h 514017"/>
                  <a:gd name="connsiteX0" fmla="*/ 247752 w 683819"/>
                  <a:gd name="connsiteY0" fmla="*/ 0 h 467560"/>
                  <a:gd name="connsiteX1" fmla="*/ 9637 w 683819"/>
                  <a:gd name="connsiteY1" fmla="*/ 173912 h 467560"/>
                  <a:gd name="connsiteX2" fmla="*/ 683819 w 683819"/>
                  <a:gd name="connsiteY2" fmla="*/ 467560 h 467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83819" h="467560">
                    <a:moveTo>
                      <a:pt x="247752" y="0"/>
                    </a:moveTo>
                    <a:cubicBezTo>
                      <a:pt x="300933" y="3572"/>
                      <a:pt x="-63041" y="95985"/>
                      <a:pt x="9637" y="173912"/>
                    </a:cubicBezTo>
                    <a:cubicBezTo>
                      <a:pt x="82315" y="251839"/>
                      <a:pt x="498647" y="407061"/>
                      <a:pt x="683819" y="467560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9" name="Freeform: Shape 48">
                <a:extLst>
                  <a:ext uri="{FF2B5EF4-FFF2-40B4-BE49-F238E27FC236}">
                    <a16:creationId xmlns:a16="http://schemas.microsoft.com/office/drawing/2014/main" id="{672CAFFD-FD94-B7D3-B486-1ABC10DCD7C6}"/>
                  </a:ext>
                </a:extLst>
              </p:cNvPr>
              <p:cNvSpPr/>
              <p:nvPr/>
            </p:nvSpPr>
            <p:spPr>
              <a:xfrm rot="19461561">
                <a:off x="2430884" y="1247286"/>
                <a:ext cx="1394830" cy="1219753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189530 w 410252"/>
                  <a:gd name="connsiteY2" fmla="*/ 214128 h 325428"/>
                  <a:gd name="connsiteX3" fmla="*/ 410252 w 410252"/>
                  <a:gd name="connsiteY3" fmla="*/ 325428 h 325428"/>
                  <a:gd name="connsiteX0" fmla="*/ 162865 w 573117"/>
                  <a:gd name="connsiteY0" fmla="*/ 0 h 325428"/>
                  <a:gd name="connsiteX1" fmla="*/ 2825 w 573117"/>
                  <a:gd name="connsiteY1" fmla="*/ 157635 h 325428"/>
                  <a:gd name="connsiteX2" fmla="*/ 352395 w 573117"/>
                  <a:gd name="connsiteY2" fmla="*/ 214128 h 325428"/>
                  <a:gd name="connsiteX3" fmla="*/ 573117 w 573117"/>
                  <a:gd name="connsiteY3" fmla="*/ 325428 h 325428"/>
                  <a:gd name="connsiteX0" fmla="*/ 0 w 977512"/>
                  <a:gd name="connsiteY0" fmla="*/ 0 h 594412"/>
                  <a:gd name="connsiteX1" fmla="*/ 407220 w 977512"/>
                  <a:gd name="connsiteY1" fmla="*/ 426619 h 594412"/>
                  <a:gd name="connsiteX2" fmla="*/ 756790 w 977512"/>
                  <a:gd name="connsiteY2" fmla="*/ 483112 h 594412"/>
                  <a:gd name="connsiteX3" fmla="*/ 977512 w 977512"/>
                  <a:gd name="connsiteY3" fmla="*/ 594412 h 594412"/>
                  <a:gd name="connsiteX0" fmla="*/ 0 w 977512"/>
                  <a:gd name="connsiteY0" fmla="*/ 0 h 594412"/>
                  <a:gd name="connsiteX1" fmla="*/ 277826 w 977512"/>
                  <a:gd name="connsiteY1" fmla="*/ 356784 h 594412"/>
                  <a:gd name="connsiteX2" fmla="*/ 756790 w 977512"/>
                  <a:gd name="connsiteY2" fmla="*/ 483112 h 594412"/>
                  <a:gd name="connsiteX3" fmla="*/ 977512 w 977512"/>
                  <a:gd name="connsiteY3" fmla="*/ 594412 h 594412"/>
                  <a:gd name="connsiteX0" fmla="*/ 0 w 1335815"/>
                  <a:gd name="connsiteY0" fmla="*/ 0 h 1441680"/>
                  <a:gd name="connsiteX1" fmla="*/ 636129 w 1335815"/>
                  <a:gd name="connsiteY1" fmla="*/ 1204052 h 1441680"/>
                  <a:gd name="connsiteX2" fmla="*/ 1115093 w 1335815"/>
                  <a:gd name="connsiteY2" fmla="*/ 1330380 h 1441680"/>
                  <a:gd name="connsiteX3" fmla="*/ 1335815 w 1335815"/>
                  <a:gd name="connsiteY3" fmla="*/ 1441680 h 1441680"/>
                  <a:gd name="connsiteX0" fmla="*/ 0 w 1335815"/>
                  <a:gd name="connsiteY0" fmla="*/ 0 h 1441680"/>
                  <a:gd name="connsiteX1" fmla="*/ 636129 w 1335815"/>
                  <a:gd name="connsiteY1" fmla="*/ 1204052 h 1441680"/>
                  <a:gd name="connsiteX2" fmla="*/ 1047626 w 1335815"/>
                  <a:gd name="connsiteY2" fmla="*/ 1372101 h 1441680"/>
                  <a:gd name="connsiteX3" fmla="*/ 1335815 w 1335815"/>
                  <a:gd name="connsiteY3" fmla="*/ 1441680 h 1441680"/>
                  <a:gd name="connsiteX0" fmla="*/ 0 w 1335815"/>
                  <a:gd name="connsiteY0" fmla="*/ 0 h 1441680"/>
                  <a:gd name="connsiteX1" fmla="*/ 636129 w 1335815"/>
                  <a:gd name="connsiteY1" fmla="*/ 1204052 h 1441680"/>
                  <a:gd name="connsiteX2" fmla="*/ 1335815 w 1335815"/>
                  <a:gd name="connsiteY2" fmla="*/ 1441680 h 1441680"/>
                  <a:gd name="connsiteX0" fmla="*/ 0 w 818548"/>
                  <a:gd name="connsiteY0" fmla="*/ 0 h 1360494"/>
                  <a:gd name="connsiteX1" fmla="*/ 118862 w 818548"/>
                  <a:gd name="connsiteY1" fmla="*/ 1122866 h 1360494"/>
                  <a:gd name="connsiteX2" fmla="*/ 818548 w 818548"/>
                  <a:gd name="connsiteY2" fmla="*/ 1360494 h 1360494"/>
                  <a:gd name="connsiteX0" fmla="*/ 22845 w 841393"/>
                  <a:gd name="connsiteY0" fmla="*/ 0 h 1360494"/>
                  <a:gd name="connsiteX1" fmla="*/ 57941 w 841393"/>
                  <a:gd name="connsiteY1" fmla="*/ 983594 h 1360494"/>
                  <a:gd name="connsiteX2" fmla="*/ 841393 w 841393"/>
                  <a:gd name="connsiteY2" fmla="*/ 1360494 h 1360494"/>
                  <a:gd name="connsiteX0" fmla="*/ 158517 w 807430"/>
                  <a:gd name="connsiteY0" fmla="*/ 0 h 897999"/>
                  <a:gd name="connsiteX1" fmla="*/ 23978 w 807430"/>
                  <a:gd name="connsiteY1" fmla="*/ 521099 h 897999"/>
                  <a:gd name="connsiteX2" fmla="*/ 807430 w 807430"/>
                  <a:gd name="connsiteY2" fmla="*/ 897999 h 897999"/>
                  <a:gd name="connsiteX0" fmla="*/ 163718 w 812631"/>
                  <a:gd name="connsiteY0" fmla="*/ 21885 h 919884"/>
                  <a:gd name="connsiteX1" fmla="*/ 166989 w 812631"/>
                  <a:gd name="connsiteY1" fmla="*/ 44359 h 919884"/>
                  <a:gd name="connsiteX2" fmla="*/ 29179 w 812631"/>
                  <a:gd name="connsiteY2" fmla="*/ 542984 h 919884"/>
                  <a:gd name="connsiteX3" fmla="*/ 812631 w 812631"/>
                  <a:gd name="connsiteY3" fmla="*/ 919884 h 919884"/>
                  <a:gd name="connsiteX0" fmla="*/ 144257 w 793170"/>
                  <a:gd name="connsiteY0" fmla="*/ 15497 h 913496"/>
                  <a:gd name="connsiteX1" fmla="*/ 342049 w 793170"/>
                  <a:gd name="connsiteY1" fmla="*/ 48134 h 913496"/>
                  <a:gd name="connsiteX2" fmla="*/ 9718 w 793170"/>
                  <a:gd name="connsiteY2" fmla="*/ 536596 h 913496"/>
                  <a:gd name="connsiteX3" fmla="*/ 793170 w 793170"/>
                  <a:gd name="connsiteY3" fmla="*/ 913496 h 913496"/>
                  <a:gd name="connsiteX0" fmla="*/ 688043 w 793170"/>
                  <a:gd name="connsiteY0" fmla="*/ 133815 h 887011"/>
                  <a:gd name="connsiteX1" fmla="*/ 342049 w 793170"/>
                  <a:gd name="connsiteY1" fmla="*/ 21649 h 887011"/>
                  <a:gd name="connsiteX2" fmla="*/ 9718 w 793170"/>
                  <a:gd name="connsiteY2" fmla="*/ 510111 h 887011"/>
                  <a:gd name="connsiteX3" fmla="*/ 793170 w 793170"/>
                  <a:gd name="connsiteY3" fmla="*/ 887011 h 887011"/>
                  <a:gd name="connsiteX0" fmla="*/ 704463 w 809590"/>
                  <a:gd name="connsiteY0" fmla="*/ 155604 h 908800"/>
                  <a:gd name="connsiteX1" fmla="*/ 184071 w 809590"/>
                  <a:gd name="connsiteY1" fmla="*/ 19861 h 908800"/>
                  <a:gd name="connsiteX2" fmla="*/ 26138 w 809590"/>
                  <a:gd name="connsiteY2" fmla="*/ 531900 h 908800"/>
                  <a:gd name="connsiteX3" fmla="*/ 809590 w 809590"/>
                  <a:gd name="connsiteY3" fmla="*/ 908800 h 908800"/>
                  <a:gd name="connsiteX0" fmla="*/ 707492 w 812619"/>
                  <a:gd name="connsiteY0" fmla="*/ 194980 h 948176"/>
                  <a:gd name="connsiteX1" fmla="*/ 167055 w 812619"/>
                  <a:gd name="connsiteY1" fmla="*/ 17317 h 948176"/>
                  <a:gd name="connsiteX2" fmla="*/ 29167 w 812619"/>
                  <a:gd name="connsiteY2" fmla="*/ 571276 h 948176"/>
                  <a:gd name="connsiteX3" fmla="*/ 812619 w 812619"/>
                  <a:gd name="connsiteY3" fmla="*/ 948176 h 948176"/>
                  <a:gd name="connsiteX0" fmla="*/ 731647 w 836774"/>
                  <a:gd name="connsiteY0" fmla="*/ 194980 h 948176"/>
                  <a:gd name="connsiteX1" fmla="*/ 191210 w 836774"/>
                  <a:gd name="connsiteY1" fmla="*/ 17317 h 948176"/>
                  <a:gd name="connsiteX2" fmla="*/ 26804 w 836774"/>
                  <a:gd name="connsiteY2" fmla="*/ 507656 h 948176"/>
                  <a:gd name="connsiteX3" fmla="*/ 836774 w 836774"/>
                  <a:gd name="connsiteY3" fmla="*/ 948176 h 948176"/>
                  <a:gd name="connsiteX0" fmla="*/ 729873 w 835000"/>
                  <a:gd name="connsiteY0" fmla="*/ 154228 h 907424"/>
                  <a:gd name="connsiteX1" fmla="*/ 202383 w 835000"/>
                  <a:gd name="connsiteY1" fmla="*/ 19965 h 907424"/>
                  <a:gd name="connsiteX2" fmla="*/ 25030 w 835000"/>
                  <a:gd name="connsiteY2" fmla="*/ 466904 h 907424"/>
                  <a:gd name="connsiteX3" fmla="*/ 835000 w 835000"/>
                  <a:gd name="connsiteY3" fmla="*/ 907424 h 907424"/>
                  <a:gd name="connsiteX0" fmla="*/ 688383 w 793510"/>
                  <a:gd name="connsiteY0" fmla="*/ 154228 h 907424"/>
                  <a:gd name="connsiteX1" fmla="*/ 160893 w 793510"/>
                  <a:gd name="connsiteY1" fmla="*/ 19965 h 907424"/>
                  <a:gd name="connsiteX2" fmla="*/ 28933 w 793510"/>
                  <a:gd name="connsiteY2" fmla="*/ 563467 h 907424"/>
                  <a:gd name="connsiteX3" fmla="*/ 793510 w 793510"/>
                  <a:gd name="connsiteY3" fmla="*/ 907424 h 907424"/>
                  <a:gd name="connsiteX0" fmla="*/ 702268 w 807395"/>
                  <a:gd name="connsiteY0" fmla="*/ 153680 h 906876"/>
                  <a:gd name="connsiteX1" fmla="*/ 105595 w 807395"/>
                  <a:gd name="connsiteY1" fmla="*/ 20007 h 906876"/>
                  <a:gd name="connsiteX2" fmla="*/ 42818 w 807395"/>
                  <a:gd name="connsiteY2" fmla="*/ 562919 h 906876"/>
                  <a:gd name="connsiteX3" fmla="*/ 807395 w 807395"/>
                  <a:gd name="connsiteY3" fmla="*/ 906876 h 906876"/>
                  <a:gd name="connsiteX0" fmla="*/ 702268 w 807395"/>
                  <a:gd name="connsiteY0" fmla="*/ 144774 h 897970"/>
                  <a:gd name="connsiteX1" fmla="*/ 105595 w 807395"/>
                  <a:gd name="connsiteY1" fmla="*/ 11101 h 897970"/>
                  <a:gd name="connsiteX2" fmla="*/ 42818 w 807395"/>
                  <a:gd name="connsiteY2" fmla="*/ 554013 h 897970"/>
                  <a:gd name="connsiteX3" fmla="*/ 807395 w 807395"/>
                  <a:gd name="connsiteY3" fmla="*/ 897970 h 897970"/>
                  <a:gd name="connsiteX0" fmla="*/ 709565 w 814692"/>
                  <a:gd name="connsiteY0" fmla="*/ 144774 h 897970"/>
                  <a:gd name="connsiteX1" fmla="*/ 112892 w 814692"/>
                  <a:gd name="connsiteY1" fmla="*/ 11101 h 897970"/>
                  <a:gd name="connsiteX2" fmla="*/ 50115 w 814692"/>
                  <a:gd name="connsiteY2" fmla="*/ 554013 h 897970"/>
                  <a:gd name="connsiteX3" fmla="*/ 814692 w 814692"/>
                  <a:gd name="connsiteY3" fmla="*/ 897970 h 897970"/>
                  <a:gd name="connsiteX0" fmla="*/ 646471 w 814692"/>
                  <a:gd name="connsiteY0" fmla="*/ 97763 h 900942"/>
                  <a:gd name="connsiteX1" fmla="*/ 112892 w 814692"/>
                  <a:gd name="connsiteY1" fmla="*/ 14073 h 900942"/>
                  <a:gd name="connsiteX2" fmla="*/ 50115 w 814692"/>
                  <a:gd name="connsiteY2" fmla="*/ 556985 h 900942"/>
                  <a:gd name="connsiteX3" fmla="*/ 814692 w 814692"/>
                  <a:gd name="connsiteY3" fmla="*/ 900942 h 9009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814692" h="900942">
                    <a:moveTo>
                      <a:pt x="646471" y="97763"/>
                    </a:moveTo>
                    <a:cubicBezTo>
                      <a:pt x="647016" y="101509"/>
                      <a:pt x="157154" y="-45060"/>
                      <a:pt x="112892" y="14073"/>
                    </a:cubicBezTo>
                    <a:cubicBezTo>
                      <a:pt x="49131" y="63441"/>
                      <a:pt x="-66852" y="409174"/>
                      <a:pt x="50115" y="556985"/>
                    </a:cubicBezTo>
                    <a:cubicBezTo>
                      <a:pt x="167082" y="704796"/>
                      <a:pt x="668924" y="851436"/>
                      <a:pt x="814692" y="900942"/>
                    </a:cubicBezTo>
                  </a:path>
                </a:pathLst>
              </a:custGeom>
              <a:noFill/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50" name="Freeform: Shape 49">
                <a:extLst>
                  <a:ext uri="{FF2B5EF4-FFF2-40B4-BE49-F238E27FC236}">
                    <a16:creationId xmlns:a16="http://schemas.microsoft.com/office/drawing/2014/main" id="{3697FBF6-42F3-8C93-FAE2-497D64A83760}"/>
                  </a:ext>
                </a:extLst>
              </p:cNvPr>
              <p:cNvSpPr/>
              <p:nvPr/>
            </p:nvSpPr>
            <p:spPr>
              <a:xfrm rot="19461561">
                <a:off x="1892930" y="828329"/>
                <a:ext cx="1706033" cy="2098056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192652 w 410252"/>
                  <a:gd name="connsiteY2" fmla="*/ 98234 h 325428"/>
                  <a:gd name="connsiteX3" fmla="*/ 410252 w 410252"/>
                  <a:gd name="connsiteY3" fmla="*/ 325428 h 325428"/>
                  <a:gd name="connsiteX0" fmla="*/ 0 w 768162"/>
                  <a:gd name="connsiteY0" fmla="*/ 0 h 1449364"/>
                  <a:gd name="connsiteX1" fmla="*/ 503693 w 768162"/>
                  <a:gd name="connsiteY1" fmla="*/ 1194779 h 1449364"/>
                  <a:gd name="connsiteX2" fmla="*/ 550562 w 768162"/>
                  <a:gd name="connsiteY2" fmla="*/ 1222170 h 1449364"/>
                  <a:gd name="connsiteX3" fmla="*/ 768162 w 768162"/>
                  <a:gd name="connsiteY3" fmla="*/ 1449364 h 1449364"/>
                  <a:gd name="connsiteX0" fmla="*/ 47585 w 815747"/>
                  <a:gd name="connsiteY0" fmla="*/ 0 h 1449364"/>
                  <a:gd name="connsiteX1" fmla="*/ 28476 w 815747"/>
                  <a:gd name="connsiteY1" fmla="*/ 847382 h 1449364"/>
                  <a:gd name="connsiteX2" fmla="*/ 598147 w 815747"/>
                  <a:gd name="connsiteY2" fmla="*/ 1222170 h 1449364"/>
                  <a:gd name="connsiteX3" fmla="*/ 815747 w 815747"/>
                  <a:gd name="connsiteY3" fmla="*/ 1449364 h 1449364"/>
                  <a:gd name="connsiteX0" fmla="*/ 28658 w 796820"/>
                  <a:gd name="connsiteY0" fmla="*/ 0 h 1449364"/>
                  <a:gd name="connsiteX1" fmla="*/ 9549 w 796820"/>
                  <a:gd name="connsiteY1" fmla="*/ 847382 h 1449364"/>
                  <a:gd name="connsiteX2" fmla="*/ 281798 w 796820"/>
                  <a:gd name="connsiteY2" fmla="*/ 1215538 h 1449364"/>
                  <a:gd name="connsiteX3" fmla="*/ 579220 w 796820"/>
                  <a:gd name="connsiteY3" fmla="*/ 1222170 h 1449364"/>
                  <a:gd name="connsiteX4" fmla="*/ 796820 w 796820"/>
                  <a:gd name="connsiteY4" fmla="*/ 1449364 h 1449364"/>
                  <a:gd name="connsiteX0" fmla="*/ 28658 w 796820"/>
                  <a:gd name="connsiteY0" fmla="*/ 0 h 1449364"/>
                  <a:gd name="connsiteX1" fmla="*/ 9549 w 796820"/>
                  <a:gd name="connsiteY1" fmla="*/ 847382 h 1449364"/>
                  <a:gd name="connsiteX2" fmla="*/ 281798 w 796820"/>
                  <a:gd name="connsiteY2" fmla="*/ 1215538 h 1449364"/>
                  <a:gd name="connsiteX3" fmla="*/ 556054 w 796820"/>
                  <a:gd name="connsiteY3" fmla="*/ 1296145 h 1449364"/>
                  <a:gd name="connsiteX4" fmla="*/ 796820 w 796820"/>
                  <a:gd name="connsiteY4" fmla="*/ 1449364 h 1449364"/>
                  <a:gd name="connsiteX0" fmla="*/ 28658 w 796820"/>
                  <a:gd name="connsiteY0" fmla="*/ 0 h 1449364"/>
                  <a:gd name="connsiteX1" fmla="*/ 9549 w 796820"/>
                  <a:gd name="connsiteY1" fmla="*/ 847382 h 1449364"/>
                  <a:gd name="connsiteX2" fmla="*/ 281798 w 796820"/>
                  <a:gd name="connsiteY2" fmla="*/ 1215538 h 1449364"/>
                  <a:gd name="connsiteX3" fmla="*/ 546538 w 796820"/>
                  <a:gd name="connsiteY3" fmla="*/ 1335006 h 1449364"/>
                  <a:gd name="connsiteX4" fmla="*/ 796820 w 796820"/>
                  <a:gd name="connsiteY4" fmla="*/ 1449364 h 1449364"/>
                  <a:gd name="connsiteX0" fmla="*/ 38635 w 795487"/>
                  <a:gd name="connsiteY0" fmla="*/ 0 h 1502427"/>
                  <a:gd name="connsiteX1" fmla="*/ 8216 w 795487"/>
                  <a:gd name="connsiteY1" fmla="*/ 900445 h 1502427"/>
                  <a:gd name="connsiteX2" fmla="*/ 280465 w 795487"/>
                  <a:gd name="connsiteY2" fmla="*/ 1268601 h 1502427"/>
                  <a:gd name="connsiteX3" fmla="*/ 545205 w 795487"/>
                  <a:gd name="connsiteY3" fmla="*/ 1388069 h 1502427"/>
                  <a:gd name="connsiteX4" fmla="*/ 795487 w 795487"/>
                  <a:gd name="connsiteY4" fmla="*/ 1502427 h 1502427"/>
                  <a:gd name="connsiteX0" fmla="*/ 133305 w 890157"/>
                  <a:gd name="connsiteY0" fmla="*/ 0 h 1502427"/>
                  <a:gd name="connsiteX1" fmla="*/ 4925 w 890157"/>
                  <a:gd name="connsiteY1" fmla="*/ 764132 h 1502427"/>
                  <a:gd name="connsiteX2" fmla="*/ 375135 w 890157"/>
                  <a:gd name="connsiteY2" fmla="*/ 1268601 h 1502427"/>
                  <a:gd name="connsiteX3" fmla="*/ 639875 w 890157"/>
                  <a:gd name="connsiteY3" fmla="*/ 1388069 h 1502427"/>
                  <a:gd name="connsiteX4" fmla="*/ 890157 w 890157"/>
                  <a:gd name="connsiteY4" fmla="*/ 1502427 h 1502427"/>
                  <a:gd name="connsiteX0" fmla="*/ 134339 w 891191"/>
                  <a:gd name="connsiteY0" fmla="*/ 0 h 1502427"/>
                  <a:gd name="connsiteX1" fmla="*/ 5959 w 891191"/>
                  <a:gd name="connsiteY1" fmla="*/ 764132 h 1502427"/>
                  <a:gd name="connsiteX2" fmla="*/ 404481 w 891191"/>
                  <a:gd name="connsiteY2" fmla="*/ 1318018 h 1502427"/>
                  <a:gd name="connsiteX3" fmla="*/ 640909 w 891191"/>
                  <a:gd name="connsiteY3" fmla="*/ 1388069 h 1502427"/>
                  <a:gd name="connsiteX4" fmla="*/ 891191 w 891191"/>
                  <a:gd name="connsiteY4" fmla="*/ 1502427 h 1502427"/>
                  <a:gd name="connsiteX0" fmla="*/ 134339 w 891191"/>
                  <a:gd name="connsiteY0" fmla="*/ 0 h 1502427"/>
                  <a:gd name="connsiteX1" fmla="*/ 5959 w 891191"/>
                  <a:gd name="connsiteY1" fmla="*/ 764132 h 1502427"/>
                  <a:gd name="connsiteX2" fmla="*/ 404481 w 891191"/>
                  <a:gd name="connsiteY2" fmla="*/ 1318018 h 1502427"/>
                  <a:gd name="connsiteX3" fmla="*/ 772176 w 891191"/>
                  <a:gd name="connsiteY3" fmla="*/ 1388368 h 1502427"/>
                  <a:gd name="connsiteX4" fmla="*/ 891191 w 891191"/>
                  <a:gd name="connsiteY4" fmla="*/ 1502427 h 1502427"/>
                  <a:gd name="connsiteX0" fmla="*/ 130460 w 891449"/>
                  <a:gd name="connsiteY0" fmla="*/ 0 h 1549463"/>
                  <a:gd name="connsiteX1" fmla="*/ 6217 w 891449"/>
                  <a:gd name="connsiteY1" fmla="*/ 811168 h 1549463"/>
                  <a:gd name="connsiteX2" fmla="*/ 404739 w 891449"/>
                  <a:gd name="connsiteY2" fmla="*/ 1365054 h 1549463"/>
                  <a:gd name="connsiteX3" fmla="*/ 772434 w 891449"/>
                  <a:gd name="connsiteY3" fmla="*/ 1435404 h 1549463"/>
                  <a:gd name="connsiteX4" fmla="*/ 891449 w 891449"/>
                  <a:gd name="connsiteY4" fmla="*/ 1549463 h 1549463"/>
                  <a:gd name="connsiteX0" fmla="*/ 153178 w 914167"/>
                  <a:gd name="connsiteY0" fmla="*/ 0 h 1549463"/>
                  <a:gd name="connsiteX1" fmla="*/ 5689 w 914167"/>
                  <a:gd name="connsiteY1" fmla="*/ 785763 h 1549463"/>
                  <a:gd name="connsiteX2" fmla="*/ 427457 w 914167"/>
                  <a:gd name="connsiteY2" fmla="*/ 1365054 h 1549463"/>
                  <a:gd name="connsiteX3" fmla="*/ 795152 w 914167"/>
                  <a:gd name="connsiteY3" fmla="*/ 1435404 h 1549463"/>
                  <a:gd name="connsiteX4" fmla="*/ 914167 w 914167"/>
                  <a:gd name="connsiteY4" fmla="*/ 1549463 h 1549463"/>
                  <a:gd name="connsiteX0" fmla="*/ 276710 w 1037699"/>
                  <a:gd name="connsiteY0" fmla="*/ 0 h 1549463"/>
                  <a:gd name="connsiteX1" fmla="*/ 3905 w 1037699"/>
                  <a:gd name="connsiteY1" fmla="*/ 680793 h 1549463"/>
                  <a:gd name="connsiteX2" fmla="*/ 550989 w 1037699"/>
                  <a:gd name="connsiteY2" fmla="*/ 1365054 h 1549463"/>
                  <a:gd name="connsiteX3" fmla="*/ 918684 w 1037699"/>
                  <a:gd name="connsiteY3" fmla="*/ 1435404 h 1549463"/>
                  <a:gd name="connsiteX4" fmla="*/ 1037699 w 1037699"/>
                  <a:gd name="connsiteY4" fmla="*/ 1549463 h 1549463"/>
                  <a:gd name="connsiteX0" fmla="*/ 202658 w 1041277"/>
                  <a:gd name="connsiteY0" fmla="*/ 0 h 1533283"/>
                  <a:gd name="connsiteX1" fmla="*/ 7483 w 1041277"/>
                  <a:gd name="connsiteY1" fmla="*/ 664613 h 1533283"/>
                  <a:gd name="connsiteX2" fmla="*/ 554567 w 1041277"/>
                  <a:gd name="connsiteY2" fmla="*/ 1348874 h 1533283"/>
                  <a:gd name="connsiteX3" fmla="*/ 922262 w 1041277"/>
                  <a:gd name="connsiteY3" fmla="*/ 1419224 h 1533283"/>
                  <a:gd name="connsiteX4" fmla="*/ 1041277 w 1041277"/>
                  <a:gd name="connsiteY4" fmla="*/ 1533283 h 1533283"/>
                  <a:gd name="connsiteX0" fmla="*/ 153532 w 992151"/>
                  <a:gd name="connsiteY0" fmla="*/ 0 h 1533283"/>
                  <a:gd name="connsiteX1" fmla="*/ 8774 w 992151"/>
                  <a:gd name="connsiteY1" fmla="*/ 684356 h 1533283"/>
                  <a:gd name="connsiteX2" fmla="*/ 505441 w 992151"/>
                  <a:gd name="connsiteY2" fmla="*/ 1348874 h 1533283"/>
                  <a:gd name="connsiteX3" fmla="*/ 873136 w 992151"/>
                  <a:gd name="connsiteY3" fmla="*/ 1419224 h 1533283"/>
                  <a:gd name="connsiteX4" fmla="*/ 992151 w 992151"/>
                  <a:gd name="connsiteY4" fmla="*/ 1533283 h 1533283"/>
                  <a:gd name="connsiteX0" fmla="*/ 136827 w 993532"/>
                  <a:gd name="connsiteY0" fmla="*/ 0 h 1549681"/>
                  <a:gd name="connsiteX1" fmla="*/ 10155 w 993532"/>
                  <a:gd name="connsiteY1" fmla="*/ 700754 h 1549681"/>
                  <a:gd name="connsiteX2" fmla="*/ 506822 w 993532"/>
                  <a:gd name="connsiteY2" fmla="*/ 1365272 h 1549681"/>
                  <a:gd name="connsiteX3" fmla="*/ 874517 w 993532"/>
                  <a:gd name="connsiteY3" fmla="*/ 1435622 h 1549681"/>
                  <a:gd name="connsiteX4" fmla="*/ 993532 w 993532"/>
                  <a:gd name="connsiteY4" fmla="*/ 1549681 h 1549681"/>
                  <a:gd name="connsiteX0" fmla="*/ 140409 w 997114"/>
                  <a:gd name="connsiteY0" fmla="*/ 0 h 1549681"/>
                  <a:gd name="connsiteX1" fmla="*/ 13737 w 997114"/>
                  <a:gd name="connsiteY1" fmla="*/ 700754 h 1549681"/>
                  <a:gd name="connsiteX2" fmla="*/ 586532 w 997114"/>
                  <a:gd name="connsiteY2" fmla="*/ 1362031 h 1549681"/>
                  <a:gd name="connsiteX3" fmla="*/ 878099 w 997114"/>
                  <a:gd name="connsiteY3" fmla="*/ 1435622 h 1549681"/>
                  <a:gd name="connsiteX4" fmla="*/ 997114 w 997114"/>
                  <a:gd name="connsiteY4" fmla="*/ 1549681 h 1549681"/>
                  <a:gd name="connsiteX0" fmla="*/ 140409 w 997114"/>
                  <a:gd name="connsiteY0" fmla="*/ 0 h 1549681"/>
                  <a:gd name="connsiteX1" fmla="*/ 13737 w 997114"/>
                  <a:gd name="connsiteY1" fmla="*/ 700754 h 1549681"/>
                  <a:gd name="connsiteX2" fmla="*/ 586532 w 997114"/>
                  <a:gd name="connsiteY2" fmla="*/ 1362031 h 1549681"/>
                  <a:gd name="connsiteX3" fmla="*/ 949384 w 997114"/>
                  <a:gd name="connsiteY3" fmla="*/ 1420764 h 1549681"/>
                  <a:gd name="connsiteX4" fmla="*/ 997114 w 997114"/>
                  <a:gd name="connsiteY4" fmla="*/ 1549681 h 1549681"/>
                  <a:gd name="connsiteX0" fmla="*/ 139755 w 996460"/>
                  <a:gd name="connsiteY0" fmla="*/ 0 h 1549681"/>
                  <a:gd name="connsiteX1" fmla="*/ 13083 w 996460"/>
                  <a:gd name="connsiteY1" fmla="*/ 700754 h 1549681"/>
                  <a:gd name="connsiteX2" fmla="*/ 572419 w 996460"/>
                  <a:gd name="connsiteY2" fmla="*/ 1335374 h 1549681"/>
                  <a:gd name="connsiteX3" fmla="*/ 948730 w 996460"/>
                  <a:gd name="connsiteY3" fmla="*/ 1420764 h 1549681"/>
                  <a:gd name="connsiteX4" fmla="*/ 996460 w 996460"/>
                  <a:gd name="connsiteY4" fmla="*/ 1549681 h 1549681"/>
                  <a:gd name="connsiteX0" fmla="*/ 139755 w 996460"/>
                  <a:gd name="connsiteY0" fmla="*/ 0 h 1549681"/>
                  <a:gd name="connsiteX1" fmla="*/ 13083 w 996460"/>
                  <a:gd name="connsiteY1" fmla="*/ 700754 h 1549681"/>
                  <a:gd name="connsiteX2" fmla="*/ 572419 w 996460"/>
                  <a:gd name="connsiteY2" fmla="*/ 1335374 h 1549681"/>
                  <a:gd name="connsiteX3" fmla="*/ 915830 w 996460"/>
                  <a:gd name="connsiteY3" fmla="*/ 1398159 h 1549681"/>
                  <a:gd name="connsiteX4" fmla="*/ 996460 w 996460"/>
                  <a:gd name="connsiteY4" fmla="*/ 1549681 h 15496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96460" h="1549681">
                    <a:moveTo>
                      <a:pt x="139755" y="0"/>
                    </a:moveTo>
                    <a:cubicBezTo>
                      <a:pt x="192936" y="3572"/>
                      <a:pt x="-59028" y="478192"/>
                      <a:pt x="13083" y="700754"/>
                    </a:cubicBezTo>
                    <a:cubicBezTo>
                      <a:pt x="85194" y="923316"/>
                      <a:pt x="421961" y="1219140"/>
                      <a:pt x="572419" y="1335374"/>
                    </a:cubicBezTo>
                    <a:cubicBezTo>
                      <a:pt x="722877" y="1451608"/>
                      <a:pt x="873060" y="1358663"/>
                      <a:pt x="915830" y="1398159"/>
                    </a:cubicBezTo>
                    <a:cubicBezTo>
                      <a:pt x="961867" y="1428321"/>
                      <a:pt x="967091" y="1512374"/>
                      <a:pt x="996460" y="1549681"/>
                    </a:cubicBezTo>
                  </a:path>
                </a:pathLst>
              </a:custGeom>
              <a:noFill/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" name="Freeform: Shape 2">
                <a:extLst>
                  <a:ext uri="{FF2B5EF4-FFF2-40B4-BE49-F238E27FC236}">
                    <a16:creationId xmlns:a16="http://schemas.microsoft.com/office/drawing/2014/main" id="{61CEF0CA-A3C8-7A2F-10F7-0C1ADDC775CF}"/>
                  </a:ext>
                </a:extLst>
              </p:cNvPr>
              <p:cNvSpPr/>
              <p:nvPr/>
            </p:nvSpPr>
            <p:spPr>
              <a:xfrm rot="19461561">
                <a:off x="2033606" y="577798"/>
                <a:ext cx="1751849" cy="1828359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899365"/>
                  <a:gd name="connsiteY0" fmla="*/ 17685 h 264215"/>
                  <a:gd name="connsiteX1" fmla="*/ 634896 w 899365"/>
                  <a:gd name="connsiteY1" fmla="*/ 9630 h 264215"/>
                  <a:gd name="connsiteX2" fmla="*/ 838846 w 899365"/>
                  <a:gd name="connsiteY2" fmla="*/ 179450 h 264215"/>
                  <a:gd name="connsiteX3" fmla="*/ 899365 w 899365"/>
                  <a:gd name="connsiteY3" fmla="*/ 264215 h 264215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838846 w 899365"/>
                  <a:gd name="connsiteY2" fmla="*/ 161765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705863 w 899365"/>
                  <a:gd name="connsiteY2" fmla="*/ 120337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164737 w 899365"/>
                  <a:gd name="connsiteY1" fmla="*/ 4845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1191533"/>
                  <a:gd name="connsiteY0" fmla="*/ 0 h 614340"/>
                  <a:gd name="connsiteX1" fmla="*/ 456905 w 1191533"/>
                  <a:gd name="connsiteY1" fmla="*/ 416265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785181 w 1191533"/>
                  <a:gd name="connsiteY2" fmla="*/ 477195 h 614340"/>
                  <a:gd name="connsiteX3" fmla="*/ 1191533 w 1191533"/>
                  <a:gd name="connsiteY3" fmla="*/ 614340 h 614340"/>
                  <a:gd name="connsiteX0" fmla="*/ 0 w 1359842"/>
                  <a:gd name="connsiteY0" fmla="*/ 0 h 1178527"/>
                  <a:gd name="connsiteX1" fmla="*/ 508766 w 1359842"/>
                  <a:gd name="connsiteY1" fmla="*/ 954016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59842"/>
                  <a:gd name="connsiteY0" fmla="*/ 0 h 1178527"/>
                  <a:gd name="connsiteX1" fmla="*/ 453857 w 1359842"/>
                  <a:gd name="connsiteY1" fmla="*/ 896315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97513"/>
                  <a:gd name="connsiteY0" fmla="*/ 0 h 1299748"/>
                  <a:gd name="connsiteX1" fmla="*/ 491528 w 1397513"/>
                  <a:gd name="connsiteY1" fmla="*/ 1017536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1397513 w 1397513"/>
                  <a:gd name="connsiteY2" fmla="*/ 1299748 h 1299748"/>
                  <a:gd name="connsiteX0" fmla="*/ 0 w 1367953"/>
                  <a:gd name="connsiteY0" fmla="*/ 0 h 1296690"/>
                  <a:gd name="connsiteX1" fmla="*/ 508687 w 1367953"/>
                  <a:gd name="connsiteY1" fmla="*/ 1009350 h 1296690"/>
                  <a:gd name="connsiteX2" fmla="*/ 1367953 w 1367953"/>
                  <a:gd name="connsiteY2" fmla="*/ 1296690 h 1296690"/>
                  <a:gd name="connsiteX0" fmla="*/ 0 w 1367953"/>
                  <a:gd name="connsiteY0" fmla="*/ 0 h 1296690"/>
                  <a:gd name="connsiteX1" fmla="*/ 544175 w 1367953"/>
                  <a:gd name="connsiteY1" fmla="*/ 1001954 h 1296690"/>
                  <a:gd name="connsiteX2" fmla="*/ 1367953 w 1367953"/>
                  <a:gd name="connsiteY2" fmla="*/ 1296690 h 1296690"/>
                  <a:gd name="connsiteX0" fmla="*/ 0 w 1354849"/>
                  <a:gd name="connsiteY0" fmla="*/ 0 h 1363958"/>
                  <a:gd name="connsiteX1" fmla="*/ 531071 w 1354849"/>
                  <a:gd name="connsiteY1" fmla="*/ 1069222 h 1363958"/>
                  <a:gd name="connsiteX2" fmla="*/ 1354849 w 1354849"/>
                  <a:gd name="connsiteY2" fmla="*/ 1363958 h 1363958"/>
                  <a:gd name="connsiteX0" fmla="*/ 0 w 933906"/>
                  <a:gd name="connsiteY0" fmla="*/ 0 h 1322623"/>
                  <a:gd name="connsiteX1" fmla="*/ 110128 w 933906"/>
                  <a:gd name="connsiteY1" fmla="*/ 1027887 h 1322623"/>
                  <a:gd name="connsiteX2" fmla="*/ 933906 w 933906"/>
                  <a:gd name="connsiteY2" fmla="*/ 1322623 h 1322623"/>
                  <a:gd name="connsiteX0" fmla="*/ 0 w 933906"/>
                  <a:gd name="connsiteY0" fmla="*/ 71559 h 1394182"/>
                  <a:gd name="connsiteX1" fmla="*/ 19820 w 933906"/>
                  <a:gd name="connsiteY1" fmla="*/ 77478 h 1394182"/>
                  <a:gd name="connsiteX2" fmla="*/ 110128 w 933906"/>
                  <a:gd name="connsiteY2" fmla="*/ 1099446 h 1394182"/>
                  <a:gd name="connsiteX3" fmla="*/ 933906 w 933906"/>
                  <a:gd name="connsiteY3" fmla="*/ 1394182 h 1394182"/>
                  <a:gd name="connsiteX0" fmla="*/ 0 w 933906"/>
                  <a:gd name="connsiteY0" fmla="*/ 76723 h 1399346"/>
                  <a:gd name="connsiteX1" fmla="*/ 230331 w 933906"/>
                  <a:gd name="connsiteY1" fmla="*/ 75643 h 1399346"/>
                  <a:gd name="connsiteX2" fmla="*/ 110128 w 933906"/>
                  <a:gd name="connsiteY2" fmla="*/ 1104610 h 1399346"/>
                  <a:gd name="connsiteX3" fmla="*/ 933906 w 933906"/>
                  <a:gd name="connsiteY3" fmla="*/ 1399346 h 1399346"/>
                  <a:gd name="connsiteX0" fmla="*/ 0 w 933906"/>
                  <a:gd name="connsiteY0" fmla="*/ 10001 h 1332624"/>
                  <a:gd name="connsiteX1" fmla="*/ 48053 w 933906"/>
                  <a:gd name="connsiteY1" fmla="*/ 120669 h 1332624"/>
                  <a:gd name="connsiteX2" fmla="*/ 110128 w 933906"/>
                  <a:gd name="connsiteY2" fmla="*/ 1037888 h 1332624"/>
                  <a:gd name="connsiteX3" fmla="*/ 933906 w 933906"/>
                  <a:gd name="connsiteY3" fmla="*/ 1332624 h 1332624"/>
                  <a:gd name="connsiteX0" fmla="*/ 309248 w 904419"/>
                  <a:gd name="connsiteY0" fmla="*/ 37164 h 1305927"/>
                  <a:gd name="connsiteX1" fmla="*/ 18566 w 904419"/>
                  <a:gd name="connsiteY1" fmla="*/ 93972 h 1305927"/>
                  <a:gd name="connsiteX2" fmla="*/ 80641 w 904419"/>
                  <a:gd name="connsiteY2" fmla="*/ 1011191 h 1305927"/>
                  <a:gd name="connsiteX3" fmla="*/ 904419 w 904419"/>
                  <a:gd name="connsiteY3" fmla="*/ 1305927 h 1305927"/>
                  <a:gd name="connsiteX0" fmla="*/ 295426 w 890597"/>
                  <a:gd name="connsiteY0" fmla="*/ 94090 h 1362853"/>
                  <a:gd name="connsiteX1" fmla="*/ 37972 w 890597"/>
                  <a:gd name="connsiteY1" fmla="*/ 70216 h 1362853"/>
                  <a:gd name="connsiteX2" fmla="*/ 66819 w 890597"/>
                  <a:gd name="connsiteY2" fmla="*/ 1068117 h 1362853"/>
                  <a:gd name="connsiteX3" fmla="*/ 890597 w 890597"/>
                  <a:gd name="connsiteY3" fmla="*/ 1362853 h 1362853"/>
                  <a:gd name="connsiteX0" fmla="*/ 423650 w 890597"/>
                  <a:gd name="connsiteY0" fmla="*/ 143628 h 1351532"/>
                  <a:gd name="connsiteX1" fmla="*/ 37972 w 890597"/>
                  <a:gd name="connsiteY1" fmla="*/ 58895 h 1351532"/>
                  <a:gd name="connsiteX2" fmla="*/ 66819 w 890597"/>
                  <a:gd name="connsiteY2" fmla="*/ 1056796 h 1351532"/>
                  <a:gd name="connsiteX3" fmla="*/ 890597 w 890597"/>
                  <a:gd name="connsiteY3" fmla="*/ 1351532 h 1351532"/>
                  <a:gd name="connsiteX0" fmla="*/ 459818 w 926765"/>
                  <a:gd name="connsiteY0" fmla="*/ 143628 h 1351532"/>
                  <a:gd name="connsiteX1" fmla="*/ 74140 w 926765"/>
                  <a:gd name="connsiteY1" fmla="*/ 58895 h 1351532"/>
                  <a:gd name="connsiteX2" fmla="*/ 55176 w 926765"/>
                  <a:gd name="connsiteY2" fmla="*/ 997615 h 1351532"/>
                  <a:gd name="connsiteX3" fmla="*/ 926765 w 926765"/>
                  <a:gd name="connsiteY3" fmla="*/ 1351532 h 1351532"/>
                  <a:gd name="connsiteX0" fmla="*/ 823666 w 926765"/>
                  <a:gd name="connsiteY0" fmla="*/ 393254 h 1326654"/>
                  <a:gd name="connsiteX1" fmla="*/ 74140 w 926765"/>
                  <a:gd name="connsiteY1" fmla="*/ 34017 h 1326654"/>
                  <a:gd name="connsiteX2" fmla="*/ 55176 w 926765"/>
                  <a:gd name="connsiteY2" fmla="*/ 972737 h 1326654"/>
                  <a:gd name="connsiteX3" fmla="*/ 926765 w 926765"/>
                  <a:gd name="connsiteY3" fmla="*/ 1326654 h 1326654"/>
                  <a:gd name="connsiteX0" fmla="*/ 823666 w 926765"/>
                  <a:gd name="connsiteY0" fmla="*/ 360407 h 1293807"/>
                  <a:gd name="connsiteX1" fmla="*/ 74140 w 926765"/>
                  <a:gd name="connsiteY1" fmla="*/ 1170 h 1293807"/>
                  <a:gd name="connsiteX2" fmla="*/ 55176 w 926765"/>
                  <a:gd name="connsiteY2" fmla="*/ 939890 h 1293807"/>
                  <a:gd name="connsiteX3" fmla="*/ 926765 w 926765"/>
                  <a:gd name="connsiteY3" fmla="*/ 1293807 h 1293807"/>
                  <a:gd name="connsiteX0" fmla="*/ 845490 w 948589"/>
                  <a:gd name="connsiteY0" fmla="*/ 360407 h 1293807"/>
                  <a:gd name="connsiteX1" fmla="*/ 95964 w 948589"/>
                  <a:gd name="connsiteY1" fmla="*/ 1170 h 1293807"/>
                  <a:gd name="connsiteX2" fmla="*/ 77000 w 948589"/>
                  <a:gd name="connsiteY2" fmla="*/ 939890 h 1293807"/>
                  <a:gd name="connsiteX3" fmla="*/ 948589 w 948589"/>
                  <a:gd name="connsiteY3" fmla="*/ 1293807 h 1293807"/>
                  <a:gd name="connsiteX0" fmla="*/ 842560 w 945659"/>
                  <a:gd name="connsiteY0" fmla="*/ 417074 h 1350474"/>
                  <a:gd name="connsiteX1" fmla="*/ 100210 w 945659"/>
                  <a:gd name="connsiteY1" fmla="*/ 1024 h 1350474"/>
                  <a:gd name="connsiteX2" fmla="*/ 74070 w 945659"/>
                  <a:gd name="connsiteY2" fmla="*/ 996557 h 1350474"/>
                  <a:gd name="connsiteX3" fmla="*/ 945659 w 945659"/>
                  <a:gd name="connsiteY3" fmla="*/ 1350474 h 1350474"/>
                  <a:gd name="connsiteX0" fmla="*/ 866211 w 969310"/>
                  <a:gd name="connsiteY0" fmla="*/ 417074 h 1350474"/>
                  <a:gd name="connsiteX1" fmla="*/ 123861 w 969310"/>
                  <a:gd name="connsiteY1" fmla="*/ 1024 h 1350474"/>
                  <a:gd name="connsiteX2" fmla="*/ 23770 w 969310"/>
                  <a:gd name="connsiteY2" fmla="*/ 493964 h 1350474"/>
                  <a:gd name="connsiteX3" fmla="*/ 97721 w 969310"/>
                  <a:gd name="connsiteY3" fmla="*/ 996557 h 1350474"/>
                  <a:gd name="connsiteX4" fmla="*/ 969310 w 969310"/>
                  <a:gd name="connsiteY4" fmla="*/ 1350474 h 1350474"/>
                  <a:gd name="connsiteX0" fmla="*/ 920980 w 1024079"/>
                  <a:gd name="connsiteY0" fmla="*/ 417074 h 1350474"/>
                  <a:gd name="connsiteX1" fmla="*/ 178630 w 1024079"/>
                  <a:gd name="connsiteY1" fmla="*/ 1024 h 1350474"/>
                  <a:gd name="connsiteX2" fmla="*/ 1272 w 1024079"/>
                  <a:gd name="connsiteY2" fmla="*/ 539531 h 1350474"/>
                  <a:gd name="connsiteX3" fmla="*/ 152490 w 1024079"/>
                  <a:gd name="connsiteY3" fmla="*/ 996557 h 1350474"/>
                  <a:gd name="connsiteX4" fmla="*/ 1024079 w 1024079"/>
                  <a:gd name="connsiteY4" fmla="*/ 1350474 h 1350474"/>
                  <a:gd name="connsiteX0" fmla="*/ 920121 w 1023220"/>
                  <a:gd name="connsiteY0" fmla="*/ 417074 h 1350474"/>
                  <a:gd name="connsiteX1" fmla="*/ 177771 w 1023220"/>
                  <a:gd name="connsiteY1" fmla="*/ 1024 h 1350474"/>
                  <a:gd name="connsiteX2" fmla="*/ 413 w 1023220"/>
                  <a:gd name="connsiteY2" fmla="*/ 539531 h 1350474"/>
                  <a:gd name="connsiteX3" fmla="*/ 181826 w 1023220"/>
                  <a:gd name="connsiteY3" fmla="*/ 1023935 h 1350474"/>
                  <a:gd name="connsiteX4" fmla="*/ 1023220 w 1023220"/>
                  <a:gd name="connsiteY4" fmla="*/ 1350474 h 135047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3220" h="1350474">
                    <a:moveTo>
                      <a:pt x="920121" y="417074"/>
                    </a:moveTo>
                    <a:cubicBezTo>
                      <a:pt x="923424" y="418061"/>
                      <a:pt x="364387" y="-24014"/>
                      <a:pt x="177771" y="1024"/>
                    </a:cubicBezTo>
                    <a:cubicBezTo>
                      <a:pt x="37364" y="13839"/>
                      <a:pt x="4770" y="373609"/>
                      <a:pt x="413" y="539531"/>
                    </a:cubicBezTo>
                    <a:cubicBezTo>
                      <a:pt x="-3944" y="705453"/>
                      <a:pt x="24236" y="881183"/>
                      <a:pt x="181826" y="1023935"/>
                    </a:cubicBezTo>
                    <a:cubicBezTo>
                      <a:pt x="322734" y="1248843"/>
                      <a:pt x="838048" y="1289975"/>
                      <a:pt x="1023220" y="1350474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" name="Freeform: Shape 3">
                <a:extLst>
                  <a:ext uri="{FF2B5EF4-FFF2-40B4-BE49-F238E27FC236}">
                    <a16:creationId xmlns:a16="http://schemas.microsoft.com/office/drawing/2014/main" id="{4015169B-E976-B928-AB8F-68F8316F0358}"/>
                  </a:ext>
                </a:extLst>
              </p:cNvPr>
              <p:cNvSpPr/>
              <p:nvPr/>
            </p:nvSpPr>
            <p:spPr>
              <a:xfrm rot="19461561">
                <a:off x="4596016" y="1470117"/>
                <a:ext cx="726696" cy="436581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899365"/>
                  <a:gd name="connsiteY0" fmla="*/ 17685 h 264215"/>
                  <a:gd name="connsiteX1" fmla="*/ 634896 w 899365"/>
                  <a:gd name="connsiteY1" fmla="*/ 9630 h 264215"/>
                  <a:gd name="connsiteX2" fmla="*/ 838846 w 899365"/>
                  <a:gd name="connsiteY2" fmla="*/ 179450 h 264215"/>
                  <a:gd name="connsiteX3" fmla="*/ 899365 w 899365"/>
                  <a:gd name="connsiteY3" fmla="*/ 264215 h 264215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838846 w 899365"/>
                  <a:gd name="connsiteY2" fmla="*/ 161765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705863 w 899365"/>
                  <a:gd name="connsiteY2" fmla="*/ 120337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164737 w 899365"/>
                  <a:gd name="connsiteY1" fmla="*/ 4845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1191533"/>
                  <a:gd name="connsiteY0" fmla="*/ 0 h 614340"/>
                  <a:gd name="connsiteX1" fmla="*/ 456905 w 1191533"/>
                  <a:gd name="connsiteY1" fmla="*/ 416265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785181 w 1191533"/>
                  <a:gd name="connsiteY2" fmla="*/ 477195 h 614340"/>
                  <a:gd name="connsiteX3" fmla="*/ 1191533 w 1191533"/>
                  <a:gd name="connsiteY3" fmla="*/ 614340 h 614340"/>
                  <a:gd name="connsiteX0" fmla="*/ 0 w 1359842"/>
                  <a:gd name="connsiteY0" fmla="*/ 0 h 1178527"/>
                  <a:gd name="connsiteX1" fmla="*/ 508766 w 1359842"/>
                  <a:gd name="connsiteY1" fmla="*/ 954016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59842"/>
                  <a:gd name="connsiteY0" fmla="*/ 0 h 1178527"/>
                  <a:gd name="connsiteX1" fmla="*/ 453857 w 1359842"/>
                  <a:gd name="connsiteY1" fmla="*/ 896315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97513"/>
                  <a:gd name="connsiteY0" fmla="*/ 0 h 1299748"/>
                  <a:gd name="connsiteX1" fmla="*/ 491528 w 1397513"/>
                  <a:gd name="connsiteY1" fmla="*/ 1017536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1397513 w 1397513"/>
                  <a:gd name="connsiteY2" fmla="*/ 1299748 h 1299748"/>
                  <a:gd name="connsiteX0" fmla="*/ 0 w 1397513"/>
                  <a:gd name="connsiteY0" fmla="*/ 0 h 1299748"/>
                  <a:gd name="connsiteX1" fmla="*/ 817159 w 1397513"/>
                  <a:gd name="connsiteY1" fmla="*/ 1138664 h 1299748"/>
                  <a:gd name="connsiteX2" fmla="*/ 1397513 w 1397513"/>
                  <a:gd name="connsiteY2" fmla="*/ 1299748 h 1299748"/>
                  <a:gd name="connsiteX0" fmla="*/ 25784 w 616127"/>
                  <a:gd name="connsiteY0" fmla="*/ 0 h 504551"/>
                  <a:gd name="connsiteX1" fmla="*/ 35773 w 616127"/>
                  <a:gd name="connsiteY1" fmla="*/ 343467 h 504551"/>
                  <a:gd name="connsiteX2" fmla="*/ 616127 w 616127"/>
                  <a:gd name="connsiteY2" fmla="*/ 504551 h 504551"/>
                  <a:gd name="connsiteX0" fmla="*/ 0 w 590343"/>
                  <a:gd name="connsiteY0" fmla="*/ 0 h 504551"/>
                  <a:gd name="connsiteX1" fmla="*/ 119963 w 590343"/>
                  <a:gd name="connsiteY1" fmla="*/ 348204 h 504551"/>
                  <a:gd name="connsiteX2" fmla="*/ 590343 w 590343"/>
                  <a:gd name="connsiteY2" fmla="*/ 504551 h 504551"/>
                  <a:gd name="connsiteX0" fmla="*/ 0 w 590343"/>
                  <a:gd name="connsiteY0" fmla="*/ 0 h 504551"/>
                  <a:gd name="connsiteX1" fmla="*/ 152487 w 590343"/>
                  <a:gd name="connsiteY1" fmla="*/ 346035 h 504551"/>
                  <a:gd name="connsiteX2" fmla="*/ 590343 w 590343"/>
                  <a:gd name="connsiteY2" fmla="*/ 504551 h 504551"/>
                  <a:gd name="connsiteX0" fmla="*/ 0 w 610388"/>
                  <a:gd name="connsiteY0" fmla="*/ 0 h 546471"/>
                  <a:gd name="connsiteX1" fmla="*/ 172532 w 610388"/>
                  <a:gd name="connsiteY1" fmla="*/ 387955 h 546471"/>
                  <a:gd name="connsiteX2" fmla="*/ 610388 w 610388"/>
                  <a:gd name="connsiteY2" fmla="*/ 546471 h 546471"/>
                  <a:gd name="connsiteX0" fmla="*/ 0 w 610388"/>
                  <a:gd name="connsiteY0" fmla="*/ 78865 h 625336"/>
                  <a:gd name="connsiteX1" fmla="*/ 276038 w 610388"/>
                  <a:gd name="connsiteY1" fmla="*/ 30370 h 625336"/>
                  <a:gd name="connsiteX2" fmla="*/ 610388 w 610388"/>
                  <a:gd name="connsiteY2" fmla="*/ 625336 h 625336"/>
                  <a:gd name="connsiteX0" fmla="*/ 0 w 627154"/>
                  <a:gd name="connsiteY0" fmla="*/ 0 h 814950"/>
                  <a:gd name="connsiteX1" fmla="*/ 292804 w 627154"/>
                  <a:gd name="connsiteY1" fmla="*/ 219984 h 814950"/>
                  <a:gd name="connsiteX2" fmla="*/ 627154 w 627154"/>
                  <a:gd name="connsiteY2" fmla="*/ 814950 h 814950"/>
                  <a:gd name="connsiteX0" fmla="*/ 0 w 627154"/>
                  <a:gd name="connsiteY0" fmla="*/ 0 h 814950"/>
                  <a:gd name="connsiteX1" fmla="*/ 272839 w 627154"/>
                  <a:gd name="connsiteY1" fmla="*/ 122731 h 814950"/>
                  <a:gd name="connsiteX2" fmla="*/ 627154 w 627154"/>
                  <a:gd name="connsiteY2" fmla="*/ 814950 h 814950"/>
                  <a:gd name="connsiteX0" fmla="*/ 0 w 424449"/>
                  <a:gd name="connsiteY0" fmla="*/ 0 h 322470"/>
                  <a:gd name="connsiteX1" fmla="*/ 272839 w 424449"/>
                  <a:gd name="connsiteY1" fmla="*/ 122731 h 322470"/>
                  <a:gd name="connsiteX2" fmla="*/ 424449 w 424449"/>
                  <a:gd name="connsiteY2" fmla="*/ 322470 h 322470"/>
                  <a:gd name="connsiteX0" fmla="*/ 0 w 424449"/>
                  <a:gd name="connsiteY0" fmla="*/ 0 h 322470"/>
                  <a:gd name="connsiteX1" fmla="*/ 259190 w 424449"/>
                  <a:gd name="connsiteY1" fmla="*/ 157844 h 322470"/>
                  <a:gd name="connsiteX2" fmla="*/ 424449 w 424449"/>
                  <a:gd name="connsiteY2" fmla="*/ 322470 h 3224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424449" h="322470">
                    <a:moveTo>
                      <a:pt x="0" y="0"/>
                    </a:moveTo>
                    <a:cubicBezTo>
                      <a:pt x="53181" y="3572"/>
                      <a:pt x="188449" y="104099"/>
                      <a:pt x="259190" y="157844"/>
                    </a:cubicBezTo>
                    <a:cubicBezTo>
                      <a:pt x="329931" y="211589"/>
                      <a:pt x="239277" y="261971"/>
                      <a:pt x="424449" y="322470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5" name="Freeform: Shape 4">
                <a:extLst>
                  <a:ext uri="{FF2B5EF4-FFF2-40B4-BE49-F238E27FC236}">
                    <a16:creationId xmlns:a16="http://schemas.microsoft.com/office/drawing/2014/main" id="{C5FC4BDD-CAE9-114A-C255-1D6C6AD92FBF}"/>
                  </a:ext>
                </a:extLst>
              </p:cNvPr>
              <p:cNvSpPr/>
              <p:nvPr/>
            </p:nvSpPr>
            <p:spPr>
              <a:xfrm rot="19461561">
                <a:off x="4811995" y="1977265"/>
                <a:ext cx="46132" cy="260565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899365"/>
                  <a:gd name="connsiteY0" fmla="*/ 17685 h 264215"/>
                  <a:gd name="connsiteX1" fmla="*/ 634896 w 899365"/>
                  <a:gd name="connsiteY1" fmla="*/ 9630 h 264215"/>
                  <a:gd name="connsiteX2" fmla="*/ 838846 w 899365"/>
                  <a:gd name="connsiteY2" fmla="*/ 179450 h 264215"/>
                  <a:gd name="connsiteX3" fmla="*/ 899365 w 899365"/>
                  <a:gd name="connsiteY3" fmla="*/ 264215 h 264215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838846 w 899365"/>
                  <a:gd name="connsiteY2" fmla="*/ 161765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705863 w 899365"/>
                  <a:gd name="connsiteY2" fmla="*/ 120337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164737 w 899365"/>
                  <a:gd name="connsiteY1" fmla="*/ 4845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1191533"/>
                  <a:gd name="connsiteY0" fmla="*/ 0 h 614340"/>
                  <a:gd name="connsiteX1" fmla="*/ 456905 w 1191533"/>
                  <a:gd name="connsiteY1" fmla="*/ 416265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785181 w 1191533"/>
                  <a:gd name="connsiteY2" fmla="*/ 477195 h 614340"/>
                  <a:gd name="connsiteX3" fmla="*/ 1191533 w 1191533"/>
                  <a:gd name="connsiteY3" fmla="*/ 614340 h 614340"/>
                  <a:gd name="connsiteX0" fmla="*/ 0 w 1359842"/>
                  <a:gd name="connsiteY0" fmla="*/ 0 h 1178527"/>
                  <a:gd name="connsiteX1" fmla="*/ 508766 w 1359842"/>
                  <a:gd name="connsiteY1" fmla="*/ 954016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59842"/>
                  <a:gd name="connsiteY0" fmla="*/ 0 h 1178527"/>
                  <a:gd name="connsiteX1" fmla="*/ 453857 w 1359842"/>
                  <a:gd name="connsiteY1" fmla="*/ 896315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97513"/>
                  <a:gd name="connsiteY0" fmla="*/ 0 h 1299748"/>
                  <a:gd name="connsiteX1" fmla="*/ 491528 w 1397513"/>
                  <a:gd name="connsiteY1" fmla="*/ 1017536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1397513 w 1397513"/>
                  <a:gd name="connsiteY2" fmla="*/ 1299748 h 1299748"/>
                  <a:gd name="connsiteX0" fmla="*/ 0 w 1397513"/>
                  <a:gd name="connsiteY0" fmla="*/ 0 h 1299748"/>
                  <a:gd name="connsiteX1" fmla="*/ 817159 w 1397513"/>
                  <a:gd name="connsiteY1" fmla="*/ 1138664 h 1299748"/>
                  <a:gd name="connsiteX2" fmla="*/ 1397513 w 1397513"/>
                  <a:gd name="connsiteY2" fmla="*/ 1299748 h 1299748"/>
                  <a:gd name="connsiteX0" fmla="*/ 25784 w 616127"/>
                  <a:gd name="connsiteY0" fmla="*/ 0 h 504551"/>
                  <a:gd name="connsiteX1" fmla="*/ 35773 w 616127"/>
                  <a:gd name="connsiteY1" fmla="*/ 343467 h 504551"/>
                  <a:gd name="connsiteX2" fmla="*/ 616127 w 616127"/>
                  <a:gd name="connsiteY2" fmla="*/ 504551 h 504551"/>
                  <a:gd name="connsiteX0" fmla="*/ 0 w 590343"/>
                  <a:gd name="connsiteY0" fmla="*/ 0 h 504551"/>
                  <a:gd name="connsiteX1" fmla="*/ 119963 w 590343"/>
                  <a:gd name="connsiteY1" fmla="*/ 348204 h 504551"/>
                  <a:gd name="connsiteX2" fmla="*/ 590343 w 590343"/>
                  <a:gd name="connsiteY2" fmla="*/ 504551 h 504551"/>
                  <a:gd name="connsiteX0" fmla="*/ 0 w 590343"/>
                  <a:gd name="connsiteY0" fmla="*/ 0 h 504551"/>
                  <a:gd name="connsiteX1" fmla="*/ 152487 w 590343"/>
                  <a:gd name="connsiteY1" fmla="*/ 346035 h 504551"/>
                  <a:gd name="connsiteX2" fmla="*/ 590343 w 590343"/>
                  <a:gd name="connsiteY2" fmla="*/ 504551 h 504551"/>
                  <a:gd name="connsiteX0" fmla="*/ 0 w 610388"/>
                  <a:gd name="connsiteY0" fmla="*/ 0 h 546471"/>
                  <a:gd name="connsiteX1" fmla="*/ 172532 w 610388"/>
                  <a:gd name="connsiteY1" fmla="*/ 387955 h 546471"/>
                  <a:gd name="connsiteX2" fmla="*/ 610388 w 610388"/>
                  <a:gd name="connsiteY2" fmla="*/ 546471 h 546471"/>
                  <a:gd name="connsiteX0" fmla="*/ 0 w 610388"/>
                  <a:gd name="connsiteY0" fmla="*/ 78865 h 625336"/>
                  <a:gd name="connsiteX1" fmla="*/ 276038 w 610388"/>
                  <a:gd name="connsiteY1" fmla="*/ 30370 h 625336"/>
                  <a:gd name="connsiteX2" fmla="*/ 610388 w 610388"/>
                  <a:gd name="connsiteY2" fmla="*/ 625336 h 625336"/>
                  <a:gd name="connsiteX0" fmla="*/ 0 w 627154"/>
                  <a:gd name="connsiteY0" fmla="*/ 0 h 814950"/>
                  <a:gd name="connsiteX1" fmla="*/ 292804 w 627154"/>
                  <a:gd name="connsiteY1" fmla="*/ 219984 h 814950"/>
                  <a:gd name="connsiteX2" fmla="*/ 627154 w 627154"/>
                  <a:gd name="connsiteY2" fmla="*/ 814950 h 814950"/>
                  <a:gd name="connsiteX0" fmla="*/ 0 w 627154"/>
                  <a:gd name="connsiteY0" fmla="*/ 0 h 814950"/>
                  <a:gd name="connsiteX1" fmla="*/ 272839 w 627154"/>
                  <a:gd name="connsiteY1" fmla="*/ 122731 h 814950"/>
                  <a:gd name="connsiteX2" fmla="*/ 627154 w 627154"/>
                  <a:gd name="connsiteY2" fmla="*/ 814950 h 814950"/>
                  <a:gd name="connsiteX0" fmla="*/ 0 w 424449"/>
                  <a:gd name="connsiteY0" fmla="*/ 0 h 322470"/>
                  <a:gd name="connsiteX1" fmla="*/ 272839 w 424449"/>
                  <a:gd name="connsiteY1" fmla="*/ 122731 h 322470"/>
                  <a:gd name="connsiteX2" fmla="*/ 424449 w 424449"/>
                  <a:gd name="connsiteY2" fmla="*/ 322470 h 322470"/>
                  <a:gd name="connsiteX0" fmla="*/ 183 w 424632"/>
                  <a:gd name="connsiteY0" fmla="*/ 0 h 322470"/>
                  <a:gd name="connsiteX1" fmla="*/ 26945 w 424632"/>
                  <a:gd name="connsiteY1" fmla="*/ 192460 h 322470"/>
                  <a:gd name="connsiteX2" fmla="*/ 424632 w 424632"/>
                  <a:gd name="connsiteY2" fmla="*/ 322470 h 322470"/>
                  <a:gd name="connsiteX0" fmla="*/ 183 w 26945"/>
                  <a:gd name="connsiteY0" fmla="*/ 0 h 192460"/>
                  <a:gd name="connsiteX1" fmla="*/ 26945 w 26945"/>
                  <a:gd name="connsiteY1" fmla="*/ 192460 h 1924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945" h="192460">
                    <a:moveTo>
                      <a:pt x="183" y="0"/>
                    </a:moveTo>
                    <a:cubicBezTo>
                      <a:pt x="53364" y="3572"/>
                      <a:pt x="-43796" y="138715"/>
                      <a:pt x="26945" y="192460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Freeform: Shape 9">
                <a:extLst>
                  <a:ext uri="{FF2B5EF4-FFF2-40B4-BE49-F238E27FC236}">
                    <a16:creationId xmlns:a16="http://schemas.microsoft.com/office/drawing/2014/main" id="{A319A1FD-CCD6-B093-9B9A-AF38D1C517F6}"/>
                  </a:ext>
                </a:extLst>
              </p:cNvPr>
              <p:cNvSpPr/>
              <p:nvPr/>
            </p:nvSpPr>
            <p:spPr>
              <a:xfrm>
                <a:off x="1952918" y="1147263"/>
                <a:ext cx="1466004" cy="446128"/>
              </a:xfrm>
              <a:custGeom>
                <a:avLst/>
                <a:gdLst>
                  <a:gd name="connsiteX0" fmla="*/ 0 w 1236617"/>
                  <a:gd name="connsiteY0" fmla="*/ 397629 h 397629"/>
                  <a:gd name="connsiteX1" fmla="*/ 714103 w 1236617"/>
                  <a:gd name="connsiteY1" fmla="*/ 40577 h 397629"/>
                  <a:gd name="connsiteX2" fmla="*/ 1236617 w 1236617"/>
                  <a:gd name="connsiteY2" fmla="*/ 23160 h 397629"/>
                  <a:gd name="connsiteX0" fmla="*/ 0 w 1297577"/>
                  <a:gd name="connsiteY0" fmla="*/ 441172 h 441172"/>
                  <a:gd name="connsiteX1" fmla="*/ 775063 w 1297577"/>
                  <a:gd name="connsiteY1" fmla="*/ 40577 h 441172"/>
                  <a:gd name="connsiteX2" fmla="*/ 1297577 w 1297577"/>
                  <a:gd name="connsiteY2" fmla="*/ 23160 h 441172"/>
                  <a:gd name="connsiteX0" fmla="*/ 0 w 1373777"/>
                  <a:gd name="connsiteY0" fmla="*/ 438993 h 438993"/>
                  <a:gd name="connsiteX1" fmla="*/ 775063 w 1373777"/>
                  <a:gd name="connsiteY1" fmla="*/ 38398 h 438993"/>
                  <a:gd name="connsiteX2" fmla="*/ 1373777 w 1373777"/>
                  <a:gd name="connsiteY2" fmla="*/ 25743 h 438993"/>
                  <a:gd name="connsiteX0" fmla="*/ 0 w 1378540"/>
                  <a:gd name="connsiteY0" fmla="*/ 446128 h 446128"/>
                  <a:gd name="connsiteX1" fmla="*/ 775063 w 1378540"/>
                  <a:gd name="connsiteY1" fmla="*/ 45533 h 446128"/>
                  <a:gd name="connsiteX2" fmla="*/ 1378540 w 1378540"/>
                  <a:gd name="connsiteY2" fmla="*/ 18590 h 446128"/>
                  <a:gd name="connsiteX0" fmla="*/ 0 w 1466004"/>
                  <a:gd name="connsiteY0" fmla="*/ 446128 h 446128"/>
                  <a:gd name="connsiteX1" fmla="*/ 775063 w 1466004"/>
                  <a:gd name="connsiteY1" fmla="*/ 45533 h 446128"/>
                  <a:gd name="connsiteX2" fmla="*/ 1466004 w 1466004"/>
                  <a:gd name="connsiteY2" fmla="*/ 18590 h 446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66004" h="446128">
                    <a:moveTo>
                      <a:pt x="0" y="446128"/>
                    </a:moveTo>
                    <a:cubicBezTo>
                      <a:pt x="254000" y="298808"/>
                      <a:pt x="568960" y="107945"/>
                      <a:pt x="775063" y="45533"/>
                    </a:cubicBezTo>
                    <a:cubicBezTo>
                      <a:pt x="981166" y="-16879"/>
                      <a:pt x="1307798" y="-3908"/>
                      <a:pt x="1466004" y="18590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Freeform: Shape 10">
                <a:extLst>
                  <a:ext uri="{FF2B5EF4-FFF2-40B4-BE49-F238E27FC236}">
                    <a16:creationId xmlns:a16="http://schemas.microsoft.com/office/drawing/2014/main" id="{E9EF76E4-D0AD-8999-81D5-99696D683B44}"/>
                  </a:ext>
                </a:extLst>
              </p:cNvPr>
              <p:cNvSpPr/>
              <p:nvPr/>
            </p:nvSpPr>
            <p:spPr>
              <a:xfrm rot="19461561">
                <a:off x="3935785" y="1141294"/>
                <a:ext cx="460378" cy="430254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899365"/>
                  <a:gd name="connsiteY0" fmla="*/ 17685 h 264215"/>
                  <a:gd name="connsiteX1" fmla="*/ 634896 w 899365"/>
                  <a:gd name="connsiteY1" fmla="*/ 9630 h 264215"/>
                  <a:gd name="connsiteX2" fmla="*/ 838846 w 899365"/>
                  <a:gd name="connsiteY2" fmla="*/ 179450 h 264215"/>
                  <a:gd name="connsiteX3" fmla="*/ 899365 w 899365"/>
                  <a:gd name="connsiteY3" fmla="*/ 264215 h 264215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838846 w 899365"/>
                  <a:gd name="connsiteY2" fmla="*/ 161765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705863 w 899365"/>
                  <a:gd name="connsiteY2" fmla="*/ 120337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164737 w 899365"/>
                  <a:gd name="connsiteY1" fmla="*/ 4845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1191533"/>
                  <a:gd name="connsiteY0" fmla="*/ 0 h 614340"/>
                  <a:gd name="connsiteX1" fmla="*/ 456905 w 1191533"/>
                  <a:gd name="connsiteY1" fmla="*/ 416265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785181 w 1191533"/>
                  <a:gd name="connsiteY2" fmla="*/ 477195 h 614340"/>
                  <a:gd name="connsiteX3" fmla="*/ 1191533 w 1191533"/>
                  <a:gd name="connsiteY3" fmla="*/ 614340 h 614340"/>
                  <a:gd name="connsiteX0" fmla="*/ 0 w 1359842"/>
                  <a:gd name="connsiteY0" fmla="*/ 0 h 1178527"/>
                  <a:gd name="connsiteX1" fmla="*/ 508766 w 1359842"/>
                  <a:gd name="connsiteY1" fmla="*/ 954016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59842"/>
                  <a:gd name="connsiteY0" fmla="*/ 0 h 1178527"/>
                  <a:gd name="connsiteX1" fmla="*/ 453857 w 1359842"/>
                  <a:gd name="connsiteY1" fmla="*/ 896315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97513"/>
                  <a:gd name="connsiteY0" fmla="*/ 0 h 1299748"/>
                  <a:gd name="connsiteX1" fmla="*/ 491528 w 1397513"/>
                  <a:gd name="connsiteY1" fmla="*/ 1017536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1397513 w 1397513"/>
                  <a:gd name="connsiteY2" fmla="*/ 1299748 h 1299748"/>
                  <a:gd name="connsiteX0" fmla="*/ 0 w 1397513"/>
                  <a:gd name="connsiteY0" fmla="*/ 0 h 1299748"/>
                  <a:gd name="connsiteX1" fmla="*/ 817159 w 1397513"/>
                  <a:gd name="connsiteY1" fmla="*/ 1138664 h 1299748"/>
                  <a:gd name="connsiteX2" fmla="*/ 1397513 w 1397513"/>
                  <a:gd name="connsiteY2" fmla="*/ 1299748 h 1299748"/>
                  <a:gd name="connsiteX0" fmla="*/ 25784 w 616127"/>
                  <a:gd name="connsiteY0" fmla="*/ 0 h 504551"/>
                  <a:gd name="connsiteX1" fmla="*/ 35773 w 616127"/>
                  <a:gd name="connsiteY1" fmla="*/ 343467 h 504551"/>
                  <a:gd name="connsiteX2" fmla="*/ 616127 w 616127"/>
                  <a:gd name="connsiteY2" fmla="*/ 504551 h 504551"/>
                  <a:gd name="connsiteX0" fmla="*/ 0 w 590343"/>
                  <a:gd name="connsiteY0" fmla="*/ 0 h 504551"/>
                  <a:gd name="connsiteX1" fmla="*/ 119963 w 590343"/>
                  <a:gd name="connsiteY1" fmla="*/ 348204 h 504551"/>
                  <a:gd name="connsiteX2" fmla="*/ 590343 w 590343"/>
                  <a:gd name="connsiteY2" fmla="*/ 504551 h 504551"/>
                  <a:gd name="connsiteX0" fmla="*/ 0 w 590343"/>
                  <a:gd name="connsiteY0" fmla="*/ 0 h 504551"/>
                  <a:gd name="connsiteX1" fmla="*/ 152487 w 590343"/>
                  <a:gd name="connsiteY1" fmla="*/ 346035 h 504551"/>
                  <a:gd name="connsiteX2" fmla="*/ 590343 w 590343"/>
                  <a:gd name="connsiteY2" fmla="*/ 504551 h 504551"/>
                  <a:gd name="connsiteX0" fmla="*/ 49080 w 639423"/>
                  <a:gd name="connsiteY0" fmla="*/ 0 h 504551"/>
                  <a:gd name="connsiteX1" fmla="*/ 31381 w 639423"/>
                  <a:gd name="connsiteY1" fmla="*/ 270873 h 504551"/>
                  <a:gd name="connsiteX2" fmla="*/ 639423 w 639423"/>
                  <a:gd name="connsiteY2" fmla="*/ 504551 h 504551"/>
                  <a:gd name="connsiteX0" fmla="*/ 144683 w 623257"/>
                  <a:gd name="connsiteY0" fmla="*/ 0 h 514017"/>
                  <a:gd name="connsiteX1" fmla="*/ 15215 w 623257"/>
                  <a:gd name="connsiteY1" fmla="*/ 280339 h 514017"/>
                  <a:gd name="connsiteX2" fmla="*/ 623257 w 623257"/>
                  <a:gd name="connsiteY2" fmla="*/ 514017 h 514017"/>
                  <a:gd name="connsiteX0" fmla="*/ 208159 w 686733"/>
                  <a:gd name="connsiteY0" fmla="*/ 0 h 514017"/>
                  <a:gd name="connsiteX1" fmla="*/ 12551 w 686733"/>
                  <a:gd name="connsiteY1" fmla="*/ 220369 h 514017"/>
                  <a:gd name="connsiteX2" fmla="*/ 686733 w 686733"/>
                  <a:gd name="connsiteY2" fmla="*/ 514017 h 514017"/>
                  <a:gd name="connsiteX0" fmla="*/ 247752 w 683819"/>
                  <a:gd name="connsiteY0" fmla="*/ 0 h 467560"/>
                  <a:gd name="connsiteX1" fmla="*/ 9637 w 683819"/>
                  <a:gd name="connsiteY1" fmla="*/ 173912 h 467560"/>
                  <a:gd name="connsiteX2" fmla="*/ 683819 w 683819"/>
                  <a:gd name="connsiteY2" fmla="*/ 467560 h 467560"/>
                  <a:gd name="connsiteX0" fmla="*/ 247133 w 666586"/>
                  <a:gd name="connsiteY0" fmla="*/ 0 h 507901"/>
                  <a:gd name="connsiteX1" fmla="*/ 9018 w 666586"/>
                  <a:gd name="connsiteY1" fmla="*/ 173912 h 507901"/>
                  <a:gd name="connsiteX2" fmla="*/ 666586 w 666586"/>
                  <a:gd name="connsiteY2" fmla="*/ 507901 h 507901"/>
                  <a:gd name="connsiteX0" fmla="*/ 0 w 556859"/>
                  <a:gd name="connsiteY0" fmla="*/ 0 h 507901"/>
                  <a:gd name="connsiteX1" fmla="*/ 548240 w 556859"/>
                  <a:gd name="connsiteY1" fmla="*/ 222060 h 507901"/>
                  <a:gd name="connsiteX2" fmla="*/ 419453 w 556859"/>
                  <a:gd name="connsiteY2" fmla="*/ 507901 h 507901"/>
                  <a:gd name="connsiteX0" fmla="*/ 295328 w 308899"/>
                  <a:gd name="connsiteY0" fmla="*/ 1518 h 322496"/>
                  <a:gd name="connsiteX1" fmla="*/ 192225 w 308899"/>
                  <a:gd name="connsiteY1" fmla="*/ 36655 h 322496"/>
                  <a:gd name="connsiteX2" fmla="*/ 63438 w 308899"/>
                  <a:gd name="connsiteY2" fmla="*/ 322496 h 322496"/>
                  <a:gd name="connsiteX0" fmla="*/ 302535 w 316216"/>
                  <a:gd name="connsiteY0" fmla="*/ 1140 h 314622"/>
                  <a:gd name="connsiteX1" fmla="*/ 199432 w 316216"/>
                  <a:gd name="connsiteY1" fmla="*/ 36277 h 314622"/>
                  <a:gd name="connsiteX2" fmla="*/ 62378 w 316216"/>
                  <a:gd name="connsiteY2" fmla="*/ 314622 h 314622"/>
                  <a:gd name="connsiteX0" fmla="*/ 341775 w 353135"/>
                  <a:gd name="connsiteY0" fmla="*/ 25183 h 295957"/>
                  <a:gd name="connsiteX1" fmla="*/ 200299 w 353135"/>
                  <a:gd name="connsiteY1" fmla="*/ 17612 h 295957"/>
                  <a:gd name="connsiteX2" fmla="*/ 63245 w 353135"/>
                  <a:gd name="connsiteY2" fmla="*/ 295957 h 295957"/>
                  <a:gd name="connsiteX0" fmla="*/ 200299 w 200299"/>
                  <a:gd name="connsiteY0" fmla="*/ 0 h 278345"/>
                  <a:gd name="connsiteX1" fmla="*/ 63245 w 200299"/>
                  <a:gd name="connsiteY1" fmla="*/ 278345 h 278345"/>
                  <a:gd name="connsiteX0" fmla="*/ 273635 w 273635"/>
                  <a:gd name="connsiteY0" fmla="*/ 0 h 305072"/>
                  <a:gd name="connsiteX1" fmla="*/ 52578 w 273635"/>
                  <a:gd name="connsiteY1" fmla="*/ 305072 h 305072"/>
                  <a:gd name="connsiteX0" fmla="*/ 268899 w 268899"/>
                  <a:gd name="connsiteY0" fmla="*/ 0 h 317797"/>
                  <a:gd name="connsiteX1" fmla="*/ 53146 w 268899"/>
                  <a:gd name="connsiteY1" fmla="*/ 317797 h 3177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8899" h="317797">
                    <a:moveTo>
                      <a:pt x="268899" y="0"/>
                    </a:moveTo>
                    <a:cubicBezTo>
                      <a:pt x="222477" y="45129"/>
                      <a:pt x="-132026" y="257298"/>
                      <a:pt x="53146" y="317797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" name="Freeform: Shape 11">
                <a:extLst>
                  <a:ext uri="{FF2B5EF4-FFF2-40B4-BE49-F238E27FC236}">
                    <a16:creationId xmlns:a16="http://schemas.microsoft.com/office/drawing/2014/main" id="{3F933306-FB77-F5F3-6BE2-37904DFFB12A}"/>
                  </a:ext>
                </a:extLst>
              </p:cNvPr>
              <p:cNvSpPr/>
              <p:nvPr/>
            </p:nvSpPr>
            <p:spPr>
              <a:xfrm rot="19461561">
                <a:off x="4703570" y="2228915"/>
                <a:ext cx="123938" cy="166555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899365"/>
                  <a:gd name="connsiteY0" fmla="*/ 17685 h 264215"/>
                  <a:gd name="connsiteX1" fmla="*/ 634896 w 899365"/>
                  <a:gd name="connsiteY1" fmla="*/ 9630 h 264215"/>
                  <a:gd name="connsiteX2" fmla="*/ 838846 w 899365"/>
                  <a:gd name="connsiteY2" fmla="*/ 179450 h 264215"/>
                  <a:gd name="connsiteX3" fmla="*/ 899365 w 899365"/>
                  <a:gd name="connsiteY3" fmla="*/ 264215 h 264215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838846 w 899365"/>
                  <a:gd name="connsiteY2" fmla="*/ 161765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705863 w 899365"/>
                  <a:gd name="connsiteY2" fmla="*/ 120337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164737 w 899365"/>
                  <a:gd name="connsiteY1" fmla="*/ 4845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1191533"/>
                  <a:gd name="connsiteY0" fmla="*/ 0 h 614340"/>
                  <a:gd name="connsiteX1" fmla="*/ 456905 w 1191533"/>
                  <a:gd name="connsiteY1" fmla="*/ 416265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785181 w 1191533"/>
                  <a:gd name="connsiteY2" fmla="*/ 477195 h 614340"/>
                  <a:gd name="connsiteX3" fmla="*/ 1191533 w 1191533"/>
                  <a:gd name="connsiteY3" fmla="*/ 614340 h 614340"/>
                  <a:gd name="connsiteX0" fmla="*/ 0 w 1359842"/>
                  <a:gd name="connsiteY0" fmla="*/ 0 h 1178527"/>
                  <a:gd name="connsiteX1" fmla="*/ 508766 w 1359842"/>
                  <a:gd name="connsiteY1" fmla="*/ 954016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59842"/>
                  <a:gd name="connsiteY0" fmla="*/ 0 h 1178527"/>
                  <a:gd name="connsiteX1" fmla="*/ 453857 w 1359842"/>
                  <a:gd name="connsiteY1" fmla="*/ 896315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97513"/>
                  <a:gd name="connsiteY0" fmla="*/ 0 h 1299748"/>
                  <a:gd name="connsiteX1" fmla="*/ 491528 w 1397513"/>
                  <a:gd name="connsiteY1" fmla="*/ 1017536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1397513 w 1397513"/>
                  <a:gd name="connsiteY2" fmla="*/ 1299748 h 1299748"/>
                  <a:gd name="connsiteX0" fmla="*/ 0 w 1397513"/>
                  <a:gd name="connsiteY0" fmla="*/ 0 h 1299748"/>
                  <a:gd name="connsiteX1" fmla="*/ 817159 w 1397513"/>
                  <a:gd name="connsiteY1" fmla="*/ 1138664 h 1299748"/>
                  <a:gd name="connsiteX2" fmla="*/ 1397513 w 1397513"/>
                  <a:gd name="connsiteY2" fmla="*/ 1299748 h 1299748"/>
                  <a:gd name="connsiteX0" fmla="*/ 25784 w 616127"/>
                  <a:gd name="connsiteY0" fmla="*/ 0 h 504551"/>
                  <a:gd name="connsiteX1" fmla="*/ 35773 w 616127"/>
                  <a:gd name="connsiteY1" fmla="*/ 343467 h 504551"/>
                  <a:gd name="connsiteX2" fmla="*/ 616127 w 616127"/>
                  <a:gd name="connsiteY2" fmla="*/ 504551 h 504551"/>
                  <a:gd name="connsiteX0" fmla="*/ 0 w 590343"/>
                  <a:gd name="connsiteY0" fmla="*/ 0 h 504551"/>
                  <a:gd name="connsiteX1" fmla="*/ 119963 w 590343"/>
                  <a:gd name="connsiteY1" fmla="*/ 348204 h 504551"/>
                  <a:gd name="connsiteX2" fmla="*/ 590343 w 590343"/>
                  <a:gd name="connsiteY2" fmla="*/ 504551 h 504551"/>
                  <a:gd name="connsiteX0" fmla="*/ 0 w 590343"/>
                  <a:gd name="connsiteY0" fmla="*/ 0 h 504551"/>
                  <a:gd name="connsiteX1" fmla="*/ 152487 w 590343"/>
                  <a:gd name="connsiteY1" fmla="*/ 346035 h 504551"/>
                  <a:gd name="connsiteX2" fmla="*/ 590343 w 590343"/>
                  <a:gd name="connsiteY2" fmla="*/ 504551 h 504551"/>
                  <a:gd name="connsiteX0" fmla="*/ 0 w 610388"/>
                  <a:gd name="connsiteY0" fmla="*/ 0 h 546471"/>
                  <a:gd name="connsiteX1" fmla="*/ 172532 w 610388"/>
                  <a:gd name="connsiteY1" fmla="*/ 387955 h 546471"/>
                  <a:gd name="connsiteX2" fmla="*/ 610388 w 610388"/>
                  <a:gd name="connsiteY2" fmla="*/ 546471 h 546471"/>
                  <a:gd name="connsiteX0" fmla="*/ 0 w 610388"/>
                  <a:gd name="connsiteY0" fmla="*/ 78865 h 625336"/>
                  <a:gd name="connsiteX1" fmla="*/ 276038 w 610388"/>
                  <a:gd name="connsiteY1" fmla="*/ 30370 h 625336"/>
                  <a:gd name="connsiteX2" fmla="*/ 610388 w 610388"/>
                  <a:gd name="connsiteY2" fmla="*/ 625336 h 625336"/>
                  <a:gd name="connsiteX0" fmla="*/ 0 w 627154"/>
                  <a:gd name="connsiteY0" fmla="*/ 0 h 814950"/>
                  <a:gd name="connsiteX1" fmla="*/ 292804 w 627154"/>
                  <a:gd name="connsiteY1" fmla="*/ 219984 h 814950"/>
                  <a:gd name="connsiteX2" fmla="*/ 627154 w 627154"/>
                  <a:gd name="connsiteY2" fmla="*/ 814950 h 814950"/>
                  <a:gd name="connsiteX0" fmla="*/ 0 w 627154"/>
                  <a:gd name="connsiteY0" fmla="*/ 0 h 814950"/>
                  <a:gd name="connsiteX1" fmla="*/ 272839 w 627154"/>
                  <a:gd name="connsiteY1" fmla="*/ 122731 h 814950"/>
                  <a:gd name="connsiteX2" fmla="*/ 627154 w 627154"/>
                  <a:gd name="connsiteY2" fmla="*/ 814950 h 814950"/>
                  <a:gd name="connsiteX0" fmla="*/ 0 w 424449"/>
                  <a:gd name="connsiteY0" fmla="*/ 0 h 322470"/>
                  <a:gd name="connsiteX1" fmla="*/ 272839 w 424449"/>
                  <a:gd name="connsiteY1" fmla="*/ 122731 h 322470"/>
                  <a:gd name="connsiteX2" fmla="*/ 424449 w 424449"/>
                  <a:gd name="connsiteY2" fmla="*/ 322470 h 322470"/>
                  <a:gd name="connsiteX0" fmla="*/ 183 w 424632"/>
                  <a:gd name="connsiteY0" fmla="*/ 0 h 322470"/>
                  <a:gd name="connsiteX1" fmla="*/ 26945 w 424632"/>
                  <a:gd name="connsiteY1" fmla="*/ 192460 h 322470"/>
                  <a:gd name="connsiteX2" fmla="*/ 424632 w 424632"/>
                  <a:gd name="connsiteY2" fmla="*/ 322470 h 322470"/>
                  <a:gd name="connsiteX0" fmla="*/ 183 w 26945"/>
                  <a:gd name="connsiteY0" fmla="*/ 0 h 192460"/>
                  <a:gd name="connsiteX1" fmla="*/ 26945 w 26945"/>
                  <a:gd name="connsiteY1" fmla="*/ 192460 h 192460"/>
                  <a:gd name="connsiteX0" fmla="*/ 0 w 239614"/>
                  <a:gd name="connsiteY0" fmla="*/ 0 h 203411"/>
                  <a:gd name="connsiteX1" fmla="*/ 239614 w 239614"/>
                  <a:gd name="connsiteY1" fmla="*/ 203411 h 203411"/>
                  <a:gd name="connsiteX0" fmla="*/ 0 w 72390"/>
                  <a:gd name="connsiteY0" fmla="*/ 0 h 123022"/>
                  <a:gd name="connsiteX1" fmla="*/ 72390 w 72390"/>
                  <a:gd name="connsiteY1" fmla="*/ 123022 h 1230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2390" h="123022">
                    <a:moveTo>
                      <a:pt x="0" y="0"/>
                    </a:moveTo>
                    <a:cubicBezTo>
                      <a:pt x="53181" y="3572"/>
                      <a:pt x="1649" y="69277"/>
                      <a:pt x="72390" y="123022"/>
                    </a:cubicBezTo>
                  </a:path>
                </a:pathLst>
              </a:custGeom>
              <a:noFill/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4" name="Freeform: Shape 13">
                <a:extLst>
                  <a:ext uri="{FF2B5EF4-FFF2-40B4-BE49-F238E27FC236}">
                    <a16:creationId xmlns:a16="http://schemas.microsoft.com/office/drawing/2014/main" id="{6C3FD7BC-8112-0F42-4C7D-4ECBD6CEE476}"/>
                  </a:ext>
                </a:extLst>
              </p:cNvPr>
              <p:cNvSpPr/>
              <p:nvPr/>
            </p:nvSpPr>
            <p:spPr>
              <a:xfrm rot="19461561">
                <a:off x="4455519" y="2398242"/>
                <a:ext cx="123938" cy="166555"/>
              </a:xfrm>
              <a:custGeom>
                <a:avLst/>
                <a:gdLst>
                  <a:gd name="connsiteX0" fmla="*/ 0 w 438150"/>
                  <a:gd name="connsiteY0" fmla="*/ 0 h 204788"/>
                  <a:gd name="connsiteX1" fmla="*/ 161925 w 438150"/>
                  <a:gd name="connsiteY1" fmla="*/ 23813 h 204788"/>
                  <a:gd name="connsiteX2" fmla="*/ 333375 w 438150"/>
                  <a:gd name="connsiteY2" fmla="*/ 100013 h 204788"/>
                  <a:gd name="connsiteX3" fmla="*/ 438150 w 438150"/>
                  <a:gd name="connsiteY3" fmla="*/ 204788 h 204788"/>
                  <a:gd name="connsiteX0" fmla="*/ 0 w 681987"/>
                  <a:gd name="connsiteY0" fmla="*/ 0 h 379619"/>
                  <a:gd name="connsiteX1" fmla="*/ 161925 w 681987"/>
                  <a:gd name="connsiteY1" fmla="*/ 23813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33375 w 681987"/>
                  <a:gd name="connsiteY2" fmla="*/ 100013 h 379619"/>
                  <a:gd name="connsiteX3" fmla="*/ 681987 w 681987"/>
                  <a:gd name="connsiteY3" fmla="*/ 379619 h 379619"/>
                  <a:gd name="connsiteX0" fmla="*/ 0 w 681987"/>
                  <a:gd name="connsiteY0" fmla="*/ 0 h 379619"/>
                  <a:gd name="connsiteX1" fmla="*/ 150825 w 681987"/>
                  <a:gd name="connsiteY1" fmla="*/ 39295 h 379619"/>
                  <a:gd name="connsiteX2" fmla="*/ 342065 w 681987"/>
                  <a:gd name="connsiteY2" fmla="*/ 194146 h 379619"/>
                  <a:gd name="connsiteX3" fmla="*/ 681987 w 681987"/>
                  <a:gd name="connsiteY3" fmla="*/ 379619 h 379619"/>
                  <a:gd name="connsiteX0" fmla="*/ 0 w 499345"/>
                  <a:gd name="connsiteY0" fmla="*/ 0 h 348288"/>
                  <a:gd name="connsiteX1" fmla="*/ 150825 w 499345"/>
                  <a:gd name="connsiteY1" fmla="*/ 39295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2065 w 499345"/>
                  <a:gd name="connsiteY2" fmla="*/ 194146 h 348288"/>
                  <a:gd name="connsiteX3" fmla="*/ 499345 w 499345"/>
                  <a:gd name="connsiteY3" fmla="*/ 348288 h 348288"/>
                  <a:gd name="connsiteX0" fmla="*/ 0 w 499345"/>
                  <a:gd name="connsiteY0" fmla="*/ 0 h 348288"/>
                  <a:gd name="connsiteX1" fmla="*/ 150240 w 499345"/>
                  <a:gd name="connsiteY1" fmla="*/ 56456 h 348288"/>
                  <a:gd name="connsiteX2" fmla="*/ 343671 w 499345"/>
                  <a:gd name="connsiteY2" fmla="*/ 224597 h 348288"/>
                  <a:gd name="connsiteX3" fmla="*/ 499345 w 499345"/>
                  <a:gd name="connsiteY3" fmla="*/ 348288 h 348288"/>
                  <a:gd name="connsiteX0" fmla="*/ 0 w 428509"/>
                  <a:gd name="connsiteY0" fmla="*/ 0 h 332659"/>
                  <a:gd name="connsiteX1" fmla="*/ 150240 w 428509"/>
                  <a:gd name="connsiteY1" fmla="*/ 56456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3671 w 428509"/>
                  <a:gd name="connsiteY2" fmla="*/ 224597 h 332659"/>
                  <a:gd name="connsiteX3" fmla="*/ 428509 w 428509"/>
                  <a:gd name="connsiteY3" fmla="*/ 332659 h 332659"/>
                  <a:gd name="connsiteX0" fmla="*/ 0 w 428509"/>
                  <a:gd name="connsiteY0" fmla="*/ 0 h 332659"/>
                  <a:gd name="connsiteX1" fmla="*/ 145783 w 428509"/>
                  <a:gd name="connsiteY1" fmla="*/ 70843 h 332659"/>
                  <a:gd name="connsiteX2" fmla="*/ 349733 w 428509"/>
                  <a:gd name="connsiteY2" fmla="*/ 240663 h 332659"/>
                  <a:gd name="connsiteX3" fmla="*/ 428509 w 428509"/>
                  <a:gd name="connsiteY3" fmla="*/ 332659 h 332659"/>
                  <a:gd name="connsiteX0" fmla="*/ 0 w 410252"/>
                  <a:gd name="connsiteY0" fmla="*/ 0 h 325428"/>
                  <a:gd name="connsiteX1" fmla="*/ 145783 w 410252"/>
                  <a:gd name="connsiteY1" fmla="*/ 70843 h 325428"/>
                  <a:gd name="connsiteX2" fmla="*/ 349733 w 410252"/>
                  <a:gd name="connsiteY2" fmla="*/ 240663 h 325428"/>
                  <a:gd name="connsiteX3" fmla="*/ 410252 w 410252"/>
                  <a:gd name="connsiteY3" fmla="*/ 325428 h 325428"/>
                  <a:gd name="connsiteX0" fmla="*/ 0 w 899365"/>
                  <a:gd name="connsiteY0" fmla="*/ 17685 h 264215"/>
                  <a:gd name="connsiteX1" fmla="*/ 634896 w 899365"/>
                  <a:gd name="connsiteY1" fmla="*/ 9630 h 264215"/>
                  <a:gd name="connsiteX2" fmla="*/ 838846 w 899365"/>
                  <a:gd name="connsiteY2" fmla="*/ 179450 h 264215"/>
                  <a:gd name="connsiteX3" fmla="*/ 899365 w 899365"/>
                  <a:gd name="connsiteY3" fmla="*/ 264215 h 264215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838846 w 899365"/>
                  <a:gd name="connsiteY2" fmla="*/ 161765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705863 w 899365"/>
                  <a:gd name="connsiteY2" fmla="*/ 120337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408863 w 899365"/>
                  <a:gd name="connsiteY1" fmla="*/ 10359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899365"/>
                  <a:gd name="connsiteY0" fmla="*/ 0 h 246530"/>
                  <a:gd name="connsiteX1" fmla="*/ 164737 w 899365"/>
                  <a:gd name="connsiteY1" fmla="*/ 48455 h 246530"/>
                  <a:gd name="connsiteX2" fmla="*/ 671545 w 899365"/>
                  <a:gd name="connsiteY2" fmla="*/ 136709 h 246530"/>
                  <a:gd name="connsiteX3" fmla="*/ 899365 w 899365"/>
                  <a:gd name="connsiteY3" fmla="*/ 246530 h 246530"/>
                  <a:gd name="connsiteX0" fmla="*/ 0 w 1191533"/>
                  <a:gd name="connsiteY0" fmla="*/ 0 h 614340"/>
                  <a:gd name="connsiteX1" fmla="*/ 456905 w 1191533"/>
                  <a:gd name="connsiteY1" fmla="*/ 416265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963713 w 1191533"/>
                  <a:gd name="connsiteY2" fmla="*/ 504519 h 614340"/>
                  <a:gd name="connsiteX3" fmla="*/ 1191533 w 1191533"/>
                  <a:gd name="connsiteY3" fmla="*/ 614340 h 614340"/>
                  <a:gd name="connsiteX0" fmla="*/ 0 w 1191533"/>
                  <a:gd name="connsiteY0" fmla="*/ 0 h 614340"/>
                  <a:gd name="connsiteX1" fmla="*/ 340457 w 1191533"/>
                  <a:gd name="connsiteY1" fmla="*/ 389829 h 614340"/>
                  <a:gd name="connsiteX2" fmla="*/ 785181 w 1191533"/>
                  <a:gd name="connsiteY2" fmla="*/ 477195 h 614340"/>
                  <a:gd name="connsiteX3" fmla="*/ 1191533 w 1191533"/>
                  <a:gd name="connsiteY3" fmla="*/ 614340 h 614340"/>
                  <a:gd name="connsiteX0" fmla="*/ 0 w 1359842"/>
                  <a:gd name="connsiteY0" fmla="*/ 0 h 1178527"/>
                  <a:gd name="connsiteX1" fmla="*/ 508766 w 1359842"/>
                  <a:gd name="connsiteY1" fmla="*/ 954016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59842"/>
                  <a:gd name="connsiteY0" fmla="*/ 0 h 1178527"/>
                  <a:gd name="connsiteX1" fmla="*/ 453857 w 1359842"/>
                  <a:gd name="connsiteY1" fmla="*/ 896315 h 1178527"/>
                  <a:gd name="connsiteX2" fmla="*/ 953490 w 1359842"/>
                  <a:gd name="connsiteY2" fmla="*/ 1041382 h 1178527"/>
                  <a:gd name="connsiteX3" fmla="*/ 1359842 w 1359842"/>
                  <a:gd name="connsiteY3" fmla="*/ 1178527 h 1178527"/>
                  <a:gd name="connsiteX0" fmla="*/ 0 w 1397513"/>
                  <a:gd name="connsiteY0" fmla="*/ 0 h 1299748"/>
                  <a:gd name="connsiteX1" fmla="*/ 491528 w 1397513"/>
                  <a:gd name="connsiteY1" fmla="*/ 1017536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991161 w 1397513"/>
                  <a:gd name="connsiteY2" fmla="*/ 1162603 h 1299748"/>
                  <a:gd name="connsiteX3" fmla="*/ 1397513 w 1397513"/>
                  <a:gd name="connsiteY3" fmla="*/ 1299748 h 1299748"/>
                  <a:gd name="connsiteX0" fmla="*/ 0 w 1397513"/>
                  <a:gd name="connsiteY0" fmla="*/ 0 h 1299748"/>
                  <a:gd name="connsiteX1" fmla="*/ 508687 w 1397513"/>
                  <a:gd name="connsiteY1" fmla="*/ 1009350 h 1299748"/>
                  <a:gd name="connsiteX2" fmla="*/ 1397513 w 1397513"/>
                  <a:gd name="connsiteY2" fmla="*/ 1299748 h 1299748"/>
                  <a:gd name="connsiteX0" fmla="*/ 0 w 1397513"/>
                  <a:gd name="connsiteY0" fmla="*/ 0 h 1299748"/>
                  <a:gd name="connsiteX1" fmla="*/ 817159 w 1397513"/>
                  <a:gd name="connsiteY1" fmla="*/ 1138664 h 1299748"/>
                  <a:gd name="connsiteX2" fmla="*/ 1397513 w 1397513"/>
                  <a:gd name="connsiteY2" fmla="*/ 1299748 h 1299748"/>
                  <a:gd name="connsiteX0" fmla="*/ 25784 w 616127"/>
                  <a:gd name="connsiteY0" fmla="*/ 0 h 504551"/>
                  <a:gd name="connsiteX1" fmla="*/ 35773 w 616127"/>
                  <a:gd name="connsiteY1" fmla="*/ 343467 h 504551"/>
                  <a:gd name="connsiteX2" fmla="*/ 616127 w 616127"/>
                  <a:gd name="connsiteY2" fmla="*/ 504551 h 504551"/>
                  <a:gd name="connsiteX0" fmla="*/ 0 w 590343"/>
                  <a:gd name="connsiteY0" fmla="*/ 0 h 504551"/>
                  <a:gd name="connsiteX1" fmla="*/ 119963 w 590343"/>
                  <a:gd name="connsiteY1" fmla="*/ 348204 h 504551"/>
                  <a:gd name="connsiteX2" fmla="*/ 590343 w 590343"/>
                  <a:gd name="connsiteY2" fmla="*/ 504551 h 504551"/>
                  <a:gd name="connsiteX0" fmla="*/ 0 w 590343"/>
                  <a:gd name="connsiteY0" fmla="*/ 0 h 504551"/>
                  <a:gd name="connsiteX1" fmla="*/ 152487 w 590343"/>
                  <a:gd name="connsiteY1" fmla="*/ 346035 h 504551"/>
                  <a:gd name="connsiteX2" fmla="*/ 590343 w 590343"/>
                  <a:gd name="connsiteY2" fmla="*/ 504551 h 504551"/>
                  <a:gd name="connsiteX0" fmla="*/ 0 w 610388"/>
                  <a:gd name="connsiteY0" fmla="*/ 0 h 546471"/>
                  <a:gd name="connsiteX1" fmla="*/ 172532 w 610388"/>
                  <a:gd name="connsiteY1" fmla="*/ 387955 h 546471"/>
                  <a:gd name="connsiteX2" fmla="*/ 610388 w 610388"/>
                  <a:gd name="connsiteY2" fmla="*/ 546471 h 546471"/>
                  <a:gd name="connsiteX0" fmla="*/ 0 w 610388"/>
                  <a:gd name="connsiteY0" fmla="*/ 78865 h 625336"/>
                  <a:gd name="connsiteX1" fmla="*/ 276038 w 610388"/>
                  <a:gd name="connsiteY1" fmla="*/ 30370 h 625336"/>
                  <a:gd name="connsiteX2" fmla="*/ 610388 w 610388"/>
                  <a:gd name="connsiteY2" fmla="*/ 625336 h 625336"/>
                  <a:gd name="connsiteX0" fmla="*/ 0 w 627154"/>
                  <a:gd name="connsiteY0" fmla="*/ 0 h 814950"/>
                  <a:gd name="connsiteX1" fmla="*/ 292804 w 627154"/>
                  <a:gd name="connsiteY1" fmla="*/ 219984 h 814950"/>
                  <a:gd name="connsiteX2" fmla="*/ 627154 w 627154"/>
                  <a:gd name="connsiteY2" fmla="*/ 814950 h 814950"/>
                  <a:gd name="connsiteX0" fmla="*/ 0 w 627154"/>
                  <a:gd name="connsiteY0" fmla="*/ 0 h 814950"/>
                  <a:gd name="connsiteX1" fmla="*/ 272839 w 627154"/>
                  <a:gd name="connsiteY1" fmla="*/ 122731 h 814950"/>
                  <a:gd name="connsiteX2" fmla="*/ 627154 w 627154"/>
                  <a:gd name="connsiteY2" fmla="*/ 814950 h 814950"/>
                  <a:gd name="connsiteX0" fmla="*/ 0 w 424449"/>
                  <a:gd name="connsiteY0" fmla="*/ 0 h 322470"/>
                  <a:gd name="connsiteX1" fmla="*/ 272839 w 424449"/>
                  <a:gd name="connsiteY1" fmla="*/ 122731 h 322470"/>
                  <a:gd name="connsiteX2" fmla="*/ 424449 w 424449"/>
                  <a:gd name="connsiteY2" fmla="*/ 322470 h 322470"/>
                  <a:gd name="connsiteX0" fmla="*/ 183 w 424632"/>
                  <a:gd name="connsiteY0" fmla="*/ 0 h 322470"/>
                  <a:gd name="connsiteX1" fmla="*/ 26945 w 424632"/>
                  <a:gd name="connsiteY1" fmla="*/ 192460 h 322470"/>
                  <a:gd name="connsiteX2" fmla="*/ 424632 w 424632"/>
                  <a:gd name="connsiteY2" fmla="*/ 322470 h 322470"/>
                  <a:gd name="connsiteX0" fmla="*/ 183 w 26945"/>
                  <a:gd name="connsiteY0" fmla="*/ 0 h 192460"/>
                  <a:gd name="connsiteX1" fmla="*/ 26945 w 26945"/>
                  <a:gd name="connsiteY1" fmla="*/ 192460 h 192460"/>
                  <a:gd name="connsiteX0" fmla="*/ 0 w 239614"/>
                  <a:gd name="connsiteY0" fmla="*/ 0 h 203411"/>
                  <a:gd name="connsiteX1" fmla="*/ 239614 w 239614"/>
                  <a:gd name="connsiteY1" fmla="*/ 203411 h 203411"/>
                  <a:gd name="connsiteX0" fmla="*/ 0 w 72390"/>
                  <a:gd name="connsiteY0" fmla="*/ 0 h 123022"/>
                  <a:gd name="connsiteX1" fmla="*/ 72390 w 72390"/>
                  <a:gd name="connsiteY1" fmla="*/ 123022 h 1230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2390" h="123022">
                    <a:moveTo>
                      <a:pt x="0" y="0"/>
                    </a:moveTo>
                    <a:cubicBezTo>
                      <a:pt x="53181" y="3572"/>
                      <a:pt x="1649" y="69277"/>
                      <a:pt x="72390" y="123022"/>
                    </a:cubicBezTo>
                  </a:path>
                </a:pathLst>
              </a:custGeom>
              <a:noFill/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5" name="Freeform: Shape 24">
                <a:extLst>
                  <a:ext uri="{FF2B5EF4-FFF2-40B4-BE49-F238E27FC236}">
                    <a16:creationId xmlns:a16="http://schemas.microsoft.com/office/drawing/2014/main" id="{8AD3D0DD-3842-03C4-7540-263F12536689}"/>
                  </a:ext>
                </a:extLst>
              </p:cNvPr>
              <p:cNvSpPr/>
              <p:nvPr/>
            </p:nvSpPr>
            <p:spPr>
              <a:xfrm>
                <a:off x="1534828" y="1350608"/>
                <a:ext cx="209006" cy="766383"/>
              </a:xfrm>
              <a:custGeom>
                <a:avLst/>
                <a:gdLst>
                  <a:gd name="connsiteX0" fmla="*/ 0 w 1236617"/>
                  <a:gd name="connsiteY0" fmla="*/ 397629 h 397629"/>
                  <a:gd name="connsiteX1" fmla="*/ 714103 w 1236617"/>
                  <a:gd name="connsiteY1" fmla="*/ 40577 h 397629"/>
                  <a:gd name="connsiteX2" fmla="*/ 1236617 w 1236617"/>
                  <a:gd name="connsiteY2" fmla="*/ 23160 h 397629"/>
                  <a:gd name="connsiteX0" fmla="*/ 31371 w 1267988"/>
                  <a:gd name="connsiteY0" fmla="*/ 494497 h 494497"/>
                  <a:gd name="connsiteX1" fmla="*/ 57497 w 1267988"/>
                  <a:gd name="connsiteY1" fmla="*/ 15525 h 494497"/>
                  <a:gd name="connsiteX2" fmla="*/ 1267988 w 1267988"/>
                  <a:gd name="connsiteY2" fmla="*/ 120028 h 494497"/>
                  <a:gd name="connsiteX0" fmla="*/ 46794 w 133478"/>
                  <a:gd name="connsiteY0" fmla="*/ 733179 h 733179"/>
                  <a:gd name="connsiteX1" fmla="*/ 72920 w 133478"/>
                  <a:gd name="connsiteY1" fmla="*/ 254207 h 733179"/>
                  <a:gd name="connsiteX2" fmla="*/ 38085 w 133478"/>
                  <a:gd name="connsiteY2" fmla="*/ 1659 h 733179"/>
                  <a:gd name="connsiteX0" fmla="*/ 8709 w 8709"/>
                  <a:gd name="connsiteY0" fmla="*/ 731520 h 731520"/>
                  <a:gd name="connsiteX1" fmla="*/ 0 w 8709"/>
                  <a:gd name="connsiteY1" fmla="*/ 0 h 731520"/>
                  <a:gd name="connsiteX0" fmla="*/ 29999 w 29999"/>
                  <a:gd name="connsiteY0" fmla="*/ 9762 h 9762"/>
                  <a:gd name="connsiteX1" fmla="*/ 0 w 29999"/>
                  <a:gd name="connsiteY1" fmla="*/ 0 h 9762"/>
                  <a:gd name="connsiteX0" fmla="*/ 56666 w 56666"/>
                  <a:gd name="connsiteY0" fmla="*/ 10976 h 10976"/>
                  <a:gd name="connsiteX1" fmla="*/ 0 w 56666"/>
                  <a:gd name="connsiteY1" fmla="*/ 0 h 10976"/>
                  <a:gd name="connsiteX0" fmla="*/ 79999 w 79999"/>
                  <a:gd name="connsiteY0" fmla="*/ 10732 h 10732"/>
                  <a:gd name="connsiteX1" fmla="*/ 0 w 79999"/>
                  <a:gd name="connsiteY1" fmla="*/ 0 h 1073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9999" h="10732">
                    <a:moveTo>
                      <a:pt x="79999" y="10732"/>
                    </a:moveTo>
                    <a:cubicBezTo>
                      <a:pt x="79305" y="8598"/>
                      <a:pt x="695" y="2134"/>
                      <a:pt x="0" y="0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185921CC-E80F-23B2-E7CC-14F8A97ACAE1}"/>
                  </a:ext>
                </a:extLst>
              </p:cNvPr>
              <p:cNvSpPr txBox="1"/>
              <p:nvPr/>
            </p:nvSpPr>
            <p:spPr>
              <a:xfrm>
                <a:off x="3992308" y="1907335"/>
                <a:ext cx="5074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i="1" dirty="0">
                    <a:solidFill>
                      <a:srgbClr val="0070C0"/>
                    </a:solidFill>
                  </a:rPr>
                  <a:t>MRN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C73EAB52-6FBB-D6D7-6FC4-00298BD42674}"/>
                  </a:ext>
                </a:extLst>
              </p:cNvPr>
              <p:cNvSpPr txBox="1"/>
              <p:nvPr/>
            </p:nvSpPr>
            <p:spPr>
              <a:xfrm>
                <a:off x="4097395" y="1609532"/>
                <a:ext cx="52696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i="1" dirty="0">
                    <a:solidFill>
                      <a:srgbClr val="FF0000"/>
                    </a:solidFill>
                  </a:rPr>
                  <a:t>DRN</a:t>
                </a:r>
              </a:p>
            </p:txBody>
          </p:sp>
          <p:sp>
            <p:nvSpPr>
              <p:cNvPr id="52" name="Freeform: Shape 51">
                <a:extLst>
                  <a:ext uri="{FF2B5EF4-FFF2-40B4-BE49-F238E27FC236}">
                    <a16:creationId xmlns:a16="http://schemas.microsoft.com/office/drawing/2014/main" id="{770A4B87-891A-1068-D748-18B21692D533}"/>
                  </a:ext>
                </a:extLst>
              </p:cNvPr>
              <p:cNvSpPr/>
              <p:nvPr/>
            </p:nvSpPr>
            <p:spPr>
              <a:xfrm>
                <a:off x="1732925" y="1316877"/>
                <a:ext cx="365760" cy="949234"/>
              </a:xfrm>
              <a:custGeom>
                <a:avLst/>
                <a:gdLst>
                  <a:gd name="connsiteX0" fmla="*/ 0 w 1236617"/>
                  <a:gd name="connsiteY0" fmla="*/ 397629 h 397629"/>
                  <a:gd name="connsiteX1" fmla="*/ 714103 w 1236617"/>
                  <a:gd name="connsiteY1" fmla="*/ 40577 h 397629"/>
                  <a:gd name="connsiteX2" fmla="*/ 1236617 w 1236617"/>
                  <a:gd name="connsiteY2" fmla="*/ 23160 h 397629"/>
                  <a:gd name="connsiteX0" fmla="*/ 0 w 1297577"/>
                  <a:gd name="connsiteY0" fmla="*/ 441172 h 441172"/>
                  <a:gd name="connsiteX1" fmla="*/ 775063 w 1297577"/>
                  <a:gd name="connsiteY1" fmla="*/ 40577 h 441172"/>
                  <a:gd name="connsiteX2" fmla="*/ 1297577 w 1297577"/>
                  <a:gd name="connsiteY2" fmla="*/ 23160 h 441172"/>
                  <a:gd name="connsiteX0" fmla="*/ 377437 w 1171929"/>
                  <a:gd name="connsiteY0" fmla="*/ 949958 h 949958"/>
                  <a:gd name="connsiteX1" fmla="*/ 1152500 w 1171929"/>
                  <a:gd name="connsiteY1" fmla="*/ 549363 h 949958"/>
                  <a:gd name="connsiteX2" fmla="*/ 11677 w 1171929"/>
                  <a:gd name="connsiteY2" fmla="*/ 724 h 949958"/>
                  <a:gd name="connsiteX0" fmla="*/ 393386 w 456527"/>
                  <a:gd name="connsiteY0" fmla="*/ 950157 h 950157"/>
                  <a:gd name="connsiteX1" fmla="*/ 245340 w 456527"/>
                  <a:gd name="connsiteY1" fmla="*/ 436351 h 950157"/>
                  <a:gd name="connsiteX2" fmla="*/ 27626 w 456527"/>
                  <a:gd name="connsiteY2" fmla="*/ 923 h 950157"/>
                  <a:gd name="connsiteX0" fmla="*/ 365760 w 365760"/>
                  <a:gd name="connsiteY0" fmla="*/ 949234 h 949234"/>
                  <a:gd name="connsiteX1" fmla="*/ 0 w 365760"/>
                  <a:gd name="connsiteY1" fmla="*/ 0 h 9492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65760" h="949234">
                    <a:moveTo>
                      <a:pt x="365760" y="949234"/>
                    </a:moveTo>
                    <a:lnTo>
                      <a:pt x="0" y="0"/>
                    </a:lnTo>
                  </a:path>
                </a:pathLst>
              </a:custGeom>
              <a:noFill/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Freeform: Shape 52">
                <a:extLst>
                  <a:ext uri="{FF2B5EF4-FFF2-40B4-BE49-F238E27FC236}">
                    <a16:creationId xmlns:a16="http://schemas.microsoft.com/office/drawing/2014/main" id="{5DB67699-DC89-FF57-8039-FD83B623E8CC}"/>
                  </a:ext>
                </a:extLst>
              </p:cNvPr>
              <p:cNvSpPr/>
              <p:nvPr/>
            </p:nvSpPr>
            <p:spPr>
              <a:xfrm>
                <a:off x="2798071" y="1722619"/>
                <a:ext cx="62995" cy="600890"/>
              </a:xfrm>
              <a:custGeom>
                <a:avLst/>
                <a:gdLst>
                  <a:gd name="connsiteX0" fmla="*/ 0 w 1236617"/>
                  <a:gd name="connsiteY0" fmla="*/ 397629 h 397629"/>
                  <a:gd name="connsiteX1" fmla="*/ 714103 w 1236617"/>
                  <a:gd name="connsiteY1" fmla="*/ 40577 h 397629"/>
                  <a:gd name="connsiteX2" fmla="*/ 1236617 w 1236617"/>
                  <a:gd name="connsiteY2" fmla="*/ 23160 h 397629"/>
                  <a:gd name="connsiteX0" fmla="*/ 0 w 1297577"/>
                  <a:gd name="connsiteY0" fmla="*/ 441172 h 441172"/>
                  <a:gd name="connsiteX1" fmla="*/ 775063 w 1297577"/>
                  <a:gd name="connsiteY1" fmla="*/ 40577 h 441172"/>
                  <a:gd name="connsiteX2" fmla="*/ 1297577 w 1297577"/>
                  <a:gd name="connsiteY2" fmla="*/ 23160 h 441172"/>
                  <a:gd name="connsiteX0" fmla="*/ 377437 w 1171929"/>
                  <a:gd name="connsiteY0" fmla="*/ 949958 h 949958"/>
                  <a:gd name="connsiteX1" fmla="*/ 1152500 w 1171929"/>
                  <a:gd name="connsiteY1" fmla="*/ 549363 h 949958"/>
                  <a:gd name="connsiteX2" fmla="*/ 11677 w 1171929"/>
                  <a:gd name="connsiteY2" fmla="*/ 724 h 949958"/>
                  <a:gd name="connsiteX0" fmla="*/ 393386 w 456527"/>
                  <a:gd name="connsiteY0" fmla="*/ 950157 h 950157"/>
                  <a:gd name="connsiteX1" fmla="*/ 245340 w 456527"/>
                  <a:gd name="connsiteY1" fmla="*/ 436351 h 950157"/>
                  <a:gd name="connsiteX2" fmla="*/ 27626 w 456527"/>
                  <a:gd name="connsiteY2" fmla="*/ 923 h 950157"/>
                  <a:gd name="connsiteX0" fmla="*/ 365760 w 365760"/>
                  <a:gd name="connsiteY0" fmla="*/ 949234 h 949234"/>
                  <a:gd name="connsiteX1" fmla="*/ 0 w 365760"/>
                  <a:gd name="connsiteY1" fmla="*/ 0 h 949234"/>
                  <a:gd name="connsiteX0" fmla="*/ 174172 w 174172"/>
                  <a:gd name="connsiteY0" fmla="*/ 653142 h 653142"/>
                  <a:gd name="connsiteX1" fmla="*/ 0 w 174172"/>
                  <a:gd name="connsiteY1" fmla="*/ 0 h 653142"/>
                  <a:gd name="connsiteX0" fmla="*/ 34835 w 34835"/>
                  <a:gd name="connsiteY0" fmla="*/ 496387 h 496387"/>
                  <a:gd name="connsiteX1" fmla="*/ 0 w 34835"/>
                  <a:gd name="connsiteY1" fmla="*/ 0 h 496387"/>
                  <a:gd name="connsiteX0" fmla="*/ 26126 w 26126"/>
                  <a:gd name="connsiteY0" fmla="*/ 522513 h 522513"/>
                  <a:gd name="connsiteX1" fmla="*/ 0 w 26126"/>
                  <a:gd name="connsiteY1" fmla="*/ 0 h 522513"/>
                  <a:gd name="connsiteX0" fmla="*/ 26126 w 26302"/>
                  <a:gd name="connsiteY0" fmla="*/ 522513 h 522513"/>
                  <a:gd name="connsiteX1" fmla="*/ 26302 w 26302"/>
                  <a:gd name="connsiteY1" fmla="*/ 305552 h 522513"/>
                  <a:gd name="connsiteX2" fmla="*/ 0 w 26302"/>
                  <a:gd name="connsiteY2" fmla="*/ 0 h 522513"/>
                  <a:gd name="connsiteX0" fmla="*/ 26126 w 26126"/>
                  <a:gd name="connsiteY0" fmla="*/ 522513 h 522513"/>
                  <a:gd name="connsiteX1" fmla="*/ 17594 w 26126"/>
                  <a:gd name="connsiteY1" fmla="*/ 227175 h 522513"/>
                  <a:gd name="connsiteX2" fmla="*/ 0 w 26126"/>
                  <a:gd name="connsiteY2" fmla="*/ 0 h 522513"/>
                  <a:gd name="connsiteX0" fmla="*/ 9317 w 53615"/>
                  <a:gd name="connsiteY0" fmla="*/ 548639 h 548639"/>
                  <a:gd name="connsiteX1" fmla="*/ 785 w 53615"/>
                  <a:gd name="connsiteY1" fmla="*/ 253301 h 548639"/>
                  <a:gd name="connsiteX2" fmla="*/ 52860 w 53615"/>
                  <a:gd name="connsiteY2" fmla="*/ 0 h 548639"/>
                  <a:gd name="connsiteX0" fmla="*/ 26586 w 70742"/>
                  <a:gd name="connsiteY0" fmla="*/ 548639 h 548639"/>
                  <a:gd name="connsiteX1" fmla="*/ 637 w 70742"/>
                  <a:gd name="connsiteY1" fmla="*/ 166216 h 548639"/>
                  <a:gd name="connsiteX2" fmla="*/ 70129 w 70742"/>
                  <a:gd name="connsiteY2" fmla="*/ 0 h 548639"/>
                  <a:gd name="connsiteX0" fmla="*/ 26652 w 62163"/>
                  <a:gd name="connsiteY0" fmla="*/ 600890 h 600890"/>
                  <a:gd name="connsiteX1" fmla="*/ 703 w 62163"/>
                  <a:gd name="connsiteY1" fmla="*/ 218467 h 600890"/>
                  <a:gd name="connsiteX2" fmla="*/ 61487 w 62163"/>
                  <a:gd name="connsiteY2" fmla="*/ 0 h 600890"/>
                  <a:gd name="connsiteX0" fmla="*/ 28160 w 62995"/>
                  <a:gd name="connsiteY0" fmla="*/ 600890 h 600890"/>
                  <a:gd name="connsiteX1" fmla="*/ 2211 w 62995"/>
                  <a:gd name="connsiteY1" fmla="*/ 218467 h 600890"/>
                  <a:gd name="connsiteX2" fmla="*/ 62995 w 62995"/>
                  <a:gd name="connsiteY2" fmla="*/ 0 h 6008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2995" h="600890">
                    <a:moveTo>
                      <a:pt x="28160" y="600890"/>
                    </a:moveTo>
                    <a:cubicBezTo>
                      <a:pt x="28219" y="528570"/>
                      <a:pt x="2152" y="290787"/>
                      <a:pt x="2211" y="218467"/>
                    </a:cubicBezTo>
                    <a:cubicBezTo>
                      <a:pt x="-6674" y="261257"/>
                      <a:pt x="10744" y="165463"/>
                      <a:pt x="62995" y="0"/>
                    </a:cubicBezTo>
                  </a:path>
                </a:pathLst>
              </a:custGeom>
              <a:noFill/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Freeform: Shape 53">
                <a:extLst>
                  <a:ext uri="{FF2B5EF4-FFF2-40B4-BE49-F238E27FC236}">
                    <a16:creationId xmlns:a16="http://schemas.microsoft.com/office/drawing/2014/main" id="{8EA20D57-071B-204C-22D6-4E8A701495E4}"/>
                  </a:ext>
                </a:extLst>
              </p:cNvPr>
              <p:cNvSpPr/>
              <p:nvPr/>
            </p:nvSpPr>
            <p:spPr>
              <a:xfrm>
                <a:off x="2266143" y="1695782"/>
                <a:ext cx="82322" cy="690425"/>
              </a:xfrm>
              <a:custGeom>
                <a:avLst/>
                <a:gdLst>
                  <a:gd name="connsiteX0" fmla="*/ 0 w 1236617"/>
                  <a:gd name="connsiteY0" fmla="*/ 397629 h 397629"/>
                  <a:gd name="connsiteX1" fmla="*/ 714103 w 1236617"/>
                  <a:gd name="connsiteY1" fmla="*/ 40577 h 397629"/>
                  <a:gd name="connsiteX2" fmla="*/ 1236617 w 1236617"/>
                  <a:gd name="connsiteY2" fmla="*/ 23160 h 397629"/>
                  <a:gd name="connsiteX0" fmla="*/ 0 w 1297577"/>
                  <a:gd name="connsiteY0" fmla="*/ 441172 h 441172"/>
                  <a:gd name="connsiteX1" fmla="*/ 775063 w 1297577"/>
                  <a:gd name="connsiteY1" fmla="*/ 40577 h 441172"/>
                  <a:gd name="connsiteX2" fmla="*/ 1297577 w 1297577"/>
                  <a:gd name="connsiteY2" fmla="*/ 23160 h 441172"/>
                  <a:gd name="connsiteX0" fmla="*/ 377437 w 1171929"/>
                  <a:gd name="connsiteY0" fmla="*/ 949958 h 949958"/>
                  <a:gd name="connsiteX1" fmla="*/ 1152500 w 1171929"/>
                  <a:gd name="connsiteY1" fmla="*/ 549363 h 949958"/>
                  <a:gd name="connsiteX2" fmla="*/ 11677 w 1171929"/>
                  <a:gd name="connsiteY2" fmla="*/ 724 h 949958"/>
                  <a:gd name="connsiteX0" fmla="*/ 393386 w 456527"/>
                  <a:gd name="connsiteY0" fmla="*/ 950157 h 950157"/>
                  <a:gd name="connsiteX1" fmla="*/ 245340 w 456527"/>
                  <a:gd name="connsiteY1" fmla="*/ 436351 h 950157"/>
                  <a:gd name="connsiteX2" fmla="*/ 27626 w 456527"/>
                  <a:gd name="connsiteY2" fmla="*/ 923 h 950157"/>
                  <a:gd name="connsiteX0" fmla="*/ 365760 w 365760"/>
                  <a:gd name="connsiteY0" fmla="*/ 949234 h 949234"/>
                  <a:gd name="connsiteX1" fmla="*/ 0 w 365760"/>
                  <a:gd name="connsiteY1" fmla="*/ 0 h 949234"/>
                  <a:gd name="connsiteX0" fmla="*/ 174172 w 174172"/>
                  <a:gd name="connsiteY0" fmla="*/ 653142 h 653142"/>
                  <a:gd name="connsiteX1" fmla="*/ 0 w 174172"/>
                  <a:gd name="connsiteY1" fmla="*/ 0 h 653142"/>
                  <a:gd name="connsiteX0" fmla="*/ 34835 w 34835"/>
                  <a:gd name="connsiteY0" fmla="*/ 496387 h 496387"/>
                  <a:gd name="connsiteX1" fmla="*/ 0 w 34835"/>
                  <a:gd name="connsiteY1" fmla="*/ 0 h 496387"/>
                  <a:gd name="connsiteX0" fmla="*/ 26126 w 26126"/>
                  <a:gd name="connsiteY0" fmla="*/ 522513 h 522513"/>
                  <a:gd name="connsiteX1" fmla="*/ 0 w 26126"/>
                  <a:gd name="connsiteY1" fmla="*/ 0 h 522513"/>
                  <a:gd name="connsiteX0" fmla="*/ 26126 w 26302"/>
                  <a:gd name="connsiteY0" fmla="*/ 522513 h 522513"/>
                  <a:gd name="connsiteX1" fmla="*/ 26302 w 26302"/>
                  <a:gd name="connsiteY1" fmla="*/ 305552 h 522513"/>
                  <a:gd name="connsiteX2" fmla="*/ 0 w 26302"/>
                  <a:gd name="connsiteY2" fmla="*/ 0 h 522513"/>
                  <a:gd name="connsiteX0" fmla="*/ 26126 w 26126"/>
                  <a:gd name="connsiteY0" fmla="*/ 522513 h 522513"/>
                  <a:gd name="connsiteX1" fmla="*/ 17594 w 26126"/>
                  <a:gd name="connsiteY1" fmla="*/ 227175 h 522513"/>
                  <a:gd name="connsiteX2" fmla="*/ 0 w 26126"/>
                  <a:gd name="connsiteY2" fmla="*/ 0 h 522513"/>
                  <a:gd name="connsiteX0" fmla="*/ 9317 w 53615"/>
                  <a:gd name="connsiteY0" fmla="*/ 548639 h 548639"/>
                  <a:gd name="connsiteX1" fmla="*/ 785 w 53615"/>
                  <a:gd name="connsiteY1" fmla="*/ 253301 h 548639"/>
                  <a:gd name="connsiteX2" fmla="*/ 52860 w 53615"/>
                  <a:gd name="connsiteY2" fmla="*/ 0 h 548639"/>
                  <a:gd name="connsiteX0" fmla="*/ 26586 w 70742"/>
                  <a:gd name="connsiteY0" fmla="*/ 548639 h 548639"/>
                  <a:gd name="connsiteX1" fmla="*/ 637 w 70742"/>
                  <a:gd name="connsiteY1" fmla="*/ 166216 h 548639"/>
                  <a:gd name="connsiteX2" fmla="*/ 70129 w 70742"/>
                  <a:gd name="connsiteY2" fmla="*/ 0 h 548639"/>
                  <a:gd name="connsiteX0" fmla="*/ 26652 w 62163"/>
                  <a:gd name="connsiteY0" fmla="*/ 600890 h 600890"/>
                  <a:gd name="connsiteX1" fmla="*/ 703 w 62163"/>
                  <a:gd name="connsiteY1" fmla="*/ 218467 h 600890"/>
                  <a:gd name="connsiteX2" fmla="*/ 61487 w 62163"/>
                  <a:gd name="connsiteY2" fmla="*/ 0 h 600890"/>
                  <a:gd name="connsiteX0" fmla="*/ 28160 w 62995"/>
                  <a:gd name="connsiteY0" fmla="*/ 600890 h 600890"/>
                  <a:gd name="connsiteX1" fmla="*/ 2211 w 62995"/>
                  <a:gd name="connsiteY1" fmla="*/ 218467 h 600890"/>
                  <a:gd name="connsiteX2" fmla="*/ 62995 w 62995"/>
                  <a:gd name="connsiteY2" fmla="*/ 0 h 600890"/>
                  <a:gd name="connsiteX0" fmla="*/ 53232 w 88067"/>
                  <a:gd name="connsiteY0" fmla="*/ 600890 h 600890"/>
                  <a:gd name="connsiteX1" fmla="*/ 1157 w 88067"/>
                  <a:gd name="connsiteY1" fmla="*/ 209758 h 600890"/>
                  <a:gd name="connsiteX2" fmla="*/ 88067 w 88067"/>
                  <a:gd name="connsiteY2" fmla="*/ 0 h 600890"/>
                  <a:gd name="connsiteX0" fmla="*/ 104910 w 104910"/>
                  <a:gd name="connsiteY0" fmla="*/ 661850 h 661850"/>
                  <a:gd name="connsiteX1" fmla="*/ 52835 w 104910"/>
                  <a:gd name="connsiteY1" fmla="*/ 270718 h 661850"/>
                  <a:gd name="connsiteX2" fmla="*/ 17825 w 104910"/>
                  <a:gd name="connsiteY2" fmla="*/ 0 h 661850"/>
                  <a:gd name="connsiteX0" fmla="*/ 112358 w 112358"/>
                  <a:gd name="connsiteY0" fmla="*/ 661850 h 661850"/>
                  <a:gd name="connsiteX1" fmla="*/ 25448 w 112358"/>
                  <a:gd name="connsiteY1" fmla="*/ 296843 h 661850"/>
                  <a:gd name="connsiteX2" fmla="*/ 25273 w 112358"/>
                  <a:gd name="connsiteY2" fmla="*/ 0 h 661850"/>
                  <a:gd name="connsiteX0" fmla="*/ 112358 w 112358"/>
                  <a:gd name="connsiteY0" fmla="*/ 661850 h 661850"/>
                  <a:gd name="connsiteX1" fmla="*/ 25448 w 112358"/>
                  <a:gd name="connsiteY1" fmla="*/ 322969 h 661850"/>
                  <a:gd name="connsiteX2" fmla="*/ 25273 w 112358"/>
                  <a:gd name="connsiteY2" fmla="*/ 0 h 661850"/>
                  <a:gd name="connsiteX0" fmla="*/ 112358 w 112358"/>
                  <a:gd name="connsiteY0" fmla="*/ 661850 h 661850"/>
                  <a:gd name="connsiteX1" fmla="*/ 25448 w 112358"/>
                  <a:gd name="connsiteY1" fmla="*/ 322969 h 661850"/>
                  <a:gd name="connsiteX2" fmla="*/ 25273 w 112358"/>
                  <a:gd name="connsiteY2" fmla="*/ 0 h 661850"/>
                  <a:gd name="connsiteX0" fmla="*/ 111011 w 111011"/>
                  <a:gd name="connsiteY0" fmla="*/ 661850 h 661850"/>
                  <a:gd name="connsiteX1" fmla="*/ 28863 w 111011"/>
                  <a:gd name="connsiteY1" fmla="*/ 342019 h 661850"/>
                  <a:gd name="connsiteX2" fmla="*/ 23926 w 111011"/>
                  <a:gd name="connsiteY2" fmla="*/ 0 h 661850"/>
                  <a:gd name="connsiteX0" fmla="*/ 111011 w 111011"/>
                  <a:gd name="connsiteY0" fmla="*/ 661850 h 661850"/>
                  <a:gd name="connsiteX1" fmla="*/ 28863 w 111011"/>
                  <a:gd name="connsiteY1" fmla="*/ 342019 h 661850"/>
                  <a:gd name="connsiteX2" fmla="*/ 23926 w 111011"/>
                  <a:gd name="connsiteY2" fmla="*/ 0 h 661850"/>
                  <a:gd name="connsiteX0" fmla="*/ 106248 w 106248"/>
                  <a:gd name="connsiteY0" fmla="*/ 690425 h 690425"/>
                  <a:gd name="connsiteX1" fmla="*/ 28863 w 106248"/>
                  <a:gd name="connsiteY1" fmla="*/ 342019 h 690425"/>
                  <a:gd name="connsiteX2" fmla="*/ 23926 w 106248"/>
                  <a:gd name="connsiteY2" fmla="*/ 0 h 690425"/>
                  <a:gd name="connsiteX0" fmla="*/ 82322 w 82322"/>
                  <a:gd name="connsiteY0" fmla="*/ 690425 h 690425"/>
                  <a:gd name="connsiteX1" fmla="*/ 0 w 82322"/>
                  <a:gd name="connsiteY1" fmla="*/ 0 h 690425"/>
                  <a:gd name="connsiteX0" fmla="*/ 82322 w 82322"/>
                  <a:gd name="connsiteY0" fmla="*/ 690425 h 690425"/>
                  <a:gd name="connsiteX1" fmla="*/ 48582 w 82322"/>
                  <a:gd name="connsiteY1" fmla="*/ 409186 h 690425"/>
                  <a:gd name="connsiteX2" fmla="*/ 0 w 82322"/>
                  <a:gd name="connsiteY2" fmla="*/ 0 h 6904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82322" h="690425">
                    <a:moveTo>
                      <a:pt x="82322" y="690425"/>
                    </a:moveTo>
                    <a:lnTo>
                      <a:pt x="48582" y="409186"/>
                    </a:lnTo>
                    <a:cubicBezTo>
                      <a:pt x="54881" y="460283"/>
                      <a:pt x="27441" y="230142"/>
                      <a:pt x="0" y="0"/>
                    </a:cubicBezTo>
                  </a:path>
                </a:pathLst>
              </a:custGeom>
              <a:noFill/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57D78B2B-2023-CCC2-3088-E171387AF7B2}"/>
                  </a:ext>
                </a:extLst>
              </p:cNvPr>
              <p:cNvCxnSpPr/>
              <p:nvPr/>
            </p:nvCxnSpPr>
            <p:spPr>
              <a:xfrm>
                <a:off x="3097631" y="813510"/>
                <a:ext cx="180343" cy="7200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62697A31-96E0-46D1-19E1-5F36E6FED36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531721" y="763944"/>
                <a:ext cx="192248" cy="11730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833E2C9B-0554-3CDC-98DF-938615224092}"/>
                  </a:ext>
                </a:extLst>
              </p:cNvPr>
              <p:cNvCxnSpPr/>
              <p:nvPr/>
            </p:nvCxnSpPr>
            <p:spPr>
              <a:xfrm>
                <a:off x="2183591" y="964941"/>
                <a:ext cx="180343" cy="7200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F8856341-AF9B-A66F-9292-592EB3E0641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81358" y="1619330"/>
                <a:ext cx="83433" cy="13701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25D401B5-E108-3F3B-09CF-92E706C8FC58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3306815" y="1162286"/>
                <a:ext cx="87564" cy="8203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id="{5C751125-4AC4-7589-34D8-D4AAF404F40E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454519" y="1406799"/>
                <a:ext cx="105952" cy="9926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id="{E91DA962-FF20-0840-1144-9469BB38A37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081939" y="1645805"/>
                <a:ext cx="155723" cy="9072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36D15678-FCAD-2D9E-DDBE-7C132A67689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230526" y="1545686"/>
                <a:ext cx="83433" cy="13701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1176E748-4AB8-C248-D887-9F045C8B105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131354" y="1058216"/>
                <a:ext cx="43740" cy="10407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>
                <a:extLst>
                  <a:ext uri="{FF2B5EF4-FFF2-40B4-BE49-F238E27FC236}">
                    <a16:creationId xmlns:a16="http://schemas.microsoft.com/office/drawing/2014/main" id="{26C3F5A6-E3E7-53FA-7D25-2ECFAB3A0A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929324" y="1942582"/>
                <a:ext cx="39647" cy="139699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>
                <a:extLst>
                  <a:ext uri="{FF2B5EF4-FFF2-40B4-BE49-F238E27FC236}">
                    <a16:creationId xmlns:a16="http://schemas.microsoft.com/office/drawing/2014/main" id="{B6F6A734-F70F-CF3C-D59E-586EE55124A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97898" y="1309413"/>
                <a:ext cx="6626" cy="169383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E57000DD-E569-1B69-A97A-EFB14D74748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101940" y="1261376"/>
                <a:ext cx="115720" cy="50973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7A93C392-CA0F-AF44-C68A-8B80C48B88D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835541" y="1784097"/>
                <a:ext cx="91880" cy="35882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id="{43B6B52A-669D-F54F-2412-631FBCB2C11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763257" y="2326239"/>
                <a:ext cx="15502" cy="89477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id="{C83D8E3C-C936-BFD8-B374-32CF75AF25D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836525" y="2162008"/>
                <a:ext cx="43740" cy="10407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67A1E144-5B1F-C238-0F99-101DF8083C5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521940" y="2482448"/>
                <a:ext cx="43740" cy="104070"/>
              </a:xfrm>
              <a:prstGeom prst="line">
                <a:avLst/>
              </a:prstGeom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>
                <a:extLst>
                  <a:ext uri="{FF2B5EF4-FFF2-40B4-BE49-F238E27FC236}">
                    <a16:creationId xmlns:a16="http://schemas.microsoft.com/office/drawing/2014/main" id="{952A2F49-EAFE-0FE9-D510-DE6E00626E1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279083" y="1714372"/>
                <a:ext cx="48511" cy="87511"/>
              </a:xfrm>
              <a:prstGeom prst="line">
                <a:avLst/>
              </a:prstGeom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EB8947B9-404D-F070-7788-FB595726327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73794" y="1361525"/>
                <a:ext cx="48511" cy="87511"/>
              </a:xfrm>
              <a:prstGeom prst="line">
                <a:avLst/>
              </a:prstGeom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8362EB7B-7945-AF21-DFE2-3E6D9C5C240F}"/>
                  </a:ext>
                </a:extLst>
              </p:cNvPr>
              <p:cNvCxnSpPr/>
              <p:nvPr/>
            </p:nvCxnSpPr>
            <p:spPr>
              <a:xfrm flipV="1">
                <a:off x="4137252" y="647436"/>
                <a:ext cx="0" cy="2286000"/>
              </a:xfrm>
              <a:prstGeom prst="line">
                <a:avLst/>
              </a:prstGeom>
              <a:ln w="1270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E9D7E413-7D75-D72C-EABE-3B31ED14F697}"/>
                  </a:ext>
                </a:extLst>
              </p:cNvPr>
              <p:cNvCxnSpPr/>
              <p:nvPr/>
            </p:nvCxnSpPr>
            <p:spPr>
              <a:xfrm flipV="1">
                <a:off x="4403106" y="638987"/>
                <a:ext cx="0" cy="2286000"/>
              </a:xfrm>
              <a:prstGeom prst="line">
                <a:avLst/>
              </a:prstGeom>
              <a:ln w="1270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085D01A1-5ED6-A629-77B6-FD5A452CDFA7}"/>
                  </a:ext>
                </a:extLst>
              </p:cNvPr>
              <p:cNvCxnSpPr/>
              <p:nvPr/>
            </p:nvCxnSpPr>
            <p:spPr>
              <a:xfrm flipV="1">
                <a:off x="4658813" y="643895"/>
                <a:ext cx="0" cy="2286000"/>
              </a:xfrm>
              <a:prstGeom prst="line">
                <a:avLst/>
              </a:prstGeom>
              <a:ln w="1270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4" name="テキスト ボックス 315">
                <a:extLst>
                  <a:ext uri="{FF2B5EF4-FFF2-40B4-BE49-F238E27FC236}">
                    <a16:creationId xmlns:a16="http://schemas.microsoft.com/office/drawing/2014/main" id="{88710A91-BF59-44DE-0B60-4D343B52A10E}"/>
                  </a:ext>
                </a:extLst>
              </p:cNvPr>
              <p:cNvSpPr txBox="1"/>
              <p:nvPr/>
            </p:nvSpPr>
            <p:spPr>
              <a:xfrm>
                <a:off x="3993532" y="432277"/>
                <a:ext cx="281444" cy="2565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67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ja-JP" altLang="en-US" sz="1067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テキスト ボックス 315">
                <a:extLst>
                  <a:ext uri="{FF2B5EF4-FFF2-40B4-BE49-F238E27FC236}">
                    <a16:creationId xmlns:a16="http://schemas.microsoft.com/office/drawing/2014/main" id="{AC16D745-526C-D4F1-0AAE-F9418E314DEF}"/>
                  </a:ext>
                </a:extLst>
              </p:cNvPr>
              <p:cNvSpPr txBox="1"/>
              <p:nvPr/>
            </p:nvSpPr>
            <p:spPr>
              <a:xfrm>
                <a:off x="4261321" y="431125"/>
                <a:ext cx="281444" cy="2565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67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ja-JP" altLang="en-US" sz="1067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テキスト ボックス 315">
                <a:extLst>
                  <a:ext uri="{FF2B5EF4-FFF2-40B4-BE49-F238E27FC236}">
                    <a16:creationId xmlns:a16="http://schemas.microsoft.com/office/drawing/2014/main" id="{F4E833C9-7841-8B30-3A11-B9EA998F0CB7}"/>
                  </a:ext>
                </a:extLst>
              </p:cNvPr>
              <p:cNvSpPr txBox="1"/>
              <p:nvPr/>
            </p:nvSpPr>
            <p:spPr>
              <a:xfrm>
                <a:off x="4525929" y="432277"/>
                <a:ext cx="281444" cy="2565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67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ja-JP" altLang="en-US" sz="1067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Freeform: Shape 25">
              <a:extLst>
                <a:ext uri="{FF2B5EF4-FFF2-40B4-BE49-F238E27FC236}">
                  <a16:creationId xmlns:a16="http://schemas.microsoft.com/office/drawing/2014/main" id="{5E0438AB-AB10-76FD-A198-8B762BC98934}"/>
                </a:ext>
              </a:extLst>
            </p:cNvPr>
            <p:cNvSpPr/>
            <p:nvPr/>
          </p:nvSpPr>
          <p:spPr>
            <a:xfrm rot="19461561">
              <a:off x="1128403" y="1135856"/>
              <a:ext cx="2646047" cy="1810756"/>
            </a:xfrm>
            <a:custGeom>
              <a:avLst/>
              <a:gdLst>
                <a:gd name="connsiteX0" fmla="*/ 0 w 438150"/>
                <a:gd name="connsiteY0" fmla="*/ 0 h 204788"/>
                <a:gd name="connsiteX1" fmla="*/ 161925 w 438150"/>
                <a:gd name="connsiteY1" fmla="*/ 23813 h 204788"/>
                <a:gd name="connsiteX2" fmla="*/ 333375 w 438150"/>
                <a:gd name="connsiteY2" fmla="*/ 100013 h 204788"/>
                <a:gd name="connsiteX3" fmla="*/ 438150 w 438150"/>
                <a:gd name="connsiteY3" fmla="*/ 204788 h 204788"/>
                <a:gd name="connsiteX0" fmla="*/ 0 w 681987"/>
                <a:gd name="connsiteY0" fmla="*/ 0 h 379619"/>
                <a:gd name="connsiteX1" fmla="*/ 161925 w 681987"/>
                <a:gd name="connsiteY1" fmla="*/ 23813 h 379619"/>
                <a:gd name="connsiteX2" fmla="*/ 333375 w 681987"/>
                <a:gd name="connsiteY2" fmla="*/ 100013 h 379619"/>
                <a:gd name="connsiteX3" fmla="*/ 681987 w 681987"/>
                <a:gd name="connsiteY3" fmla="*/ 379619 h 379619"/>
                <a:gd name="connsiteX0" fmla="*/ 0 w 681987"/>
                <a:gd name="connsiteY0" fmla="*/ 0 h 379619"/>
                <a:gd name="connsiteX1" fmla="*/ 150825 w 681987"/>
                <a:gd name="connsiteY1" fmla="*/ 39295 h 379619"/>
                <a:gd name="connsiteX2" fmla="*/ 333375 w 681987"/>
                <a:gd name="connsiteY2" fmla="*/ 100013 h 379619"/>
                <a:gd name="connsiteX3" fmla="*/ 681987 w 681987"/>
                <a:gd name="connsiteY3" fmla="*/ 379619 h 379619"/>
                <a:gd name="connsiteX0" fmla="*/ 0 w 681987"/>
                <a:gd name="connsiteY0" fmla="*/ 0 h 379619"/>
                <a:gd name="connsiteX1" fmla="*/ 150825 w 681987"/>
                <a:gd name="connsiteY1" fmla="*/ 39295 h 379619"/>
                <a:gd name="connsiteX2" fmla="*/ 342065 w 681987"/>
                <a:gd name="connsiteY2" fmla="*/ 194146 h 379619"/>
                <a:gd name="connsiteX3" fmla="*/ 681987 w 681987"/>
                <a:gd name="connsiteY3" fmla="*/ 379619 h 379619"/>
                <a:gd name="connsiteX0" fmla="*/ 0 w 499345"/>
                <a:gd name="connsiteY0" fmla="*/ 0 h 348288"/>
                <a:gd name="connsiteX1" fmla="*/ 150825 w 499345"/>
                <a:gd name="connsiteY1" fmla="*/ 39295 h 348288"/>
                <a:gd name="connsiteX2" fmla="*/ 342065 w 499345"/>
                <a:gd name="connsiteY2" fmla="*/ 194146 h 348288"/>
                <a:gd name="connsiteX3" fmla="*/ 499345 w 499345"/>
                <a:gd name="connsiteY3" fmla="*/ 348288 h 348288"/>
                <a:gd name="connsiteX0" fmla="*/ 0 w 499345"/>
                <a:gd name="connsiteY0" fmla="*/ 0 h 348288"/>
                <a:gd name="connsiteX1" fmla="*/ 150240 w 499345"/>
                <a:gd name="connsiteY1" fmla="*/ 56456 h 348288"/>
                <a:gd name="connsiteX2" fmla="*/ 342065 w 499345"/>
                <a:gd name="connsiteY2" fmla="*/ 194146 h 348288"/>
                <a:gd name="connsiteX3" fmla="*/ 499345 w 499345"/>
                <a:gd name="connsiteY3" fmla="*/ 348288 h 348288"/>
                <a:gd name="connsiteX0" fmla="*/ 0 w 499345"/>
                <a:gd name="connsiteY0" fmla="*/ 0 h 348288"/>
                <a:gd name="connsiteX1" fmla="*/ 150240 w 499345"/>
                <a:gd name="connsiteY1" fmla="*/ 56456 h 348288"/>
                <a:gd name="connsiteX2" fmla="*/ 343671 w 499345"/>
                <a:gd name="connsiteY2" fmla="*/ 224597 h 348288"/>
                <a:gd name="connsiteX3" fmla="*/ 499345 w 499345"/>
                <a:gd name="connsiteY3" fmla="*/ 348288 h 348288"/>
                <a:gd name="connsiteX0" fmla="*/ 0 w 428509"/>
                <a:gd name="connsiteY0" fmla="*/ 0 h 332659"/>
                <a:gd name="connsiteX1" fmla="*/ 150240 w 428509"/>
                <a:gd name="connsiteY1" fmla="*/ 56456 h 332659"/>
                <a:gd name="connsiteX2" fmla="*/ 343671 w 428509"/>
                <a:gd name="connsiteY2" fmla="*/ 224597 h 332659"/>
                <a:gd name="connsiteX3" fmla="*/ 428509 w 428509"/>
                <a:gd name="connsiteY3" fmla="*/ 332659 h 332659"/>
                <a:gd name="connsiteX0" fmla="*/ 0 w 428509"/>
                <a:gd name="connsiteY0" fmla="*/ 0 h 332659"/>
                <a:gd name="connsiteX1" fmla="*/ 145783 w 428509"/>
                <a:gd name="connsiteY1" fmla="*/ 70843 h 332659"/>
                <a:gd name="connsiteX2" fmla="*/ 343671 w 428509"/>
                <a:gd name="connsiteY2" fmla="*/ 224597 h 332659"/>
                <a:gd name="connsiteX3" fmla="*/ 428509 w 428509"/>
                <a:gd name="connsiteY3" fmla="*/ 332659 h 332659"/>
                <a:gd name="connsiteX0" fmla="*/ 0 w 428509"/>
                <a:gd name="connsiteY0" fmla="*/ 0 h 332659"/>
                <a:gd name="connsiteX1" fmla="*/ 145783 w 428509"/>
                <a:gd name="connsiteY1" fmla="*/ 70843 h 332659"/>
                <a:gd name="connsiteX2" fmla="*/ 349733 w 428509"/>
                <a:gd name="connsiteY2" fmla="*/ 240663 h 332659"/>
                <a:gd name="connsiteX3" fmla="*/ 428509 w 428509"/>
                <a:gd name="connsiteY3" fmla="*/ 332659 h 332659"/>
                <a:gd name="connsiteX0" fmla="*/ 0 w 410252"/>
                <a:gd name="connsiteY0" fmla="*/ 0 h 325428"/>
                <a:gd name="connsiteX1" fmla="*/ 145783 w 410252"/>
                <a:gd name="connsiteY1" fmla="*/ 70843 h 325428"/>
                <a:gd name="connsiteX2" fmla="*/ 349733 w 410252"/>
                <a:gd name="connsiteY2" fmla="*/ 240663 h 325428"/>
                <a:gd name="connsiteX3" fmla="*/ 410252 w 410252"/>
                <a:gd name="connsiteY3" fmla="*/ 325428 h 325428"/>
                <a:gd name="connsiteX0" fmla="*/ 0 w 410252"/>
                <a:gd name="connsiteY0" fmla="*/ 0 h 325428"/>
                <a:gd name="connsiteX1" fmla="*/ 145783 w 410252"/>
                <a:gd name="connsiteY1" fmla="*/ 70843 h 325428"/>
                <a:gd name="connsiteX2" fmla="*/ 189530 w 410252"/>
                <a:gd name="connsiteY2" fmla="*/ 214128 h 325428"/>
                <a:gd name="connsiteX3" fmla="*/ 410252 w 410252"/>
                <a:gd name="connsiteY3" fmla="*/ 325428 h 325428"/>
                <a:gd name="connsiteX0" fmla="*/ 162865 w 573117"/>
                <a:gd name="connsiteY0" fmla="*/ 0 h 325428"/>
                <a:gd name="connsiteX1" fmla="*/ 2825 w 573117"/>
                <a:gd name="connsiteY1" fmla="*/ 157635 h 325428"/>
                <a:gd name="connsiteX2" fmla="*/ 352395 w 573117"/>
                <a:gd name="connsiteY2" fmla="*/ 214128 h 325428"/>
                <a:gd name="connsiteX3" fmla="*/ 573117 w 573117"/>
                <a:gd name="connsiteY3" fmla="*/ 325428 h 325428"/>
                <a:gd name="connsiteX0" fmla="*/ 0 w 977512"/>
                <a:gd name="connsiteY0" fmla="*/ 0 h 594412"/>
                <a:gd name="connsiteX1" fmla="*/ 407220 w 977512"/>
                <a:gd name="connsiteY1" fmla="*/ 426619 h 594412"/>
                <a:gd name="connsiteX2" fmla="*/ 756790 w 977512"/>
                <a:gd name="connsiteY2" fmla="*/ 483112 h 594412"/>
                <a:gd name="connsiteX3" fmla="*/ 977512 w 977512"/>
                <a:gd name="connsiteY3" fmla="*/ 594412 h 594412"/>
                <a:gd name="connsiteX0" fmla="*/ 0 w 977512"/>
                <a:gd name="connsiteY0" fmla="*/ 0 h 594412"/>
                <a:gd name="connsiteX1" fmla="*/ 277826 w 977512"/>
                <a:gd name="connsiteY1" fmla="*/ 356784 h 594412"/>
                <a:gd name="connsiteX2" fmla="*/ 756790 w 977512"/>
                <a:gd name="connsiteY2" fmla="*/ 483112 h 594412"/>
                <a:gd name="connsiteX3" fmla="*/ 977512 w 977512"/>
                <a:gd name="connsiteY3" fmla="*/ 594412 h 594412"/>
                <a:gd name="connsiteX0" fmla="*/ 0 w 1335815"/>
                <a:gd name="connsiteY0" fmla="*/ 0 h 1441680"/>
                <a:gd name="connsiteX1" fmla="*/ 636129 w 1335815"/>
                <a:gd name="connsiteY1" fmla="*/ 1204052 h 1441680"/>
                <a:gd name="connsiteX2" fmla="*/ 1115093 w 1335815"/>
                <a:gd name="connsiteY2" fmla="*/ 1330380 h 1441680"/>
                <a:gd name="connsiteX3" fmla="*/ 1335815 w 1335815"/>
                <a:gd name="connsiteY3" fmla="*/ 1441680 h 1441680"/>
                <a:gd name="connsiteX0" fmla="*/ 0 w 1335815"/>
                <a:gd name="connsiteY0" fmla="*/ 0 h 1441680"/>
                <a:gd name="connsiteX1" fmla="*/ 636129 w 1335815"/>
                <a:gd name="connsiteY1" fmla="*/ 1204052 h 1441680"/>
                <a:gd name="connsiteX2" fmla="*/ 1047626 w 1335815"/>
                <a:gd name="connsiteY2" fmla="*/ 1372101 h 1441680"/>
                <a:gd name="connsiteX3" fmla="*/ 1335815 w 1335815"/>
                <a:gd name="connsiteY3" fmla="*/ 1441680 h 1441680"/>
                <a:gd name="connsiteX0" fmla="*/ 0 w 1335815"/>
                <a:gd name="connsiteY0" fmla="*/ 0 h 1441680"/>
                <a:gd name="connsiteX1" fmla="*/ 636129 w 1335815"/>
                <a:gd name="connsiteY1" fmla="*/ 1204052 h 1441680"/>
                <a:gd name="connsiteX2" fmla="*/ 1335815 w 1335815"/>
                <a:gd name="connsiteY2" fmla="*/ 1441680 h 1441680"/>
                <a:gd name="connsiteX0" fmla="*/ 0 w 1545504"/>
                <a:gd name="connsiteY0" fmla="*/ 0 h 1337472"/>
                <a:gd name="connsiteX1" fmla="*/ 845818 w 1545504"/>
                <a:gd name="connsiteY1" fmla="*/ 1099844 h 1337472"/>
                <a:gd name="connsiteX2" fmla="*/ 1545504 w 1545504"/>
                <a:gd name="connsiteY2" fmla="*/ 1337472 h 1337472"/>
                <a:gd name="connsiteX0" fmla="*/ 0 w 1545504"/>
                <a:gd name="connsiteY0" fmla="*/ 0 h 1337472"/>
                <a:gd name="connsiteX1" fmla="*/ 873377 w 1545504"/>
                <a:gd name="connsiteY1" fmla="*/ 1081473 h 1337472"/>
                <a:gd name="connsiteX2" fmla="*/ 1545504 w 1545504"/>
                <a:gd name="connsiteY2" fmla="*/ 1337472 h 1337472"/>
                <a:gd name="connsiteX0" fmla="*/ 0 w 1545504"/>
                <a:gd name="connsiteY0" fmla="*/ 0 h 1337472"/>
                <a:gd name="connsiteX1" fmla="*/ 821678 w 1545504"/>
                <a:gd name="connsiteY1" fmla="*/ 991236 h 1337472"/>
                <a:gd name="connsiteX2" fmla="*/ 1545504 w 1545504"/>
                <a:gd name="connsiteY2" fmla="*/ 1337472 h 1337472"/>
                <a:gd name="connsiteX0" fmla="*/ 0 w 1545504"/>
                <a:gd name="connsiteY0" fmla="*/ 0 h 1337472"/>
                <a:gd name="connsiteX1" fmla="*/ 813559 w 1545504"/>
                <a:gd name="connsiteY1" fmla="*/ 1005555 h 1337472"/>
                <a:gd name="connsiteX2" fmla="*/ 1545504 w 1545504"/>
                <a:gd name="connsiteY2" fmla="*/ 1337472 h 13374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545504" h="1337472">
                  <a:moveTo>
                    <a:pt x="0" y="0"/>
                  </a:moveTo>
                  <a:cubicBezTo>
                    <a:pt x="53181" y="3572"/>
                    <a:pt x="590923" y="765275"/>
                    <a:pt x="813559" y="1005555"/>
                  </a:cubicBezTo>
                  <a:cubicBezTo>
                    <a:pt x="1036195" y="1245835"/>
                    <a:pt x="1399736" y="1287966"/>
                    <a:pt x="1545504" y="1337472"/>
                  </a:cubicBezTo>
                </a:path>
              </a:pathLst>
            </a:custGeom>
            <a:noFill/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155" name="テキスト ボックス 214">
            <a:extLst>
              <a:ext uri="{FF2B5EF4-FFF2-40B4-BE49-F238E27FC236}">
                <a16:creationId xmlns:a16="http://schemas.microsoft.com/office/drawing/2014/main" id="{48121E70-C9BC-8334-D93B-319CF0722869}"/>
              </a:ext>
            </a:extLst>
          </p:cNvPr>
          <p:cNvSpPr txBox="1"/>
          <p:nvPr/>
        </p:nvSpPr>
        <p:spPr>
          <a:xfrm>
            <a:off x="180750" y="536853"/>
            <a:ext cx="281444" cy="261325"/>
          </a:xfrm>
          <a:prstGeom prst="rect">
            <a:avLst/>
          </a:prstGeom>
          <a:noFill/>
        </p:spPr>
        <p:txBody>
          <a:bodyPr wrap="square" lIns="75918" tIns="37959" rIns="75918" bIns="37959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</a:t>
            </a:r>
            <a:endParaRPr lang="ja-JP" altLang="en-US" sz="12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FAA3E38-8247-952F-1946-0D3A607391C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828" y="3751299"/>
            <a:ext cx="5725668" cy="230017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8F794DD4-594B-0ABF-D5F7-4543C8BA3A32}"/>
              </a:ext>
            </a:extLst>
          </p:cNvPr>
          <p:cNvSpPr txBox="1"/>
          <p:nvPr/>
        </p:nvSpPr>
        <p:spPr>
          <a:xfrm>
            <a:off x="374828" y="7142487"/>
            <a:ext cx="5439069" cy="7432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You may use these figures without asking the authors (CC BY 4.0). However, please cite our paper (Ohmura and </a:t>
            </a:r>
            <a:r>
              <a:rPr lang="en-US" dirty="0" err="1"/>
              <a:t>Nagayasu</a:t>
            </a:r>
            <a:r>
              <a:rPr lang="en-US" dirty="0"/>
              <a:t>, 2025, </a:t>
            </a:r>
            <a:r>
              <a:rPr lang="en-US" i="1" dirty="0" err="1"/>
              <a:t>Neuropsychopharmacol</a:t>
            </a:r>
            <a:r>
              <a:rPr lang="en-US" i="1" dirty="0"/>
              <a:t> Rep</a:t>
            </a:r>
            <a:r>
              <a:rPr lang="en-US" dirty="0"/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780571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Arial"/>
        <a:cs typeface=""/>
      </a:majorFont>
      <a:minorFont>
        <a:latin typeface="Arial"/>
        <a:ea typeface="Arial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rtlCol="0" anchor="ctr"/>
      <a:lstStyle>
        <a:defPPr algn="ctr">
          <a:defRPr kumimoji="1"/>
        </a:defPPr>
      </a:lstStyle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spDef>
  </a:objectDefaults>
  <a:extraClrSchemeLst/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60</TotalTime>
  <Words>50</Words>
  <Application>Microsoft Office PowerPoint</Application>
  <PresentationFormat>Custom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Office テーマ</vt:lpstr>
      <vt:lpstr>Custom Desig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bikke</dc:creator>
  <cp:lastModifiedBy>Yu Ohmura</cp:lastModifiedBy>
  <cp:revision>353</cp:revision>
  <dcterms:created xsi:type="dcterms:W3CDTF">2018-02-09T03:54:15Z</dcterms:created>
  <dcterms:modified xsi:type="dcterms:W3CDTF">2025-03-20T10:36:04Z</dcterms:modified>
</cp:coreProperties>
</file>